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533" r:id="rId2"/>
    <p:sldId id="534" r:id="rId3"/>
    <p:sldId id="428" r:id="rId4"/>
    <p:sldId id="429" r:id="rId5"/>
    <p:sldId id="511" r:id="rId6"/>
    <p:sldId id="494" r:id="rId7"/>
    <p:sldId id="530" r:id="rId8"/>
    <p:sldId id="537" r:id="rId9"/>
    <p:sldId id="536" r:id="rId10"/>
    <p:sldId id="528" r:id="rId11"/>
    <p:sldId id="462" r:id="rId12"/>
    <p:sldId id="256" r:id="rId1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ED7D31"/>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107" autoAdjust="0"/>
    <p:restoredTop sz="94660"/>
  </p:normalViewPr>
  <p:slideViewPr>
    <p:cSldViewPr snapToGrid="0">
      <p:cViewPr varScale="1">
        <p:scale>
          <a:sx n="71" d="100"/>
          <a:sy n="71" d="100"/>
        </p:scale>
        <p:origin x="80" y="40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4C748E-1685-4BB0-A95B-AE43B118BF9C}" type="datetimeFigureOut">
              <a:rPr lang="zh-CN" altLang="en-US" smtClean="0"/>
              <a:t>2023/3/23</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458D62-1115-49DF-AE13-6F29B2893A1F}" type="slidenum">
              <a:rPr lang="zh-CN" altLang="en-US" smtClean="0"/>
              <a:t>‹#›</a:t>
            </a:fld>
            <a:endParaRPr lang="zh-CN" altLang="en-US"/>
          </a:p>
        </p:txBody>
      </p:sp>
    </p:spTree>
    <p:extLst>
      <p:ext uri="{BB962C8B-B14F-4D97-AF65-F5344CB8AC3E}">
        <p14:creationId xmlns:p14="http://schemas.microsoft.com/office/powerpoint/2010/main" val="31379666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5"/>
          </p:nvPr>
        </p:nvSpPr>
        <p:spPr/>
        <p:txBody>
          <a:bodyPr/>
          <a:lstStyle/>
          <a:p>
            <a:fld id="{800A5DE9-D3E2-4527-AFFD-3726C28DA2EF}" type="slidenum">
              <a:rPr lang="zh-CN" altLang="en-US" smtClean="0"/>
              <a:t>3</a:t>
            </a:fld>
            <a:endParaRPr lang="zh-CN" altLang="en-US"/>
          </a:p>
        </p:txBody>
      </p:sp>
    </p:spTree>
    <p:extLst>
      <p:ext uri="{BB962C8B-B14F-4D97-AF65-F5344CB8AC3E}">
        <p14:creationId xmlns:p14="http://schemas.microsoft.com/office/powerpoint/2010/main" val="21675752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1BA19F9-CA55-ED83-9ED9-6ED345F2B025}"/>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E06059F0-BF00-8563-688D-94502D47BE4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C188C1EB-296A-B6C8-82B6-4D5F3E8E8B8C}"/>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18202F03-C0C9-3C91-5926-10E550247C6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B7250E1-FF13-F6C1-E7A9-F53AB5CF2DF8}"/>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24520012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0787404-0964-D179-E7C4-63DB0F46A499}"/>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4A0E0842-48D5-E0A5-49D9-4A01856DC797}"/>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443AC0F0-8224-3D0E-2393-2BC37085C5ED}"/>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5F31A215-2CA0-075B-0C5E-13B724147EE8}"/>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30F3BE51-CF4F-16A3-E714-DC22F8530271}"/>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27952766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554BA565-D7FE-A797-07D8-06AB4E19AB5E}"/>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A37B65E4-887C-3D00-32BB-BBEE41E1DA21}"/>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B1CC0532-96AB-17CC-8FA7-6826B474AF2B}"/>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4857A800-943A-5FF1-1AE9-F8507AB99DC7}"/>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2C4CDA4-037A-A917-BFE5-599787FA05B0}"/>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36658148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D2018F6-C836-A026-6A3D-537F22F1A9ED}"/>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A03FEBA5-5E25-818C-D970-5EFCACA9AF8C}"/>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A338A220-9794-F762-AF3B-9115539A0CF3}"/>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A9324CA0-0010-6134-BE01-8FD0A18F6775}"/>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752531E-F40A-3220-0A03-40EF94CE452C}"/>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317048224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F90717A-49F6-EC08-AAA1-5FE7A51D6408}"/>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C09D62CA-1CC5-27F7-4E09-82F1340776C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8CFA1D5D-DECF-3D43-4804-BB9D14BF1762}"/>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95A02DE6-2536-A665-9BDE-CA28FAE88089}"/>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32835AF-4AA0-C3DC-53D2-61FC9D1B5059}"/>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7487937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C90A573-8BCE-26AC-ED37-46097E8AF8D4}"/>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F504FF2B-AFDE-15F3-302A-972CF5AD22D4}"/>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A8D8D432-29E7-AB49-E723-4C8DA93099AC}"/>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B5ADEE8C-5E90-89BE-3B3B-24C8C41B14DE}"/>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6" name="页脚占位符 5">
            <a:extLst>
              <a:ext uri="{FF2B5EF4-FFF2-40B4-BE49-F238E27FC236}">
                <a16:creationId xmlns:a16="http://schemas.microsoft.com/office/drawing/2014/main" id="{65C1E537-90F9-1098-9648-DE16CE9D343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675C6179-05E0-223B-E0DE-62AE80683A54}"/>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27067258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ED74AEF-C482-729D-99A7-8DF8BD261255}"/>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25F8B7B7-95CF-C5F5-1CAC-4130099D593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8E180C54-F9A0-D3DF-FA34-51FE522CAF9A}"/>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ADBDAF76-CEE2-AF33-71BF-DE5066917C0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0E9964FA-8ED0-3545-C542-C9D698A1E519}"/>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686AA871-5688-C149-02FE-0A29090C9D66}"/>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8" name="页脚占位符 7">
            <a:extLst>
              <a:ext uri="{FF2B5EF4-FFF2-40B4-BE49-F238E27FC236}">
                <a16:creationId xmlns:a16="http://schemas.microsoft.com/office/drawing/2014/main" id="{2298458B-FD1F-002B-5462-C3824CC7683A}"/>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AE8EE0AA-B3F6-9415-5C4C-CFB60E26F96F}"/>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12077696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54B22A1-6173-09C6-BAE0-F2FFD019CC55}"/>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D1D739EE-6286-45A0-B0D8-E474149224D2}"/>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4" name="页脚占位符 3">
            <a:extLst>
              <a:ext uri="{FF2B5EF4-FFF2-40B4-BE49-F238E27FC236}">
                <a16:creationId xmlns:a16="http://schemas.microsoft.com/office/drawing/2014/main" id="{B7DEE3E9-A1A8-7867-4C74-BDD13F3231A9}"/>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3E4221B6-2352-BC87-1639-664DA1047156}"/>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20993060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2B90577-7131-CD3C-30B3-3C94C5A8AB1D}"/>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3" name="页脚占位符 2">
            <a:extLst>
              <a:ext uri="{FF2B5EF4-FFF2-40B4-BE49-F238E27FC236}">
                <a16:creationId xmlns:a16="http://schemas.microsoft.com/office/drawing/2014/main" id="{04507C24-07F9-0024-5266-1A30CC2C55A2}"/>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C5406D71-90DB-261A-750D-E97CFA4B9071}"/>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37813990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0F2A16F-F6C9-7B5B-0D88-ACCABC956EA1}"/>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AED5F314-D856-60BE-E0D0-8B1AB18D698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F387E1F-E6A3-A10E-A067-B8C4302E4E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5FE2E793-491A-C6F9-86C1-7EADDE1CFF0B}"/>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6" name="页脚占位符 5">
            <a:extLst>
              <a:ext uri="{FF2B5EF4-FFF2-40B4-BE49-F238E27FC236}">
                <a16:creationId xmlns:a16="http://schemas.microsoft.com/office/drawing/2014/main" id="{5D00FFC2-E7F7-F750-49A3-E3196272AC6B}"/>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C1D53903-A493-6024-D878-C53B81608371}"/>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380242597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ECF3070-41F9-4DB4-95E3-8BBAA2F8E850}"/>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F01F1AC9-462F-A664-050B-2B62E132182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BB79E474-CE8C-EBD2-AC52-AEA9A170050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18BDDEF-C694-AC12-BEDF-F83D35B782A7}"/>
              </a:ext>
            </a:extLst>
          </p:cNvPr>
          <p:cNvSpPr>
            <a:spLocks noGrp="1"/>
          </p:cNvSpPr>
          <p:nvPr>
            <p:ph type="dt" sz="half" idx="10"/>
          </p:nvPr>
        </p:nvSpPr>
        <p:spPr/>
        <p:txBody>
          <a:bodyPr/>
          <a:lstStyle/>
          <a:p>
            <a:fld id="{5F990EB0-DF50-41DF-9606-EA0DE507A0E4}" type="datetimeFigureOut">
              <a:rPr lang="zh-CN" altLang="en-US" smtClean="0"/>
              <a:t>2023/3/23</a:t>
            </a:fld>
            <a:endParaRPr lang="zh-CN" altLang="en-US"/>
          </a:p>
        </p:txBody>
      </p:sp>
      <p:sp>
        <p:nvSpPr>
          <p:cNvPr id="6" name="页脚占位符 5">
            <a:extLst>
              <a:ext uri="{FF2B5EF4-FFF2-40B4-BE49-F238E27FC236}">
                <a16:creationId xmlns:a16="http://schemas.microsoft.com/office/drawing/2014/main" id="{47D50E28-8C12-8562-FB4A-5E5A6585BB2C}"/>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88E0184-6FBC-7D2C-E0D2-D7B5315BCD07}"/>
              </a:ext>
            </a:extLst>
          </p:cNvPr>
          <p:cNvSpPr>
            <a:spLocks noGrp="1"/>
          </p:cNvSpPr>
          <p:nvPr>
            <p:ph type="sldNum" sz="quarter" idx="12"/>
          </p:nvPr>
        </p:nvSpPr>
        <p:spPr/>
        <p:txBody>
          <a:body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1116703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DE433F19-C6BF-82BF-F9EC-117CB224747D}"/>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D058493A-A028-75CE-890F-E1E40F5C218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C7918A8-7E2C-09D3-649C-45B576A4F31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F990EB0-DF50-41DF-9606-EA0DE507A0E4}" type="datetimeFigureOut">
              <a:rPr lang="zh-CN" altLang="en-US" smtClean="0"/>
              <a:t>2023/3/23</a:t>
            </a:fld>
            <a:endParaRPr lang="zh-CN" altLang="en-US"/>
          </a:p>
        </p:txBody>
      </p:sp>
      <p:sp>
        <p:nvSpPr>
          <p:cNvPr id="5" name="页脚占位符 4">
            <a:extLst>
              <a:ext uri="{FF2B5EF4-FFF2-40B4-BE49-F238E27FC236}">
                <a16:creationId xmlns:a16="http://schemas.microsoft.com/office/drawing/2014/main" id="{0C4ECACC-A3F3-CADA-7BB6-180022AAB129}"/>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D766D4A0-DDD2-208B-C8C6-8EF5D931CB0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29FA5FE-2E42-40C3-A61F-E95D0F8483FE}" type="slidenum">
              <a:rPr lang="zh-CN" altLang="en-US" smtClean="0"/>
              <a:t>‹#›</a:t>
            </a:fld>
            <a:endParaRPr lang="zh-CN" altLang="en-US"/>
          </a:p>
        </p:txBody>
      </p:sp>
    </p:spTree>
    <p:extLst>
      <p:ext uri="{BB962C8B-B14F-4D97-AF65-F5344CB8AC3E}">
        <p14:creationId xmlns:p14="http://schemas.microsoft.com/office/powerpoint/2010/main" val="17602894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1.xml"/><Relationship Id="rId5" Type="http://schemas.openxmlformats.org/officeDocument/2006/relationships/image" Target="../media/image6.png"/><Relationship Id="rId4" Type="http://schemas.openxmlformats.org/officeDocument/2006/relationships/image" Target="../media/image5.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42DF3CCA-7E7F-41F8-AF76-378E0BAEE745}"/>
              </a:ext>
            </a:extLst>
          </p:cNvPr>
          <p:cNvSpPr txBox="1"/>
          <p:nvPr/>
        </p:nvSpPr>
        <p:spPr>
          <a:xfrm>
            <a:off x="254001" y="-105358"/>
            <a:ext cx="12344400" cy="7275325"/>
          </a:xfrm>
          <a:prstGeom prst="rect">
            <a:avLst/>
          </a:prstGeom>
          <a:noFill/>
        </p:spPr>
        <p:txBody>
          <a:bodyPr wrap="square">
            <a:spAutoFit/>
          </a:bodyPr>
          <a:lstStyle/>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720                   *               -4680                   *               -4640                   *               -4600                   *               -4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GTGAACAACCAAACATACCGGCAATCTAATCAATCCCCCTGGAGGCTAGTGCATGATATAAATGTGGATGCTTCA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GAGTTG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TCGGTGAGGGATAA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GTGCTTATATAATCTTGGGCTACTTCTCATATTGCTAATTGGTTTTATGTTGGAACCCCAATTTCATCATGG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GTGAACAACCAAACATACCGGCAATCTAATCAATCCCCCTGGAGGCTAGTGCATGATATAAATGTGGATGCTTCA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GAGTTG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TCGGTGAGGGATAA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GTGCTTATATAATCTTGGGCTACTTCTCATATTGCTAATTGGTTTTATGTTGGAACCCCAATTTCATCATGG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20                   *               -4480                   *               -4440                   *               -4400                   *               -4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GGATTGTCCTCGTGTGAAGCCAAACGGCCACACGCGCTCCACGTCACCTAGTTGTTGTCCACGTGTAGGC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AATCCACCACACGTGCAGGGGCATGTTGAGAGTCGTCACCTAGTTGTTGTCCACGTGTAGGCT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TCCACCACACGTGCAGGGGCATGTTGAGAGTTGTCCCACATCGGTGAGG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GGATTGTCCTCGTGTGAAGCCAAACGGCCACACGCGCTCCACGTCACCTAGTTGTTGTCCACGTGTAGGC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TCCACCACACGTGCAGGGGCATGTTGAGAGTTGTCCCACATCGGTGAGG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320                   *               -4280                   *               -4240                   *               -4200                   *               -4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GTTTGCTATGTGCTTATATGATCTTGGGCTAATTCTCATATTGCCAATTGGTTTTATGGAGGAACTCCAATTTCATCATCACCTTTATTTTATTAAATTAATGTTTCATTTGGCTATATCTTATTCTTTACGTGACCCTTAAGCCAATTCAAAGCTCTAGAAATAAAGCACAAGATTTACACTTTTTATAATCG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GTTTGCTATGTGCTTATATGATCTTGGGCTAATTCTCATATTGCCAATTGGTTTTATGGAGGAACTCCAATTTCATCATCACCTTTATTTTATTAAATTAATGTTTCATTTGGCTATATCTTATTCTTTACGTGACCCTTAAGCCAATTCAAAGCTCTAGAAATAAAGCACAAGATTTACACTTTTTATAATCG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120                   *               -4080                   *               -4040                   *               -4000                   *               -3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ATTTTCTCATCATTTCGTGGTGTGTTCAAAATTCAAATAAACACGCAAGGTGTAAGCACATATGCATTTGAAAAGTGGATAACGTACGTTTGCATGGTGACATGCATGAGCCGTCCCTTTGAGATAGCAAAGGGTTATACCATGCCATGATCTAGAAAGAAAACATACACGATAGAAATATATTTGAAT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ATTTTCTCATCATTTCGTGGTGTGTTCAAAATTCAAATAAACACGCAAGGTGTAAGCACATATGCATTTGAAAAGTGGATAACGTACGTTTGCATGGTGACATGCATGAGCCGTCCCTTTGAGATAGCAAAGGGTTATACCATGCCATGATCTAGAAAGAAAACATACACGATAGAAATATATTTGAAT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20                   *               -3880                   *               -3840                   *               -3800                   *               -3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ATTTGGACCATTCCGAGCAAGTCTATCTAAATAGCAATAGCATCACTCTATATTATTGCAGTTCTTATTAAGA</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GGCCCGGCCCAGGCGCAGTGCAACAGGGGCAATTGTCCAGGGCCCAAAGTTGAATGGGGCACCCAAAAAACAAAATCCAAATAATTAGGTATAAAAAAAAATTTGTCCAA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ATTTGGACCATTCCGAGCAAGTCTATCTAAATAGCAATAGCATCACTCTATATTATTGCAGTTCTTATTA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1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20                   *               -3680                   *               -3640                   *               -3600                   *               -3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CAAAATAAAGGCTGTAGGCGATAACTTGTCCAGGTTTTGGGGATTAAAAATCAATATAACATAAAGGGTATCTGAAGGGGACAAGTCGTCCAGGTTTTGGGCATGGAGGAGAGGCATAAGATTCAAGTTTTTCAAAGGGAGCTCCCTCTCTGCTTGGAGCTTGTCACCCAACTGCCCAAGCCCAAGGTACTACGG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520                   *               -3480                   *               -3440                   *               -3400                   *               -3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CAAACCCTTCTCAAATTTCAGCTTAATTTTTGTGTTCTAAGTCGGAAGCTTCGTTTCTTTTGCTTGAATTGTTCTGGTTTCTGTTTTCAAAATTGGGGTTTTTTTTGTAGCTATTGAGAGGTGCAAGCAGCAGATTTCAGATGCAACCGCAAATTACCTGCATGGACAATCTAAGTGTTCTGAGCAGACTTCAA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20                   *               -3280                   *               -3240                   *               -3200                   *               -3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GGCATGTTTTTGAGGAATTCATTCCATTAACACGGATTTCATACAACTCCAGATGCACCACTCGAAGAGGTATAAAAAAAAGACTCCACCTTCATCAATTTTAGTAAATTTTGTGACTGCCCTTTTGTTTGGTTGCTTATAAAATTTGAGGTGAAGAAGTGGAAAGTATTGATTTTTAGGTGTAGGGTAATGGCA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120                   *               -3080                   *               -3040                   *               -3000                   *               -2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AGCAAGTTAAAGGCTATAGTGATGGAGATGAAGAGAAATGGGGTGCTTTTCAGCCTTTCCAAGGGAAAAAAAAAGCATTGGAAAGACAAATGGACCGGTGGCTAAAGAACCTTCTTCGGCTCCGGCTACTAGTTCCACCACGGACACCGTGAGTGGAGACAGTGGTGGGAACAACAAGAACAAAGAGAAAGATGGA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20                   *               -2880                   *               -2840                   *               -2800                   *               -2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GAAACGAAGGCGAAACTGGTCACCGGAGTTGCACCGCCGGTTCTTGCATGCTCTTCTCTTCAACAACTTGGTGGTTCACTTGGTATGCAGTTGAGATTAATTTAGTGGGATATGTTATTTTATATGATTGGATGAATATGTGATTGGATTGTGATGTATTGGATGTGTTTAATGCGTTCTGCGTATATGTGATTT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20                   *               -2680                   *               -2640                   *               -2600                   *               -2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ATCTGTTTTTAATCATAATTTGGTTGATGTGAAAATTTTTGCACATACATGATAGAAATTGGAAGGCATTTTGCATGCTACTAGTGATGATTTTTTTACACATACATGTGATTAACCTCGCAAAATATTTATTTTAAACATATGTTTCTGTACTAAAAAGGGCACATTTTGAACTTTCGCACTGGGCACCAAAAAAC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20                   *               -2480                   *               -2440                   *               -2400                   *               -2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ACCGGCCCTG</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TTACATATTCAATATAAAGTTCCAATACGATCACTGATTGATTAATTGGTATCAAGTACAATACTTCTGCATCTCTCTTAAAAAACATCAACAATGCATTACGTGTTGTAGATTGTTATCAGAGTCGGCCC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TTACATATTCAATATAAAGTTCCAATACGATCACTGATTGATTAATTGGTATCAAGTACAATACTTCTGCATCTCTCTTAAAAAACATCAACAATGCATTACGTGTTGTAGATTGTTATCAGAGTCGGCCC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98</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20                   *               -2280                   *               -2240                   *               -2200                   *               -2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ACCAGGGCGACCG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CCAAAAAAACG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CATATATGTATAAGGTTTTGTTTTATTCTTGATATATAGTAAACGCTCATATTAAATAGCAATATGTTTTAG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GGTTTTATTTGGTTTTTCCGTGCCCACCTAGGTTTAATTCCCTCTCTC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ACCAGGGCGACCG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CCAAAAAAACG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CATATATGTATAAGGTTTTGTTTTATTCTTGATATATAGTAAACGCTCATATTAAATAGCAATATGTTTTAG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GGTTTTATTTGGTTTTTCCGTGCCCACCTAGGTTTAATTCCCTCTCTC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20                   *               -2080                   *               -2040                   *               -2000                   *               -1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GTAGTTTCCCTTCTATTTTATTCATGTCTACTTTAAATAACAAACAAACATTAATTAGCTTATTAAATGTGGCATTTTCAGTAGTCGTTTTTTGTTTTCAGTTTGAATTAACTCGCAAAATCATGTTCAAGTTTGTCTAAATATAAATTTAGGTTTTTTATATTTGTTGATAATCTTTTCATGGTTAAGTA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GTAGTTTCCCTTCTATTTTATTCATGTCTACTTTAAATAACAAACAAACATTAATTAGCTTATTAAATGTGGCATTTTCAGTAGTCGTTTTTTGTTTTCAGTTTGAATTAACTCGCAAAATCATGTTCAAGTTTGTCTAAATATAAATTTAGGTTTTTTATATTTGTTGATAATCTTTTCATGGTTAAGTA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20                   *               -1880                   *               -1840                   *               -1800                   *               -1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TGTGATCATTATCTTTTTATTGAACGAAGTATTGTTATTGACAATCCAAAAATATCATCCTACACTTCTTTGTATA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TATGATTTTATATATTTGGAATGAACCGCAACTTTTCATGAGCGCTCGAAAAACAAAAACATAGTTGAATTACTATGTGCCCTTTGGTAGTAGCAATTTGTTGTTTT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TGTGATCATTATCTTTTTATTGAACGAAGTATT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TCCAAAAATATCATCCTACACTTCTTTGTATA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TATGATTTTATATATTTGGAATGAACCGCAACTTTTCATGAGCGCTCGAAAAACAAAAACATAGTTGAATTACTATGTGCCCTTTGGTAGTAGCAATTTGTTGTTTT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20                   *               -1680                   *               -1640                   *               -1600                   *               -1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TGCTTACATATAGAAATTAGAGATCTTAAATATGAAAAATTCATTTCAAAAGTTTCATAATGTGCAAGTAGCTTGTAGATCAGTTAGTTAAAAGTGTTCAGCTTGTCACTCAATGACTCGTTTTCAAATTTCCTCACCGTA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AGTTTAGTGTAAATTACCCTATCATTTGTCAAAAAAGTCATAATG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TGCTTACATATAGAAATTAGAGATCTTAAATATGAAAAATTCATTTCAAAAGTTTCATAATGTGCAAGTAGCTTGTAGATCAGTTAGTTAAAAGTGTTCAGCTTGTCACTCAATGACTCGTTTTCAAATTTCCTCACCGTA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AGTTTAGTGTAAATTACCCTATCATTTGTCAAAAAAGTCATAATG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20                   *               -1480                   *               -1440                   *               -1400                   *               -1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GTCTATTTTCTTTAATATTCAATGTACAACA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CTAAGATAAATAATTATTTTATGTGAAGTTATGTTAGGGCATATTTTTCAATGT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GGGCCTCATAAAACTCAGGATAGGCCTTGATTGTTATATATGGTACTAAACAAAAGTT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ACAAAGTTTAAAAAGATTCAAGTG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GTCTATTTTCTTTAATATTCAATGTACAACA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CTAAGATAAATAATTATTTTATGTGAAGTTATGTTAGGGCATATTTTTCAATGT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GGGCCTCATAAAACTCAGGATAGGCCTTGATTGTTATATATGGTACTAAACAAAAGTT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ACAAAGTTTAAAAAGATTCAAGTG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20                   *               -1280                   *               -1240                   *               -1200                   *               -1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GAATT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ATTATAAATTTTG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CGAGTTGATTAATTGCGGGGGATGTGGTCATCATGACCG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GTTCATGGAGCAACCTACTTGTTCCCCCACTTATGATTGACGCATTTTTACTGTATGAACAT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5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GAATT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ATTATAAATTTTG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CGAGTTGATTAATTGCGGGGGATGTGGTCATCATGACCG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GTTCATGGAGCAACCTACTTGTTCCCCCACTTATGATTGACGCATTTTTACTGTATGAACAT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CAGAACCGTTCGTTCTCTTTGTCATCATCGAAAGATCA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20                   *               -1080                   *               -1040                   *               -1000                   *                -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CTCATTAAATTGAGAGATTTTTTTA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ATGTATCATACAAAT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TCATCATAAGGATGCTACTTGTTACCAAAAACATTGATTGGTTTGACATATATGGATGGGTAAACAATCTCCAAATGGAATATTTTTTTTAGATATGATATTTCGATGATGATAAAGAGAATGAACGGGTCAAATA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CTCATTAAATTGAGAGATTTTTTTA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ATGTATCATACAAAT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TCATCATAAGGATGCTACTTGTTACCAAAAACATTGATTGGTTTGACATATATGGATGGGTAAACAATCTCCAAATGGAATATTTTTTTTAGATATGATATTTCGATGATGATAAAGAGAATGAACGGGTCAAATA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20                   *                -880                   *                -840                   *                -800                   *                -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TCATATGGTGAAGATGCGTAAATCATAAGTGAAGGGACAAGTTGGTTCCCTATGGAGGACACAAGCATTATTCGTTTTTAGGTGTATTCAATTAGAATTGTAAATGAATCTATAAAAGTTCAGGAATATTCAGTCAGAATGTTAAACAAGCTTATAGAACTCCATACAAATTCAGGTGTATTAATCAATTA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TCATATGGTGAAGATGCGTAAATCATAAGTGAAGGGACAAGTTGGTTCCCTATGGAGGACACAAGCATTATTCGTTTTTAGGTGTATTCAATTAGAATTGTAAATGAATCTATAAAAGTTCAGGAATATTCAGTCAGAATGTTAAACAAGCTTATAGAACTCCATACAAATTCAGGTGTATTAATCAATTA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20                   *                -680                   *                -640                   *                -600                   *                -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AGGATTTTATAAAAGTCAACAGAAATCTGAGTGTATTCAAAGAAGATTTTGAAAAAGTCTAAGAAAGTTAGAGTGT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GTAATAATTTGATTTTAAAGAATTTTAAAATGATACATTTTAGTAAATTTGAAGGAATTTCATAGAGTATTTAACCCTTAATAAATCATACTTCTGTAAAGTC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1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AGGATTTTATAAAAGTCAACAGAAATCTGAGTGTATTCAAAGAAGATTTTGAAAAAGTCTAAGAAAGTTAGAGTGT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GTAATAATTTGATTTTAAAGAATTTTAAAATGATACATTTTAGTAAATTTGAAGGAATTTCATAGAGTATTTAACCCTTAATAAATCATACTTCTGTAAAGTC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20                   *                -480                   *                -440                   *                -400                   *                -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CCATCAACTTTCATAAATTGAAACATTTTTAAATCCATAAAAGTTGAACCGAATCTATTTTCATATATTATTTTATACATGCAACGACTTACGTTGTAACATAAGGGATGCAATGCATGGCGCAGAAAGTCATAGAGTC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TTTCGTCTGAATCTCTCATGTCCGAGAACCCATACCTCAAG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3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CCATCAACTTTCATAAATTGAAACATTTTTAAATCCATAAAAGTTGAACCGAATCTATTTTCATATATTATTTTATACATGCAACGACTTACGTTGTAACATAAGGGATGCAATGCATGGCGCAGAAAGTCATAGAGTC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TTTCGTCTGAATCTCTCATGTCCGAGAACCCATACCTCAAG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                   *                -280                   *                -240                   *                -200                   *                -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AGACGACACAATACACAACAA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TCAATACCCTTCTCTTCCGCTGCCTATAAATACCAATGGAAATCCCACGACATTCTCACCAAATCATCATCACTTGAACACACCAA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ACTTCTAGCTACAATTCTAAGTTTCCATTTTCCAACATCC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TGTTCAAAAATATCATCAGCCTCGAG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AGACGACACAATACACAACAA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TCAATACCCTTCTCTTCCGCTGCCTATAAATACCAATGGAAATCCCACGACATTCTCACCAAATCATCATCACTTGAACACACCAA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ACTTCTAGCTACAATTCTAAGTTTCCATTTTCCAACATCC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TGTTCAAAAATATCATCAGCCTCGAG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1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                   *                 -80                   *                 -40                   *                   0                   *                  4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TTTATTATCCTTCGTGACCCTCCTTTTAGTATTTGGTTCTTTTTGAAAGACGATTTGTTAGGTGTTTCTAGGCCTCTAGCCATCTTGTATCTCACCAAAAAAAAATATATTACCAGCTGTTTACACCAAATTAAATAGTAAAAAGAAAGCATCAATGGCTTTAAAAACACAGTTGTTGTGGTCATTTGTTGT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7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TTTATTATCCTTCGTGACCCTCCTTTTAGTATTTGGTTCTTTTTGAAAGACGATTTGTTAGGTGTTTCTAGGCCTCTAGCCATCTTGTATCTCACCAAAAAAAAATATATTACCAGCTGTTTACACCAAATTAAATAGTAAAAAGAAAGCATCAATGGCTTTAAAAACACAGTTGTTGTGGTCATTTGTTGT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                   *                 120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TTGTTTCCTTCAGTACAACTTCATGTTCTGGTAGTAGTTTCCAGGAGGTCAACGCGCTTCATAGTTACGTTGACCATGTTGATGATAAAGAG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8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TTGTTTCCTTCAGTACAACTTCATGTTCTGGTAGTAGTTTCCAGGAGGTCAACGCGCTTCATAGTTACGTTGACCATGTTGATGATAAAGAGTCCGG</a:t>
            </a:r>
            <a:r>
              <a:rPr lang="en-US" altLang="zh-CN" sz="700" kern="100" dirty="0">
                <a:latin typeface="等线" panose="02010600030101010101" pitchFamily="2" charset="-122"/>
                <a:ea typeface="等线" panose="02010600030101010101" pitchFamily="2" charset="-122"/>
                <a:cs typeface="Times New Roman" panose="02020603050405020304" pitchFamily="18" charset="0"/>
              </a:rPr>
              <a:t>  </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34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zh-CN" altLang="en-US" sz="700" dirty="0"/>
          </a:p>
        </p:txBody>
      </p:sp>
      <p:sp>
        <p:nvSpPr>
          <p:cNvPr id="4" name="文本框 3">
            <a:extLst>
              <a:ext uri="{FF2B5EF4-FFF2-40B4-BE49-F238E27FC236}">
                <a16:creationId xmlns:a16="http://schemas.microsoft.com/office/drawing/2014/main" id="{F45167E6-63FB-46A5-AF2A-81804596A93D}"/>
              </a:ext>
            </a:extLst>
          </p:cNvPr>
          <p:cNvSpPr txBox="1"/>
          <p:nvPr/>
        </p:nvSpPr>
        <p:spPr>
          <a:xfrm>
            <a:off x="0" y="31516"/>
            <a:ext cx="529981" cy="27699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zh-CN" sz="1200" b="1" dirty="0">
                <a:solidFill>
                  <a:prstClr val="black"/>
                </a:solidFill>
                <a:latin typeface="Times New Roman" panose="02020603050405020304" pitchFamily="18" charset="0"/>
                <a:ea typeface="等线" panose="02010600030101010101" pitchFamily="2" charset="-122"/>
              </a:rPr>
              <a:t>A</a:t>
            </a:r>
            <a:endParaRPr kumimoji="0" lang="zh-CN" altLang="en-US" sz="12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
        <p:nvSpPr>
          <p:cNvPr id="5" name="矩形 4">
            <a:extLst>
              <a:ext uri="{FF2B5EF4-FFF2-40B4-BE49-F238E27FC236}">
                <a16:creationId xmlns:a16="http://schemas.microsoft.com/office/drawing/2014/main" id="{82AF37BA-4E16-4B30-B9D1-3BC2919BAAC1}"/>
              </a:ext>
            </a:extLst>
          </p:cNvPr>
          <p:cNvSpPr/>
          <p:nvPr/>
        </p:nvSpPr>
        <p:spPr>
          <a:xfrm>
            <a:off x="9360518" y="6181642"/>
            <a:ext cx="189506" cy="280728"/>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spTree>
    <p:extLst>
      <p:ext uri="{BB962C8B-B14F-4D97-AF65-F5344CB8AC3E}">
        <p14:creationId xmlns:p14="http://schemas.microsoft.com/office/powerpoint/2010/main" val="193733355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7" name="组合 66">
            <a:extLst>
              <a:ext uri="{FF2B5EF4-FFF2-40B4-BE49-F238E27FC236}">
                <a16:creationId xmlns:a16="http://schemas.microsoft.com/office/drawing/2014/main" id="{0FAFFD71-98A1-1ECA-8984-9216723A949C}"/>
              </a:ext>
            </a:extLst>
          </p:cNvPr>
          <p:cNvGrpSpPr/>
          <p:nvPr/>
        </p:nvGrpSpPr>
        <p:grpSpPr>
          <a:xfrm>
            <a:off x="2146634" y="-87477"/>
            <a:ext cx="7700695" cy="6650347"/>
            <a:chOff x="271451" y="308508"/>
            <a:chExt cx="7700695" cy="6650347"/>
          </a:xfrm>
        </p:grpSpPr>
        <p:sp>
          <p:nvSpPr>
            <p:cNvPr id="23" name="文本框 22">
              <a:extLst>
                <a:ext uri="{FF2B5EF4-FFF2-40B4-BE49-F238E27FC236}">
                  <a16:creationId xmlns:a16="http://schemas.microsoft.com/office/drawing/2014/main" id="{FB446EA7-6EEE-C3A7-055D-BB7744F49B1E}"/>
                </a:ext>
              </a:extLst>
            </p:cNvPr>
            <p:cNvSpPr txBox="1"/>
            <p:nvPr/>
          </p:nvSpPr>
          <p:spPr>
            <a:xfrm>
              <a:off x="1056096" y="308508"/>
              <a:ext cx="6916050" cy="6650347"/>
            </a:xfrm>
            <a:prstGeom prst="rect">
              <a:avLst/>
            </a:prstGeom>
            <a:noFill/>
          </p:spPr>
          <p:txBody>
            <a:bodyPr wrap="square">
              <a:spAutoFit/>
            </a:bodyPr>
            <a:lstStyle/>
            <a:p>
              <a:pPr>
                <a:lnSpc>
                  <a:spcPts val="700"/>
                </a:lnSpc>
              </a:pP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         *        40         *        60         *        80         *       1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AGGCGCAGTGCAACAGGGGCAATTGTCCAGGGCCCAAAGTTGAATGGGGCACCCAAAAAACAAAATCCAAATAATTAGGTATAAAAAAAAATTTG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AGGCGCAGTGCAACAGGGGCAATTGTCCAGGGCCCAAAGTTGAATGGGGCACCCAAAAAACAAAATCCAAATAATTAGGTATAAAAAAAAATTTG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AGGCGCAGTGCAACAGGGGCAATTGTCCAGGGCCCAAAGTTGAATGGGGCACCCAAAAAACAAAATCCAAATAATTAGGTATAAAAAAAAATTTG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         *       140         *       160         *       180         *       2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GCCCAAAATAAAGGCTGTAGGCGATAACTTGTCCAGGTTTTGGGGATTAAAAATCAATATAACATAAAGGGTATCTGAAGGGGACAAGTCGTCC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GCCCAAAATAAAGGCTGTAGGCGATAACTTGTCCAGGTTTTGGGGATTAAAAATCAATATAACATAAAGGGTATCTGAAGGGGACAAGTCGTCC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GCCCAAAATAAAGGCTGTAGGCGATAACTTGTCCAGGTTTTGGGGATTAAAAATCAATATAACATAAAGGGTATCTGAAGGGGACAAGTCGTCC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         *       240         *       260         *       280         *       3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TTGGGCATGGAGGAGAGGCATAAGATTCAAGTTTTTCAAAGGGAGCTCCCTCTCTGCTTGGAGCTTGTCACCCAACTGCCCAAGCCCA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ACTAC :  3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TTGGGCATGGAGGAGAGGCATAAGATTCAAGTTTTTCAAAGGGAGCTCCCTCTCTGCTTGGAGCTTGTCACCCAACTGCCCAAGCCCA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3</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TTGGGCATGGAGGAGAGGCATAAGATTCAAGTTTTTCAAAGGGAGCTCCCTCTCTGCTTGGAGCTTGTCACCCAACTGCCCAAGCCCA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3</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         *       340         *       360         *       380         *       4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GGAGAACACAAACCCTTCTCAAATTTCAGCTTAATTTTTGTGTTCTAAGTCGGAAGCTTCGTTTCTTTTGCTTGAATTGTTCTGGTTTCTGTTTTCAAAA :  4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         *       440         *       460         *       480         *       5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TTGGGGTTTTTTTTGTA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TGAGAGGTGCAAGCAGCAGATTTCAGATGCAACCGCAAATTACCTGCATGGACAATCTAAGTGTTCTGAGCAGACT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TGAGAGGTGCAAGCAGCAGATTTCAGATGCAACCGCAAATTACCTGCATGGACAATCTAAGTGTTCTGAGCAGACT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TGAGAGGTGCAAGCAGCAGATTTCAGATGCAACCGCAAATTACCTGCATGGACAATCTAAGTGTTCTGAGCAGACT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20         *       540         *       560         *       580         *       6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GAGGGGCATGTTTTTGAGGAATTCATTCCATTAACACGGATTTCATACAACTCCAGATGCACCACTCGAAG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ATAAAAAAAAGACTCCACCTT :  6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GAGGGGCATGTTTTTGAGGAATTCATTCCATTAACACGGATTTCATACAACTCCAGATGCACCACTCGAAG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2</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GAGGGGCATGTTTTTGAGGAATTCATTCCATTAACACGGATTTCATACAACTCCAGATGCACCACTCGAAGA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2</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20         *       640         *       660         *       680         *       7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CATCAATTTTAGTAAATTTTGTGACTGCCCTTTTGTTTGGTTGCTTATAAAATTTGAGGTGAAGAAGTGGAAAGTATTGATTTTTAG</a:t>
              </a:r>
              <a:r>
                <a:rPr lang="en-US" altLang="zh-CN" sz="800" kern="0" dirty="0">
                  <a:solidFill>
                    <a:srgbClr val="FFFFFF"/>
                  </a:solidFill>
                  <a:effectLst/>
                  <a:highlight>
                    <a:srgbClr val="808080"/>
                  </a:highlight>
                  <a:latin typeface="Courier"/>
                  <a:ea typeface="等线" panose="02010600030101010101" pitchFamily="2" charset="-122"/>
                  <a:cs typeface="Times New Roman" panose="02020603050405020304" pitchFamily="18" charset="0"/>
                </a:rPr>
                <a:t>GTGTAGGGT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808080"/>
                  </a:highlight>
                  <a:latin typeface="Courier"/>
                  <a:ea typeface="等线" panose="02010600030101010101" pitchFamily="2" charset="-122"/>
                  <a:cs typeface="Times New Roman" panose="02020603050405020304" pitchFamily="18" charset="0"/>
                </a:rPr>
                <a:t>GTGTAGGGT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20         *       740         *       760         *       780         *       8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808080"/>
                  </a:highlight>
                  <a:latin typeface="Courier"/>
                  <a:ea typeface="等线" panose="02010600030101010101" pitchFamily="2" charset="-122"/>
                  <a:cs typeface="Times New Roman" panose="02020603050405020304" pitchFamily="18" charset="0"/>
                </a:rPr>
                <a:t>GCA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AGCAAGTTAAAGGCTATAGTGATGGAGATGAAGAGAAATGGGGTGCTTTTCAGCCTTTCCAAGGGAAAAAAAAAGCATTGGAAAGACA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808080"/>
                  </a:highlight>
                  <a:latin typeface="Courier"/>
                  <a:ea typeface="等线" panose="02010600030101010101" pitchFamily="2" charset="-122"/>
                  <a:cs typeface="Times New Roman" panose="02020603050405020304" pitchFamily="18" charset="0"/>
                </a:rPr>
                <a:t>GCA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AGCAAGTTAAAGGCTATAGTGATGGAGATGAAGAGAAATGGGGTGCTTTTCAGCCTTTCCAAGGGAAAAAAAAAGCATTGGAAAGACA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6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AGCAAGTTAAAGGCTATAGTGATGGAGATGAAGAGAAATGGGGTGCTTTTCAGCCTTTCCAAGGGAAAAAAAAAGCATTGGAAAGACA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48</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20         *       840         *       860         *       880         *       9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GGTGGCTAAAGAACCTTCTTCGGCTCCGGCTACTAGTTCCACCACGGACACCGTGAGTGGAGACAGTGGTGGGAACAACAAGAACAAAGAGAA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GGTGGCTAAAGAACCTTCTTCGGCTCCGGCTACTAGTTCCACCACGGACACCGTGAGTGGAGACAGTGGTGGGAACAACAAGAACAAAGAGAA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6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GGTGGCTAAAGAACCTTCTTCGGCTCCGGCTACTAGTTCCACCACGGACACCGTGAGTGGAGACAGTGGTGGGAACAACAAGAACAAAGAGAA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48</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20         *       940         *       960         *       980         *      10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AGGGAAACGAAGGCGAAACTGGTCACCGGAGTTGCACCGCCGGTTCTTGCATGCTCTTCTCTTCAACAACTTGGTGGTTCACTTGGTATGCA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AGGGAAACGAAGGCGAAACTGGTCACCGGAGTTGCACCGCCGGTTCTTGCATGCTCTTCTCTTCAACAACTTGGTGGTTCACTTGGTATGCA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6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AGGGAAACGAAGGCGAAACTGGTCACCGGAGTTGCACCGCCGGTTCTTGCATGCTCTTCTCTTCAACAACTTGGTGGTTCACTTGGTATGCA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48</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20         *      1040         *      1060         *      1080         *      11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ATTAATTTAGTGGGATATGTTATTTTATATGATTGGATGAATATGTGATTGGATTGTGATGTATTGGATGTGTTTAATGCGTTCTGCGTATATG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ATTAATTTAGTGGGATATGTTATTTTATATGATTGGATGAATATGTGATTGGATTGTGATGTATTGGATGTGTTTAATGCGTTCTGCGTATATG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65</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ATTAATTTAGTGGGATATGTTATTTTATATGATTGGATGAATATGTGATTGGATTGTGATGTATTGGATGTGTTTAATGCGTTCTGCGTATATG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48</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20         *      114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CATCTGTTTTTAATCATAATTTGGTTGATGTGAAAAT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46</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CATCTGTTTTTAATCATAATTTGGTTGATGTGAAAAT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11</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CATCTGTTTTTAATCATAATTTGGTTGATGTGAAAAT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94</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zh-CN" altLang="en-US" sz="800" dirty="0"/>
            </a:p>
          </p:txBody>
        </p:sp>
        <p:sp>
          <p:nvSpPr>
            <p:cNvPr id="34" name="矩形 33">
              <a:extLst>
                <a:ext uri="{FF2B5EF4-FFF2-40B4-BE49-F238E27FC236}">
                  <a16:creationId xmlns:a16="http://schemas.microsoft.com/office/drawing/2014/main" id="{A2E14429-26CC-ABED-C231-7D4F94C06F51}"/>
                </a:ext>
              </a:extLst>
            </p:cNvPr>
            <p:cNvSpPr/>
            <p:nvPr/>
          </p:nvSpPr>
          <p:spPr>
            <a:xfrm>
              <a:off x="1341322" y="848687"/>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grpSp>
          <p:nvGrpSpPr>
            <p:cNvPr id="60" name="组合 59">
              <a:extLst>
                <a:ext uri="{FF2B5EF4-FFF2-40B4-BE49-F238E27FC236}">
                  <a16:creationId xmlns:a16="http://schemas.microsoft.com/office/drawing/2014/main" id="{DC52F545-3765-010F-04E7-68C74F377CFD}"/>
                </a:ext>
              </a:extLst>
            </p:cNvPr>
            <p:cNvGrpSpPr/>
            <p:nvPr/>
          </p:nvGrpSpPr>
          <p:grpSpPr>
            <a:xfrm>
              <a:off x="271452" y="452772"/>
              <a:ext cx="1308091" cy="5319848"/>
              <a:chOff x="271452" y="452772"/>
              <a:chExt cx="1308091" cy="5319848"/>
            </a:xfrm>
          </p:grpSpPr>
          <p:sp>
            <p:nvSpPr>
              <p:cNvPr id="26" name="文本框 25">
                <a:extLst>
                  <a:ext uri="{FF2B5EF4-FFF2-40B4-BE49-F238E27FC236}">
                    <a16:creationId xmlns:a16="http://schemas.microsoft.com/office/drawing/2014/main" id="{E23F773F-57A5-3634-E892-3BC01FB17431}"/>
                  </a:ext>
                </a:extLst>
              </p:cNvPr>
              <p:cNvSpPr txBox="1"/>
              <p:nvPr/>
            </p:nvSpPr>
            <p:spPr>
              <a:xfrm>
                <a:off x="275676" y="452772"/>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27" name="文本框 26">
                <a:extLst>
                  <a:ext uri="{FF2B5EF4-FFF2-40B4-BE49-F238E27FC236}">
                    <a16:creationId xmlns:a16="http://schemas.microsoft.com/office/drawing/2014/main" id="{A35939AD-260B-2481-0A4F-EFDD9FF9481C}"/>
                  </a:ext>
                </a:extLst>
              </p:cNvPr>
              <p:cNvSpPr txBox="1"/>
              <p:nvPr/>
            </p:nvSpPr>
            <p:spPr>
              <a:xfrm>
                <a:off x="275676" y="2060790"/>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28" name="文本框 27">
                <a:extLst>
                  <a:ext uri="{FF2B5EF4-FFF2-40B4-BE49-F238E27FC236}">
                    <a16:creationId xmlns:a16="http://schemas.microsoft.com/office/drawing/2014/main" id="{1EE0FB7F-EF74-556D-808C-B7609FB2EC5D}"/>
                  </a:ext>
                </a:extLst>
              </p:cNvPr>
              <p:cNvSpPr txBox="1"/>
              <p:nvPr/>
            </p:nvSpPr>
            <p:spPr>
              <a:xfrm>
                <a:off x="275676" y="2590806"/>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29" name="文本框 28">
                <a:extLst>
                  <a:ext uri="{FF2B5EF4-FFF2-40B4-BE49-F238E27FC236}">
                    <a16:creationId xmlns:a16="http://schemas.microsoft.com/office/drawing/2014/main" id="{6486905D-425D-CF90-0A2C-600096D920F2}"/>
                  </a:ext>
                </a:extLst>
              </p:cNvPr>
              <p:cNvSpPr txBox="1"/>
              <p:nvPr/>
            </p:nvSpPr>
            <p:spPr>
              <a:xfrm>
                <a:off x="275676" y="3129288"/>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30" name="文本框 29">
                <a:extLst>
                  <a:ext uri="{FF2B5EF4-FFF2-40B4-BE49-F238E27FC236}">
                    <a16:creationId xmlns:a16="http://schemas.microsoft.com/office/drawing/2014/main" id="{267988CC-DE96-9165-0F07-01132826E115}"/>
                  </a:ext>
                </a:extLst>
              </p:cNvPr>
              <p:cNvSpPr txBox="1"/>
              <p:nvPr/>
            </p:nvSpPr>
            <p:spPr>
              <a:xfrm>
                <a:off x="271452" y="5249400"/>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31" name="文本框 30">
                <a:extLst>
                  <a:ext uri="{FF2B5EF4-FFF2-40B4-BE49-F238E27FC236}">
                    <a16:creationId xmlns:a16="http://schemas.microsoft.com/office/drawing/2014/main" id="{BCDF5B00-A4A2-B137-0428-B0DDA767DC46}"/>
                  </a:ext>
                </a:extLst>
              </p:cNvPr>
              <p:cNvSpPr txBox="1"/>
              <p:nvPr/>
            </p:nvSpPr>
            <p:spPr>
              <a:xfrm>
                <a:off x="271996" y="4733711"/>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32" name="文本框 31">
                <a:extLst>
                  <a:ext uri="{FF2B5EF4-FFF2-40B4-BE49-F238E27FC236}">
                    <a16:creationId xmlns:a16="http://schemas.microsoft.com/office/drawing/2014/main" id="{9E559FD8-0768-183D-481B-EAFD26DCEB32}"/>
                  </a:ext>
                </a:extLst>
              </p:cNvPr>
              <p:cNvSpPr txBox="1"/>
              <p:nvPr/>
            </p:nvSpPr>
            <p:spPr>
              <a:xfrm>
                <a:off x="275676" y="986375"/>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33" name="文本框 32">
                <a:extLst>
                  <a:ext uri="{FF2B5EF4-FFF2-40B4-BE49-F238E27FC236}">
                    <a16:creationId xmlns:a16="http://schemas.microsoft.com/office/drawing/2014/main" id="{1DD37248-51B3-6438-E915-B7E41293233C}"/>
                  </a:ext>
                </a:extLst>
              </p:cNvPr>
              <p:cNvSpPr txBox="1"/>
              <p:nvPr/>
            </p:nvSpPr>
            <p:spPr>
              <a:xfrm>
                <a:off x="275676" y="1542628"/>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grpSp>
        <p:sp>
          <p:nvSpPr>
            <p:cNvPr id="51" name="矩形 50">
              <a:extLst>
                <a:ext uri="{FF2B5EF4-FFF2-40B4-BE49-F238E27FC236}">
                  <a16:creationId xmlns:a16="http://schemas.microsoft.com/office/drawing/2014/main" id="{00BA24CA-21EC-6DE2-AE19-52469CF6B32F}"/>
                </a:ext>
              </a:extLst>
            </p:cNvPr>
            <p:cNvSpPr/>
            <p:nvPr/>
          </p:nvSpPr>
          <p:spPr>
            <a:xfrm>
              <a:off x="1341322" y="1359155"/>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3" name="矩形 52">
              <a:extLst>
                <a:ext uri="{FF2B5EF4-FFF2-40B4-BE49-F238E27FC236}">
                  <a16:creationId xmlns:a16="http://schemas.microsoft.com/office/drawing/2014/main" id="{C5FAB49B-76FF-E5A9-D53C-CFDEB0665A84}"/>
                </a:ext>
              </a:extLst>
            </p:cNvPr>
            <p:cNvSpPr/>
            <p:nvPr/>
          </p:nvSpPr>
          <p:spPr>
            <a:xfrm>
              <a:off x="1341322" y="1912534"/>
              <a:ext cx="5616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4" name="矩形 53">
              <a:extLst>
                <a:ext uri="{FF2B5EF4-FFF2-40B4-BE49-F238E27FC236}">
                  <a16:creationId xmlns:a16="http://schemas.microsoft.com/office/drawing/2014/main" id="{651C4F56-7C48-A638-2CAB-1CB3B5633814}"/>
                </a:ext>
              </a:extLst>
            </p:cNvPr>
            <p:cNvSpPr/>
            <p:nvPr/>
          </p:nvSpPr>
          <p:spPr>
            <a:xfrm>
              <a:off x="2418282" y="2979332"/>
              <a:ext cx="493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5" name="矩形 54">
              <a:extLst>
                <a:ext uri="{FF2B5EF4-FFF2-40B4-BE49-F238E27FC236}">
                  <a16:creationId xmlns:a16="http://schemas.microsoft.com/office/drawing/2014/main" id="{1971989E-0186-CE6A-CCAE-4C13B152EC30}"/>
                </a:ext>
              </a:extLst>
            </p:cNvPr>
            <p:cNvSpPr/>
            <p:nvPr/>
          </p:nvSpPr>
          <p:spPr>
            <a:xfrm>
              <a:off x="1341322" y="3495711"/>
              <a:ext cx="4608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6" name="矩形 55">
              <a:extLst>
                <a:ext uri="{FF2B5EF4-FFF2-40B4-BE49-F238E27FC236}">
                  <a16:creationId xmlns:a16="http://schemas.microsoft.com/office/drawing/2014/main" id="{EA439167-0AC3-9015-819A-B7066D81578F}"/>
                </a:ext>
              </a:extLst>
            </p:cNvPr>
            <p:cNvSpPr/>
            <p:nvPr/>
          </p:nvSpPr>
          <p:spPr>
            <a:xfrm>
              <a:off x="1341322" y="4571397"/>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7" name="矩形 56">
              <a:extLst>
                <a:ext uri="{FF2B5EF4-FFF2-40B4-BE49-F238E27FC236}">
                  <a16:creationId xmlns:a16="http://schemas.microsoft.com/office/drawing/2014/main" id="{AC8D5464-A824-384A-6B5E-026CDB151B5C}"/>
                </a:ext>
              </a:extLst>
            </p:cNvPr>
            <p:cNvSpPr/>
            <p:nvPr/>
          </p:nvSpPr>
          <p:spPr>
            <a:xfrm>
              <a:off x="1341322" y="5105532"/>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8" name="矩形 57">
              <a:extLst>
                <a:ext uri="{FF2B5EF4-FFF2-40B4-BE49-F238E27FC236}">
                  <a16:creationId xmlns:a16="http://schemas.microsoft.com/office/drawing/2014/main" id="{DDDD2672-2629-8158-1285-0EDD6B1D0527}"/>
                </a:ext>
              </a:extLst>
            </p:cNvPr>
            <p:cNvSpPr/>
            <p:nvPr/>
          </p:nvSpPr>
          <p:spPr>
            <a:xfrm>
              <a:off x="1341322" y="5630801"/>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59" name="矩形 58">
              <a:extLst>
                <a:ext uri="{FF2B5EF4-FFF2-40B4-BE49-F238E27FC236}">
                  <a16:creationId xmlns:a16="http://schemas.microsoft.com/office/drawing/2014/main" id="{6F6594E4-D25F-0BE1-A2D8-774AABA25B16}"/>
                </a:ext>
              </a:extLst>
            </p:cNvPr>
            <p:cNvSpPr/>
            <p:nvPr/>
          </p:nvSpPr>
          <p:spPr>
            <a:xfrm>
              <a:off x="1341322" y="6164934"/>
              <a:ext cx="601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42" name="文本框 41">
              <a:extLst>
                <a:ext uri="{FF2B5EF4-FFF2-40B4-BE49-F238E27FC236}">
                  <a16:creationId xmlns:a16="http://schemas.microsoft.com/office/drawing/2014/main" id="{B520A488-B169-FAD9-3C54-740AF34159EE}"/>
                </a:ext>
              </a:extLst>
            </p:cNvPr>
            <p:cNvSpPr txBox="1"/>
            <p:nvPr/>
          </p:nvSpPr>
          <p:spPr>
            <a:xfrm>
              <a:off x="4050445" y="1251768"/>
              <a:ext cx="797539" cy="276999"/>
            </a:xfrm>
            <a:prstGeom prst="rect">
              <a:avLst/>
            </a:prstGeom>
            <a:noFill/>
          </p:spPr>
          <p:txBody>
            <a:bodyPr wrap="square" rtlCol="0">
              <a:spAutoFit/>
            </a:bodyPr>
            <a:lstStyle/>
            <a:p>
              <a:r>
                <a:rPr lang="en-US" altLang="zh-CN" sz="1200" b="1" dirty="0">
                  <a:solidFill>
                    <a:srgbClr val="FF0000"/>
                  </a:solidFill>
                  <a:latin typeface="Times New Roman" panose="02020603050405020304" pitchFamily="18" charset="0"/>
                  <a:cs typeface="Times New Roman" panose="02020603050405020304" pitchFamily="18" charset="0"/>
                </a:rPr>
                <a:t>exon1</a:t>
              </a:r>
              <a:endParaRPr lang="zh-CN" altLang="en-US" sz="1200" b="1" dirty="0">
                <a:solidFill>
                  <a:srgbClr val="FF0000"/>
                </a:solidFill>
                <a:latin typeface="Times New Roman" panose="02020603050405020304" pitchFamily="18" charset="0"/>
                <a:cs typeface="Times New Roman" panose="02020603050405020304" pitchFamily="18" charset="0"/>
              </a:endParaRPr>
            </a:p>
          </p:txBody>
        </p:sp>
        <p:sp>
          <p:nvSpPr>
            <p:cNvPr id="43" name="文本框 42">
              <a:extLst>
                <a:ext uri="{FF2B5EF4-FFF2-40B4-BE49-F238E27FC236}">
                  <a16:creationId xmlns:a16="http://schemas.microsoft.com/office/drawing/2014/main" id="{900C21BB-0C87-03D3-E146-7C761F35FD1B}"/>
                </a:ext>
              </a:extLst>
            </p:cNvPr>
            <p:cNvSpPr txBox="1"/>
            <p:nvPr/>
          </p:nvSpPr>
          <p:spPr>
            <a:xfrm>
              <a:off x="4105402" y="2874332"/>
              <a:ext cx="797539" cy="276999"/>
            </a:xfrm>
            <a:prstGeom prst="rect">
              <a:avLst/>
            </a:prstGeom>
            <a:noFill/>
          </p:spPr>
          <p:txBody>
            <a:bodyPr wrap="square" rtlCol="0">
              <a:spAutoFit/>
            </a:bodyPr>
            <a:lstStyle/>
            <a:p>
              <a:r>
                <a:rPr lang="en-US" altLang="zh-CN" sz="1200" b="1" dirty="0">
                  <a:solidFill>
                    <a:srgbClr val="FF0000"/>
                  </a:solidFill>
                  <a:latin typeface="Times New Roman" panose="02020603050405020304" pitchFamily="18" charset="0"/>
                  <a:cs typeface="Times New Roman" panose="02020603050405020304" pitchFamily="18" charset="0"/>
                </a:rPr>
                <a:t>exon2</a:t>
              </a:r>
              <a:endParaRPr lang="zh-CN" altLang="en-US" sz="1200" b="1" dirty="0">
                <a:solidFill>
                  <a:srgbClr val="FF0000"/>
                </a:solidFill>
                <a:latin typeface="Times New Roman" panose="02020603050405020304" pitchFamily="18" charset="0"/>
                <a:cs typeface="Times New Roman" panose="02020603050405020304" pitchFamily="18" charset="0"/>
              </a:endParaRPr>
            </a:p>
          </p:txBody>
        </p:sp>
        <p:sp>
          <p:nvSpPr>
            <p:cNvPr id="61" name="矩形 60">
              <a:extLst>
                <a:ext uri="{FF2B5EF4-FFF2-40B4-BE49-F238E27FC236}">
                  <a16:creationId xmlns:a16="http://schemas.microsoft.com/office/drawing/2014/main" id="{18F1CD4A-2D37-EAE7-8521-1437693D45BD}"/>
                </a:ext>
              </a:extLst>
            </p:cNvPr>
            <p:cNvSpPr/>
            <p:nvPr/>
          </p:nvSpPr>
          <p:spPr>
            <a:xfrm>
              <a:off x="6553402" y="3992277"/>
              <a:ext cx="79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62" name="矩形 61">
              <a:extLst>
                <a:ext uri="{FF2B5EF4-FFF2-40B4-BE49-F238E27FC236}">
                  <a16:creationId xmlns:a16="http://schemas.microsoft.com/office/drawing/2014/main" id="{FDB9B180-B043-26D0-3683-E2722F6AEB26}"/>
                </a:ext>
              </a:extLst>
            </p:cNvPr>
            <p:cNvSpPr/>
            <p:nvPr/>
          </p:nvSpPr>
          <p:spPr>
            <a:xfrm>
              <a:off x="1333402" y="6699067"/>
              <a:ext cx="2772000" cy="108000"/>
            </a:xfrm>
            <a:prstGeom prst="rect">
              <a:avLst/>
            </a:prstGeom>
            <a:solidFill>
              <a:srgbClr val="00B0F0"/>
            </a:solidFill>
            <a:ln w="12700" cap="flat" cmpd="sng" algn="ctr">
              <a:solidFill>
                <a:sysClr val="windowText" lastClr="000000"/>
              </a:solidFill>
              <a:prstDash val="solid"/>
              <a:miter lim="800000"/>
            </a:ln>
            <a:effectLst/>
            <a:scene3d>
              <a:camera prst="orthographicFront"/>
              <a:lightRig rig="threePt" dir="t"/>
            </a:scene3d>
            <a:sp3d>
              <a:bevelT w="165100" prst="coolSlant"/>
            </a:sp3d>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zh-CN" altLang="en-US" sz="1800" b="0" i="0" u="none" strike="noStrike" kern="0" cap="none" spc="0" normalizeH="0" baseline="0" noProof="0" dirty="0">
                <a:ln>
                  <a:noFill/>
                </a:ln>
                <a:solidFill>
                  <a:prstClr val="white"/>
                </a:solidFill>
                <a:effectLst/>
                <a:uLnTx/>
                <a:uFillTx/>
                <a:latin typeface="Times New Roman" panose="02020603050405020304" pitchFamily="18" charset="0"/>
                <a:ea typeface="宋体" panose="02010600030101010101" pitchFamily="2" charset="-122"/>
                <a:cs typeface="Times New Roman" panose="02020603050405020304" pitchFamily="18" charset="0"/>
              </a:endParaRPr>
            </a:p>
          </p:txBody>
        </p:sp>
        <p:sp>
          <p:nvSpPr>
            <p:cNvPr id="63" name="文本框 62">
              <a:extLst>
                <a:ext uri="{FF2B5EF4-FFF2-40B4-BE49-F238E27FC236}">
                  <a16:creationId xmlns:a16="http://schemas.microsoft.com/office/drawing/2014/main" id="{B7CFF94F-4EAC-9A05-1903-88CD828163B3}"/>
                </a:ext>
              </a:extLst>
            </p:cNvPr>
            <p:cNvSpPr txBox="1"/>
            <p:nvPr/>
          </p:nvSpPr>
          <p:spPr>
            <a:xfrm>
              <a:off x="271997" y="3655095"/>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64" name="文本框 63">
              <a:extLst>
                <a:ext uri="{FF2B5EF4-FFF2-40B4-BE49-F238E27FC236}">
                  <a16:creationId xmlns:a16="http://schemas.microsoft.com/office/drawing/2014/main" id="{ACEB44DB-AEA1-FFB8-D546-074F6E9609DB}"/>
                </a:ext>
              </a:extLst>
            </p:cNvPr>
            <p:cNvSpPr txBox="1"/>
            <p:nvPr/>
          </p:nvSpPr>
          <p:spPr>
            <a:xfrm>
              <a:off x="271997" y="4173257"/>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65" name="文本框 64">
              <a:extLst>
                <a:ext uri="{FF2B5EF4-FFF2-40B4-BE49-F238E27FC236}">
                  <a16:creationId xmlns:a16="http://schemas.microsoft.com/office/drawing/2014/main" id="{75302349-C0DF-B2B0-A931-D3FAA47CCBF7}"/>
                </a:ext>
              </a:extLst>
            </p:cNvPr>
            <p:cNvSpPr txBox="1"/>
            <p:nvPr/>
          </p:nvSpPr>
          <p:spPr>
            <a:xfrm>
              <a:off x="271451" y="6313145"/>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66" name="文本框 65">
              <a:extLst>
                <a:ext uri="{FF2B5EF4-FFF2-40B4-BE49-F238E27FC236}">
                  <a16:creationId xmlns:a16="http://schemas.microsoft.com/office/drawing/2014/main" id="{46897BD9-A87A-E4AF-CAC6-8399DF8AC841}"/>
                </a:ext>
              </a:extLst>
            </p:cNvPr>
            <p:cNvSpPr txBox="1"/>
            <p:nvPr/>
          </p:nvSpPr>
          <p:spPr>
            <a:xfrm>
              <a:off x="271451" y="5793978"/>
              <a:ext cx="1303867" cy="523220"/>
            </a:xfrm>
            <a:prstGeom prst="rect">
              <a:avLst/>
            </a:prstGeom>
            <a:noFill/>
          </p:spPr>
          <p:txBody>
            <a:bodyPr wrap="square" rtlCol="0">
              <a:spAutoFit/>
            </a:bodyPr>
            <a:lstStyle/>
            <a:p>
              <a:pPr algn="just">
                <a:lnSpc>
                  <a:spcPts val="800"/>
                </a:lnSpc>
              </a:pPr>
              <a:r>
                <a:rPr lang="en-US" altLang="zh-CN" sz="800" b="1" dirty="0">
                  <a:latin typeface="Times New Roman" panose="02020603050405020304" pitchFamily="18" charset="0"/>
                  <a:cs typeface="Times New Roman" panose="02020603050405020304" pitchFamily="18" charset="0"/>
                </a:rPr>
                <a:t>lncRNA(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1(cDNA)</a:t>
              </a:r>
            </a:p>
            <a:p>
              <a:pPr algn="just">
                <a:lnSpc>
                  <a:spcPts val="800"/>
                </a:lnSpc>
              </a:pPr>
              <a:r>
                <a:rPr lang="en-US" altLang="zh-CN" sz="800" b="1" dirty="0">
                  <a:latin typeface="Times New Roman" panose="02020603050405020304" pitchFamily="18" charset="0"/>
                  <a:cs typeface="Times New Roman" panose="02020603050405020304" pitchFamily="18" charset="0"/>
                </a:rPr>
                <a:t>lncRNA</a:t>
              </a:r>
              <a:r>
                <a:rPr lang="ko-KR" altLang="zh-CN" sz="800" b="1" kern="0" dirty="0">
                  <a:effectLst/>
                  <a:latin typeface="Times New Roman" panose="02020603050405020304" pitchFamily="18" charset="0"/>
                  <a:ea typeface="Batang" panose="02030600000101010101" pitchFamily="18" charset="-127"/>
                  <a:cs typeface="Times New Roman" panose="02020603050405020304" pitchFamily="18" charset="0"/>
                </a:rPr>
                <a:t>×</a:t>
              </a:r>
              <a:r>
                <a:rPr lang="en-US" altLang="ko-KR" sz="800" b="1" kern="0" dirty="0">
                  <a:effectLst/>
                  <a:latin typeface="Times New Roman" panose="02020603050405020304" pitchFamily="18" charset="0"/>
                  <a:ea typeface="Batang" panose="02030600000101010101" pitchFamily="18" charset="-127"/>
                  <a:cs typeface="Times New Roman" panose="02020603050405020304" pitchFamily="18" charset="0"/>
                </a:rPr>
                <a:t>2(cDNA)</a:t>
              </a:r>
              <a:endParaRPr lang="en-US" altLang="zh-CN" sz="800" b="1" dirty="0">
                <a:latin typeface="Times New Roman" panose="02020603050405020304" pitchFamily="18" charset="0"/>
                <a:cs typeface="Times New Roman" panose="02020603050405020304" pitchFamily="18" charset="0"/>
              </a:endParaRPr>
            </a:p>
            <a:p>
              <a:endParaRPr lang="en-US" altLang="zh-CN" sz="800" dirty="0">
                <a:latin typeface="Times New Roman" panose="02020603050405020304" pitchFamily="18" charset="0"/>
                <a:cs typeface="Times New Roman" panose="02020603050405020304" pitchFamily="18" charset="0"/>
              </a:endParaRPr>
            </a:p>
          </p:txBody>
        </p:sp>
        <p:sp>
          <p:nvSpPr>
            <p:cNvPr id="44" name="文本框 43">
              <a:extLst>
                <a:ext uri="{FF2B5EF4-FFF2-40B4-BE49-F238E27FC236}">
                  <a16:creationId xmlns:a16="http://schemas.microsoft.com/office/drawing/2014/main" id="{B742BA43-786E-C055-3453-A1B7EC2740F5}"/>
                </a:ext>
              </a:extLst>
            </p:cNvPr>
            <p:cNvSpPr txBox="1"/>
            <p:nvPr/>
          </p:nvSpPr>
          <p:spPr>
            <a:xfrm>
              <a:off x="4149322" y="4995321"/>
              <a:ext cx="797539" cy="276999"/>
            </a:xfrm>
            <a:prstGeom prst="rect">
              <a:avLst/>
            </a:prstGeom>
            <a:noFill/>
          </p:spPr>
          <p:txBody>
            <a:bodyPr wrap="square" rtlCol="0">
              <a:spAutoFit/>
            </a:bodyPr>
            <a:lstStyle/>
            <a:p>
              <a:r>
                <a:rPr lang="en-US" altLang="zh-CN" sz="1200" b="1" dirty="0">
                  <a:solidFill>
                    <a:srgbClr val="FF0000"/>
                  </a:solidFill>
                  <a:latin typeface="Times New Roman" panose="02020603050405020304" pitchFamily="18" charset="0"/>
                  <a:cs typeface="Times New Roman" panose="02020603050405020304" pitchFamily="18" charset="0"/>
                </a:rPr>
                <a:t>exon3</a:t>
              </a:r>
              <a:endParaRPr lang="zh-CN" altLang="en-US" sz="1200" b="1" dirty="0">
                <a:solidFill>
                  <a:srgbClr val="FF0000"/>
                </a:solidFill>
                <a:latin typeface="Times New Roman" panose="02020603050405020304" pitchFamily="18" charset="0"/>
                <a:cs typeface="Times New Roman" panose="02020603050405020304" pitchFamily="18" charset="0"/>
              </a:endParaRPr>
            </a:p>
          </p:txBody>
        </p:sp>
      </p:grpSp>
      <p:sp>
        <p:nvSpPr>
          <p:cNvPr id="72" name="文本框 71">
            <a:extLst>
              <a:ext uri="{FF2B5EF4-FFF2-40B4-BE49-F238E27FC236}">
                <a16:creationId xmlns:a16="http://schemas.microsoft.com/office/drawing/2014/main" id="{647828BC-4D27-8212-B998-07CDB8A93FDA}"/>
              </a:ext>
            </a:extLst>
          </p:cNvPr>
          <p:cNvSpPr txBox="1"/>
          <p:nvPr/>
        </p:nvSpPr>
        <p:spPr>
          <a:xfrm>
            <a:off x="167831" y="6401740"/>
            <a:ext cx="11926838" cy="523220"/>
          </a:xfrm>
          <a:prstGeom prst="rect">
            <a:avLst/>
          </a:prstGeom>
          <a:noFill/>
        </p:spPr>
        <p:txBody>
          <a:bodyPr wrap="square">
            <a:spAutoFit/>
          </a:bodyPr>
          <a:lstStyle/>
          <a:p>
            <a:pPr algn="just"/>
            <a:r>
              <a:rPr lang="en-US" altLang="zh-CN" sz="1400" b="1" dirty="0">
                <a:effectLst/>
                <a:latin typeface="Times New Roman" panose="02020603050405020304" pitchFamily="18" charset="0"/>
                <a:ea typeface="等线" panose="02010600030101010101" pitchFamily="2" charset="-122"/>
              </a:rPr>
              <a:t>Supplemental Figure S3. cDNA sequence of two</a:t>
            </a:r>
            <a:r>
              <a:rPr lang="en-US" altLang="zh-CN" sz="1400" b="1" i="1" dirty="0">
                <a:effectLst/>
                <a:latin typeface="Times New Roman" panose="02020603050405020304" pitchFamily="18" charset="0"/>
                <a:ea typeface="等线" panose="02010600030101010101" pitchFamily="2" charset="-122"/>
              </a:rPr>
              <a:t> lncRNA</a:t>
            </a:r>
            <a:r>
              <a:rPr lang="en-US" altLang="zh-CN" sz="1400" b="1" dirty="0">
                <a:effectLst/>
                <a:latin typeface="Times New Roman" panose="02020603050405020304" pitchFamily="18" charset="0"/>
                <a:ea typeface="等线" panose="02010600030101010101" pitchFamily="2" charset="-122"/>
              </a:rPr>
              <a:t> transcript isoforms. </a:t>
            </a:r>
            <a:r>
              <a:rPr lang="en-US" altLang="zh-CN" sz="1400" dirty="0">
                <a:effectLst/>
                <a:latin typeface="Times New Roman" panose="02020603050405020304" pitchFamily="18" charset="0"/>
                <a:ea typeface="等线" panose="02010600030101010101" pitchFamily="2" charset="-122"/>
              </a:rPr>
              <a:t>Two lncRNA cDNA sequences of 911 bp and 894 bp were cloned from ‘</a:t>
            </a:r>
            <a:r>
              <a:rPr lang="en-US" altLang="zh-CN" sz="1400" dirty="0" err="1">
                <a:effectLst/>
                <a:latin typeface="Times New Roman" panose="02020603050405020304" pitchFamily="18" charset="0"/>
                <a:ea typeface="等线" panose="02010600030101010101" pitchFamily="2" charset="-122"/>
              </a:rPr>
              <a:t>Huashuo</a:t>
            </a:r>
            <a:r>
              <a:rPr lang="en-US" altLang="zh-CN" sz="1400" dirty="0">
                <a:effectLst/>
                <a:latin typeface="Times New Roman" panose="02020603050405020304" pitchFamily="18" charset="0"/>
                <a:ea typeface="等线" panose="02010600030101010101" pitchFamily="2" charset="-122"/>
              </a:rPr>
              <a:t>’ fruit flesh. lncRNA DNA and lncRNA cDNA sequences were aligned using </a:t>
            </a:r>
            <a:r>
              <a:rPr lang="en-US" altLang="zh-CN" sz="1400" dirty="0" err="1">
                <a:effectLst/>
                <a:latin typeface="Times New Roman" panose="02020603050405020304" pitchFamily="18" charset="0"/>
                <a:ea typeface="等线" panose="02010600030101010101" pitchFamily="2" charset="-122"/>
              </a:rPr>
              <a:t>Geneious</a:t>
            </a:r>
            <a:r>
              <a:rPr lang="en-US" altLang="zh-CN" sz="1400" dirty="0">
                <a:effectLst/>
                <a:latin typeface="Times New Roman" panose="02020603050405020304" pitchFamily="18" charset="0"/>
                <a:ea typeface="等线" panose="02010600030101010101" pitchFamily="2" charset="-122"/>
              </a:rPr>
              <a:t> software v9.1.4. The blue diamond showed the three exons of lncRNA.</a:t>
            </a:r>
            <a:endParaRPr lang="zh-CN" altLang="en-US" sz="1400" dirty="0"/>
          </a:p>
        </p:txBody>
      </p:sp>
    </p:spTree>
    <p:extLst>
      <p:ext uri="{BB962C8B-B14F-4D97-AF65-F5344CB8AC3E}">
        <p14:creationId xmlns:p14="http://schemas.microsoft.com/office/powerpoint/2010/main" val="24758695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文本框 4">
            <a:extLst>
              <a:ext uri="{FF2B5EF4-FFF2-40B4-BE49-F238E27FC236}">
                <a16:creationId xmlns:a16="http://schemas.microsoft.com/office/drawing/2014/main" id="{04D189E6-29E8-46FB-BC1F-CD47866F2FC5}"/>
              </a:ext>
            </a:extLst>
          </p:cNvPr>
          <p:cNvSpPr txBox="1"/>
          <p:nvPr/>
        </p:nvSpPr>
        <p:spPr>
          <a:xfrm>
            <a:off x="241978" y="456324"/>
            <a:ext cx="11862816" cy="5749266"/>
          </a:xfrm>
          <a:prstGeom prst="rect">
            <a:avLst/>
          </a:prstGeom>
          <a:noFill/>
        </p:spPr>
        <p:txBody>
          <a:bodyPr wrap="square">
            <a:spAutoFit/>
          </a:bodyPr>
          <a:lstStyle/>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         *        40         *        60         *        80         *       100         *       120         *       140         *       160         *       180         *       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GTAAATCGTTGATTAGCG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C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G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GGGCAATTGTCCAGGGCCCAAAGTTG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CAAAAAACAAAATCCAAATAATTAGGTATAA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GCCCAAAATA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CTTGTCCAGGTTTTGGG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CAATAT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9</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G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G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GGGCAATTGTCCAGGGCCCAAAGTTG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CAAAAAACAAAATCCAAATAATTAGGTATAA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GCCCAAAATA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CTTGTCCAGGTTTTGGG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CAATAT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ACACTTATGTGAG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C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G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GGGCAATTGTCCAGGGCCCAAAGTTG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CAAAAAACAAAATCCAAATAATTAGGTATAA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GCCCAAAATA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CTTGTCCAGGTTTTGGG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CAATAT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CTTTGGCAAAAGCAAGGTGC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C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G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GGGCAATTGTCCAGGGCCCAAAGTTG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CAAAAAACAAAATCCAAATAATTAGGTATAA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GCCCAAAATA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CTTGTCCAGGTTTTGGG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CAATAT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GTGTGT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C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G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GGGCAATTGTCCAGGGCCCAAAGTTG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CCAAAAAACAAAATCCAAATAATTAGGTATAA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GCCCAAAATA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CTTGTCCAGGTTTTGGG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CAATAT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         *       240         *       260         *       280         *       300         *       320         *       340         *       360         *       380         *       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TA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GTCGTCCAGGTTTTGGGCATGGAGGAGAGGCATAAGATTCAAGTT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AGCT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GGAGCTT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CAAC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CCCAAGGTACTACGGAGAACACAAACC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TTCAGCTTAATTTTTGTGTTCTAAGTCGGAAGCTTCGTTTC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TA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GTCGTCCAGGTTTTGGGCATGGAGGAGAGGCATAAGATTCAAGTT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AGCT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GGAGCTT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CAAC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CCCAAGGTACTACGGAGAACACAAACC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TTCAGCTTAATTTTTGTGTTCTAAGTCGGAAGCTTCGTTTC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TA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GTCGTCCAGGTTTTGGGCATGGAGGAGAGGCATAAGATTCAAGTT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AGCT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GGAGCTT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CAAC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CCCAAGGTACTACGGAGAACACAAACC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TTCAGCTTAATTTTTGTGTTCTAAGTCGGAAGCTTCGTTTC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TA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GTCGTCCAGGTTTTGGGCATGGAGGAGAGGCATAAGATTCAAGTT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AGCT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GGAGCTT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CAAC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CCCAAGGTACTACGGAGAACACAAACC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TTCAGCTTAATTTTTGTGTTCTAAGTCGGAAGCTTCGTTTC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TA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GTCGTCCAGGTTTTGGGCATGGAGGAGAGGCATAAGATTCAAGTT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AGCT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GGAGCTT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CAAC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CCCAAGGTACTACGGAGAACACAAACC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TTCAGCTTAATTTTTGTGTTCTAAGTCGGAAGCTTCGTTTC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8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         *       440         *       460         *       480         *       500         *       520         *       540         *       560         *       580         *       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AATTGTTCTGGTTTCTGTTTTCAAAATTGGGG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ATTGAGAGGTGCAAGCAGC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ACC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ACCTGCATGGACAATCTAAGTGTTCTGAGCAGACTTCAAGTGAGG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GAGGAATTCATTCCATTAACACGGATTTCATACAACTCCAGATGC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9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AATTGTTCTGGTTTCTGTTTTCAAAATTGGGG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ATTGAGAGGTGCAAGCAGC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ACC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ACCTGCATGGACAATCTAAGTGTTCTGAGCAGACTTCAAGTGAGG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GAGGAATTCATTCCATTAACACGGATTTCATACAACTCCAGATGC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7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AATTGTTCTGGTTTCTGTTTTCAAAATTGGGG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ATTGAGAGGTGCAAGCAGC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ACC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ACCTGCATGGACAATCTAAGTGTTCTGAGCAGACTTCAAGTGAGG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GAGGAATTCATTCCATTAACACGGATTTCATACAACTCCAGATGC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AATTGTTCTGGTTTCTGTTTTCAAAATTGGGG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ATTGAGAGGTGCAAGCAGC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ACC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ACCTGCATGGACAATCTAAGTGTTCTGAGCAGACTTCAAGTGAGG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GAGGAATTCATTCCATTAACACGGATTTCATACAACTCCAGATGC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AATTGTTCTGGTTTCTGTTTTCAAAATTGGGG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ATTGAGAGGTGCAAGCAGC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ACC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ACCTGCATGGACAATCTAAGTGTTCTGAGCAGACTTCAAGTGAGG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GAGGAATTCATTCCATTAACACGGATTTCATACAACTCCAGATGC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8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20         *       640         *       660         *       680         *       700         *       720         *       740         *       760         *       780         *       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AT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TCCACCTTCATCAATTTTAGTAAATTTTGTGACTGCCCTTTTGTTTGGTTGCTTATAAAATTTGAGGTGAAGAAGTGGAAAGTATTGATTTTTAGGTGTAGGGTAATGGCAGGAGGAGCAAGTTAAAGGCTATAGTGATGGAGATGAAGAGAAATGGGGTGCTTTTCAGCCTT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9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AT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TCCACCTTCATCAATTTTAGTAAATTTTGTGACTGCCCTTTTGTTTGGTTGCTTATAAAATTTGAGGTGAAGAAGTGGAAAGTATTGATTTTTAGGTGTAGGGTAATGGCAGGAGGAGCAAGTTAAAGGCTATAGTGATGGAGATGAAGAGAAATGGGGTGCTTTTCAGCCTT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7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AT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TCCACCTTCATCAATTTTAGTAAATTTTGTGACTGCCCTTTTGTTTGGTTGCTTATAAAATTTGAGGTGAAGAAGTGGAAAGTATTGATTTTTAGGTGTAGGGTAATGGCAGGAGGAGCAAGTTAAAGGCTATAGTGATGGAGATGAAGAGAAATGGGGTGCTTTTCAGCCTT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AT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TCCACCTTCATCAATTTTAGTAAATTTTGTGACTGCCCTTTTGTTTGGTTGCTTATAAAATTTGAGGTGAAGAAGTGGAAAGTATTGATTTTTAGGTGTAGGGTAATGGCAGGAGGAGCAAGTTAAAGGCTATAGTGATGGAGATGAAGAGAAATGGGGTGCTTTTCAGCCTT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TATAA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TCCACCTTCATCAATTTTAGTAAATTTTGTGACTGCCCTTTTGTTTGGTTGCTTATAAAATTTGAGGTGAAGAAGTGGAAAGTATTGATTTTTAGGTGTAGGGTAATGGCAGGAGGAGCAAGTTAAAGGCTATAGTGATGGAGATGAAGAGAAATGGGGTGCTTTTCAGCCTT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8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20         *       840         *       860         *       880         *       900         *       920         *       940         *       960         *       980         *      1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AAAAGCATTGGAAAGACA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GGCTAAAGAACCTTCTTCGGCTCCGGCTACTAGTTCCACCACGGACACC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GACAGTGGTGGGAACAACA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GAAA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G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92</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AAAAGCATTGGAAAGACA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GGCTAAAGAACCTTCTTCGGCTCCGGCTACTAGTTCCACCACGGACACC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GACAGTGGTGGGAACAACA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GAAA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G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72</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AAAAGCATTGGAAAGACA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GGCTAAAGAACCTTCTTCGGCTCCGGCTACTAGTTCCACCACGGACACC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GACAGTGGTGGGAACAACA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GAAA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G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9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AAAAGCATTGGAAAGACA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GGCTAAAGAACCTTCTTCGGCTCCGGCTACTAGTTCCACCACGGACACC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GACAGTGGTGGGAACAACA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GAAA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G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94</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AAAAGCATTGGAAAGACA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GGCTAAAGAACCTTCTTCGGCTCCGGCTACTAGTTCCACCACGGACACC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GACAGTGGTGGGAACAACA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AGAAA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G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8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20         *      1040         *      1060         *      1080         *      1100         *      1120         *      1140         *      1160         *      1180         *      1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ACAACTTGGTGGT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TGCAGTTGAGATTAATTTAGTGGGATATGTTATTTTATATGATTGGATGAATATGTGATTGG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ATTGGATGTGTTTAATGCGT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ATGTGATTTTCC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AATCATAATTTGGTTGATG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C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1</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ACAACTTGGTGGT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TGCAGTTGAGATTAATTTAGTGGGATATGTTATTTTATATGATTGGATGAATATGTGATTGG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ATTGGATGTGTTTAATGCGT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ATGTGATTTTCC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AATCATAATTTGGTTGATG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C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72</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ACAACTTGGTGGT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TGCAGTTGAGATTAATTTAGTGGGATATGTTATTTTATATGATTGGATGAATATGTGATTGG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ATTGGATGTGTTTAATGCGT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ATGTGATTTTCC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AATCATAATTTGGTTGATG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C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ACAACTTGGTGGT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TGCAGTTGAGATTAATTTAGTGGGATATGTTATTTTATATGATTGGATGAATATGTGATTGG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ATTGGATGTGTTTAATGCGT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ATGTGATTTTCC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AATCATAATTTGGTTGATG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ACAACTTGGTGGT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TGCAGTTGAGATTAATTTAGTGGGATATGTTATTTTATATGATTGGATGAATATGTGATTGGA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ATTGGATGTGTTTAATGCGTT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ATGTGATTTTCC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AATCATAATTTGGTTGATG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C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8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endParaRPr>
          </a:p>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20         *      1240         *      1260         *      1280         *      1300         *      1320         *      1340         *      1360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CATGCTACTAGTG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CATACATGT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GCAAAATATTTATTTTA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A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GGAC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TAGCGTAACACTCCCTC---- : 1359</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CATGCTACTAGTG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CATACATGT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GCAAAATATTTATTTTA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G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A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GGAC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TGAGGTGAAACCCCCGA---- : 134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5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CATGCTACTAGTG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CATACATGT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GCAAAATATTTATTTTA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G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A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GGAC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G-------------------- : 1348</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CATGCTACTAGTG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CATACATGT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GCAAAATATTTATTTTA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TG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A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GGAC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AGGTTGCCCATTTGATTTATT : 136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hr10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A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CATGCTACTAGTG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CATACATGTGAT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GCAAAATATTTATTTTA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TG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CACATT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GGAC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TGTGTAT--------------- : 134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zh-CN" altLang="en-US" sz="700" dirty="0"/>
          </a:p>
        </p:txBody>
      </p:sp>
      <p:sp>
        <p:nvSpPr>
          <p:cNvPr id="4" name="文本框 3">
            <a:extLst>
              <a:ext uri="{FF2B5EF4-FFF2-40B4-BE49-F238E27FC236}">
                <a16:creationId xmlns:a16="http://schemas.microsoft.com/office/drawing/2014/main" id="{7D2BD060-68C9-4960-9596-0FA1DED4542F}"/>
              </a:ext>
            </a:extLst>
          </p:cNvPr>
          <p:cNvSpPr txBox="1"/>
          <p:nvPr/>
        </p:nvSpPr>
        <p:spPr>
          <a:xfrm>
            <a:off x="581970" y="6140066"/>
            <a:ext cx="11287299" cy="523220"/>
          </a:xfrm>
          <a:prstGeom prst="rect">
            <a:avLst/>
          </a:prstGeom>
          <a:noFill/>
        </p:spPr>
        <p:txBody>
          <a:bodyPr wrap="square">
            <a:spAutoFit/>
          </a:bodyPr>
          <a:lstStyle/>
          <a:p>
            <a:r>
              <a:rPr lang="en-US" altLang="zh-CN" sz="1400" b="1" dirty="0">
                <a:effectLst/>
                <a:latin typeface="Times New Roman" panose="02020603050405020304" pitchFamily="18" charset="0"/>
                <a:ea typeface="等线" panose="02010600030101010101" pitchFamily="2" charset="-122"/>
              </a:rPr>
              <a:t>Supplemental Figure S4. Sequence alignments of </a:t>
            </a:r>
            <a:r>
              <a:rPr lang="en-US" altLang="zh-CN" sz="1400" b="1" i="1" dirty="0">
                <a:effectLst/>
                <a:latin typeface="Times New Roman" panose="02020603050405020304" pitchFamily="18" charset="0"/>
                <a:ea typeface="等线" panose="02010600030101010101" pitchFamily="2" charset="-122"/>
              </a:rPr>
              <a:t>lncRNA</a:t>
            </a:r>
            <a:r>
              <a:rPr lang="en-US" altLang="zh-CN" sz="1400" b="1" i="1" baseline="-25000" dirty="0">
                <a:effectLst/>
                <a:latin typeface="Times New Roman" panose="02020603050405020304" pitchFamily="18" charset="0"/>
                <a:ea typeface="等线" panose="02010600030101010101" pitchFamily="2" charset="-122"/>
              </a:rPr>
              <a:t>PG1</a:t>
            </a:r>
            <a:r>
              <a:rPr lang="en-US" altLang="zh-CN" sz="1400" b="1" dirty="0">
                <a:latin typeface="Times New Roman" panose="02020603050405020304" pitchFamily="18" charset="0"/>
                <a:ea typeface="等线" panose="02010600030101010101" pitchFamily="2" charset="-122"/>
              </a:rPr>
              <a:t> homologs. </a:t>
            </a:r>
            <a:r>
              <a:rPr lang="en-US" altLang="zh-CN" sz="1400" i="1" dirty="0">
                <a:effectLst/>
                <a:latin typeface="Times New Roman" panose="02020603050405020304" pitchFamily="18" charset="0"/>
                <a:ea typeface="等线" panose="02010600030101010101" pitchFamily="2" charset="-122"/>
              </a:rPr>
              <a:t>LncRNA</a:t>
            </a:r>
            <a:r>
              <a:rPr lang="en-US" altLang="zh-CN" sz="1400" i="1" baseline="-25000" dirty="0">
                <a:effectLst/>
                <a:latin typeface="Times New Roman" panose="02020603050405020304" pitchFamily="18" charset="0"/>
                <a:ea typeface="等线" panose="02010600030101010101" pitchFamily="2" charset="-122"/>
              </a:rPr>
              <a:t>PG1 </a:t>
            </a:r>
            <a:r>
              <a:rPr lang="en-US" altLang="zh-CN" sz="1400" dirty="0">
                <a:effectLst/>
                <a:latin typeface="Times New Roman" panose="02020603050405020304" pitchFamily="18" charset="0"/>
                <a:ea typeface="等线" panose="02010600030101010101" pitchFamily="2" charset="-122"/>
              </a:rPr>
              <a:t>homolog sequences</a:t>
            </a:r>
            <a:r>
              <a:rPr lang="en-US" altLang="zh-CN" sz="1400" kern="0" dirty="0">
                <a:effectLst/>
                <a:latin typeface="Times New Roman" panose="02020603050405020304" pitchFamily="18" charset="0"/>
                <a:ea typeface="等线" panose="02010600030101010101" pitchFamily="2" charset="-122"/>
              </a:rPr>
              <a:t> were identified from on chromosome 0, 1, 5, 11 and 10 by Blast search, PCR-amplified from genomic DNA of ‘</a:t>
            </a:r>
            <a:r>
              <a:rPr lang="en-US" altLang="zh-CN" sz="1400" kern="0" dirty="0" err="1">
                <a:effectLst/>
                <a:latin typeface="Times New Roman" panose="02020603050405020304" pitchFamily="18" charset="0"/>
                <a:ea typeface="等线" panose="02010600030101010101" pitchFamily="2" charset="-122"/>
              </a:rPr>
              <a:t>Huashuo</a:t>
            </a:r>
            <a:r>
              <a:rPr lang="en-US" altLang="zh-CN" sz="1400" kern="0" dirty="0">
                <a:effectLst/>
                <a:latin typeface="Times New Roman" panose="02020603050405020304" pitchFamily="18" charset="0"/>
                <a:ea typeface="等线" panose="02010600030101010101" pitchFamily="2" charset="-122"/>
              </a:rPr>
              <a:t>’</a:t>
            </a:r>
            <a:r>
              <a:rPr lang="en-US" altLang="zh-CN" sz="1400" dirty="0">
                <a:effectLst/>
                <a:latin typeface="Times New Roman" panose="02020603050405020304" pitchFamily="18" charset="0"/>
                <a:ea typeface="等线" panose="02010600030101010101" pitchFamily="2" charset="-122"/>
              </a:rPr>
              <a:t>, cloned, sequenced, and aligned using </a:t>
            </a:r>
            <a:r>
              <a:rPr lang="en-US" altLang="zh-CN" sz="1400" dirty="0" err="1">
                <a:effectLst/>
                <a:latin typeface="Times New Roman" panose="02020603050405020304" pitchFamily="18" charset="0"/>
                <a:ea typeface="等线" panose="02010600030101010101" pitchFamily="2" charset="-122"/>
              </a:rPr>
              <a:t>Geneious</a:t>
            </a:r>
            <a:r>
              <a:rPr lang="en-US" altLang="zh-CN" sz="1400" dirty="0">
                <a:effectLst/>
                <a:latin typeface="Times New Roman" panose="02020603050405020304" pitchFamily="18" charset="0"/>
                <a:ea typeface="等线" panose="02010600030101010101" pitchFamily="2" charset="-122"/>
              </a:rPr>
              <a:t> software v9.1.4.</a:t>
            </a:r>
            <a:endParaRPr lang="zh-CN" altLang="en-US" sz="1400" dirty="0"/>
          </a:p>
        </p:txBody>
      </p:sp>
    </p:spTree>
    <p:extLst>
      <p:ext uri="{BB962C8B-B14F-4D97-AF65-F5344CB8AC3E}">
        <p14:creationId xmlns:p14="http://schemas.microsoft.com/office/powerpoint/2010/main" val="109329388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组合 13">
            <a:extLst>
              <a:ext uri="{FF2B5EF4-FFF2-40B4-BE49-F238E27FC236}">
                <a16:creationId xmlns:a16="http://schemas.microsoft.com/office/drawing/2014/main" id="{E5C13CF5-42D5-991F-4DF6-94F3D9D2C9D4}"/>
              </a:ext>
            </a:extLst>
          </p:cNvPr>
          <p:cNvGrpSpPr/>
          <p:nvPr/>
        </p:nvGrpSpPr>
        <p:grpSpPr>
          <a:xfrm>
            <a:off x="971385" y="4679978"/>
            <a:ext cx="10144538" cy="1939431"/>
            <a:chOff x="1065475" y="2776161"/>
            <a:chExt cx="10249231" cy="2552538"/>
          </a:xfrm>
        </p:grpSpPr>
        <p:pic>
          <p:nvPicPr>
            <p:cNvPr id="15" name="图片 14">
              <a:extLst>
                <a:ext uri="{FF2B5EF4-FFF2-40B4-BE49-F238E27FC236}">
                  <a16:creationId xmlns:a16="http://schemas.microsoft.com/office/drawing/2014/main" id="{096EF543-D917-5EEE-7032-BCBBCA8AF5C4}"/>
                </a:ext>
              </a:extLst>
            </p:cNvPr>
            <p:cNvPicPr>
              <a:picLocks noChangeAspect="1"/>
            </p:cNvPicPr>
            <p:nvPr/>
          </p:nvPicPr>
          <p:blipFill rotWithShape="1">
            <a:blip r:embed="rId2"/>
            <a:srcRect b="59130"/>
            <a:stretch/>
          </p:blipFill>
          <p:spPr>
            <a:xfrm>
              <a:off x="1065475" y="2776161"/>
              <a:ext cx="10249231" cy="1453933"/>
            </a:xfrm>
            <a:prstGeom prst="rect">
              <a:avLst/>
            </a:prstGeom>
          </p:spPr>
        </p:pic>
        <p:pic>
          <p:nvPicPr>
            <p:cNvPr id="16" name="图片 15">
              <a:extLst>
                <a:ext uri="{FF2B5EF4-FFF2-40B4-BE49-F238E27FC236}">
                  <a16:creationId xmlns:a16="http://schemas.microsoft.com/office/drawing/2014/main" id="{8DE49997-CCC5-B21C-5B61-FC75AE6EB64E}"/>
                </a:ext>
              </a:extLst>
            </p:cNvPr>
            <p:cNvPicPr>
              <a:picLocks noChangeAspect="1"/>
            </p:cNvPicPr>
            <p:nvPr/>
          </p:nvPicPr>
          <p:blipFill rotWithShape="1">
            <a:blip r:embed="rId2"/>
            <a:srcRect t="69118"/>
            <a:stretch/>
          </p:blipFill>
          <p:spPr>
            <a:xfrm>
              <a:off x="1065475" y="4230094"/>
              <a:ext cx="10249231" cy="1098605"/>
            </a:xfrm>
            <a:prstGeom prst="rect">
              <a:avLst/>
            </a:prstGeom>
          </p:spPr>
        </p:pic>
      </p:grpSp>
      <p:grpSp>
        <p:nvGrpSpPr>
          <p:cNvPr id="11" name="组合 10">
            <a:extLst>
              <a:ext uri="{FF2B5EF4-FFF2-40B4-BE49-F238E27FC236}">
                <a16:creationId xmlns:a16="http://schemas.microsoft.com/office/drawing/2014/main" id="{54057AEC-4D08-E219-A4D1-1A790667B667}"/>
              </a:ext>
            </a:extLst>
          </p:cNvPr>
          <p:cNvGrpSpPr/>
          <p:nvPr/>
        </p:nvGrpSpPr>
        <p:grpSpPr>
          <a:xfrm>
            <a:off x="866691" y="58489"/>
            <a:ext cx="10249232" cy="2908118"/>
            <a:chOff x="866691" y="58489"/>
            <a:chExt cx="10249232" cy="2908118"/>
          </a:xfrm>
        </p:grpSpPr>
        <p:pic>
          <p:nvPicPr>
            <p:cNvPr id="5" name="图片 4">
              <a:extLst>
                <a:ext uri="{FF2B5EF4-FFF2-40B4-BE49-F238E27FC236}">
                  <a16:creationId xmlns:a16="http://schemas.microsoft.com/office/drawing/2014/main" id="{B205C64B-0884-EDF3-8DAB-4AFCC3A44964}"/>
                </a:ext>
              </a:extLst>
            </p:cNvPr>
            <p:cNvPicPr>
              <a:picLocks noChangeAspect="1"/>
            </p:cNvPicPr>
            <p:nvPr/>
          </p:nvPicPr>
          <p:blipFill>
            <a:blip r:embed="rId3"/>
            <a:stretch>
              <a:fillRect/>
            </a:stretch>
          </p:blipFill>
          <p:spPr>
            <a:xfrm>
              <a:off x="866692" y="58489"/>
              <a:ext cx="10249231" cy="1539177"/>
            </a:xfrm>
            <a:prstGeom prst="rect">
              <a:avLst/>
            </a:prstGeom>
          </p:spPr>
        </p:pic>
        <p:pic>
          <p:nvPicPr>
            <p:cNvPr id="7" name="图片 6">
              <a:extLst>
                <a:ext uri="{FF2B5EF4-FFF2-40B4-BE49-F238E27FC236}">
                  <a16:creationId xmlns:a16="http://schemas.microsoft.com/office/drawing/2014/main" id="{291DE928-3086-0EA3-F7BB-187A542358CC}"/>
                </a:ext>
              </a:extLst>
            </p:cNvPr>
            <p:cNvPicPr>
              <a:picLocks noChangeAspect="1"/>
            </p:cNvPicPr>
            <p:nvPr/>
          </p:nvPicPr>
          <p:blipFill>
            <a:blip r:embed="rId4"/>
            <a:stretch>
              <a:fillRect/>
            </a:stretch>
          </p:blipFill>
          <p:spPr>
            <a:xfrm>
              <a:off x="866691" y="1291241"/>
              <a:ext cx="10249231" cy="1675366"/>
            </a:xfrm>
            <a:prstGeom prst="rect">
              <a:avLst/>
            </a:prstGeom>
          </p:spPr>
        </p:pic>
      </p:grpSp>
      <p:pic>
        <p:nvPicPr>
          <p:cNvPr id="13" name="图片 12">
            <a:extLst>
              <a:ext uri="{FF2B5EF4-FFF2-40B4-BE49-F238E27FC236}">
                <a16:creationId xmlns:a16="http://schemas.microsoft.com/office/drawing/2014/main" id="{89E9D642-3886-C7EC-0915-34C686508897}"/>
              </a:ext>
            </a:extLst>
          </p:cNvPr>
          <p:cNvPicPr>
            <a:picLocks noChangeAspect="1"/>
          </p:cNvPicPr>
          <p:nvPr/>
        </p:nvPicPr>
        <p:blipFill>
          <a:blip r:embed="rId5"/>
          <a:stretch>
            <a:fillRect/>
          </a:stretch>
        </p:blipFill>
        <p:spPr>
          <a:xfrm>
            <a:off x="910424" y="3005065"/>
            <a:ext cx="10205498" cy="1675366"/>
          </a:xfrm>
          <a:prstGeom prst="rect">
            <a:avLst/>
          </a:prstGeom>
        </p:spPr>
      </p:pic>
      <p:sp>
        <p:nvSpPr>
          <p:cNvPr id="2" name="文本框 1">
            <a:extLst>
              <a:ext uri="{FF2B5EF4-FFF2-40B4-BE49-F238E27FC236}">
                <a16:creationId xmlns:a16="http://schemas.microsoft.com/office/drawing/2014/main" id="{89A9A18A-02C7-6DE5-3FC5-30529E287030}"/>
              </a:ext>
            </a:extLst>
          </p:cNvPr>
          <p:cNvSpPr txBox="1"/>
          <p:nvPr/>
        </p:nvSpPr>
        <p:spPr>
          <a:xfrm>
            <a:off x="87679" y="6627325"/>
            <a:ext cx="11807254" cy="523220"/>
          </a:xfrm>
          <a:prstGeom prst="rect">
            <a:avLst/>
          </a:prstGeom>
          <a:noFill/>
        </p:spPr>
        <p:txBody>
          <a:bodyPr wrap="square">
            <a:spAutoFit/>
          </a:bodyPr>
          <a:lstStyle/>
          <a:p>
            <a:r>
              <a:rPr lang="en-US" altLang="zh-CN" sz="1400" b="1" dirty="0">
                <a:effectLst/>
                <a:latin typeface="Times New Roman" panose="02020603050405020304" pitchFamily="18" charset="0"/>
                <a:ea typeface="等线" panose="02010600030101010101" pitchFamily="2" charset="-122"/>
              </a:rPr>
              <a:t>Supplemental Figure S5</a:t>
            </a:r>
            <a:r>
              <a:rPr lang="en-US" altLang="zh-CN" sz="1400" b="1" dirty="0">
                <a:latin typeface="Times New Roman" panose="02020603050405020304" pitchFamily="18" charset="0"/>
                <a:ea typeface="等线" panose="02010600030101010101" pitchFamily="2" charset="-122"/>
              </a:rPr>
              <a:t>. Six highly </a:t>
            </a:r>
            <a:r>
              <a:rPr lang="en-US" altLang="zh-CN" sz="1400" b="1" dirty="0">
                <a:latin typeface="Times New Roman" panose="02020603050405020304" pitchFamily="18" charset="0"/>
              </a:rPr>
              <a:t>similar sequences of lncRNA  </a:t>
            </a:r>
            <a:r>
              <a:rPr lang="en-US" altLang="zh-CN" sz="1400" b="1" dirty="0">
                <a:latin typeface="Times New Roman" panose="02020603050405020304" pitchFamily="18" charset="0"/>
                <a:ea typeface="等线" panose="02010600030101010101" pitchFamily="2" charset="-122"/>
              </a:rPr>
              <a:t>were annotated as putative nonprotein-coding genes. </a:t>
            </a:r>
            <a:r>
              <a:rPr lang="en-US" altLang="zh-CN" sz="1400" dirty="0">
                <a:latin typeface="Times New Roman" panose="02020603050405020304" pitchFamily="18" charset="0"/>
                <a:ea typeface="等线" panose="02010600030101010101" pitchFamily="2" charset="-122"/>
              </a:rPr>
              <a:t>According to the apple lncRNA database information, six highly similar sequences of lncRNA  were annotated as putative nonprotein-coding genes</a:t>
            </a:r>
            <a:r>
              <a:rPr lang="en-US" altLang="zh-CN" sz="1400" dirty="0">
                <a:latin typeface="Times New Roman" panose="02020603050405020304" pitchFamily="18" charset="0"/>
              </a:rPr>
              <a:t>. </a:t>
            </a:r>
            <a:r>
              <a:rPr lang="en-US" altLang="zh-CN" sz="1400" dirty="0" err="1">
                <a:latin typeface="Times New Roman" panose="02020603050405020304" pitchFamily="18" charset="0"/>
              </a:rPr>
              <a:t>PLnc</a:t>
            </a:r>
            <a:r>
              <a:rPr lang="en-US" altLang="zh-CN" sz="1400" dirty="0">
                <a:latin typeface="Times New Roman" panose="02020603050405020304" pitchFamily="18" charset="0"/>
              </a:rPr>
              <a:t> DB (https://www.tobaccodb.org/plncdb/) </a:t>
            </a:r>
            <a:endParaRPr lang="zh-CN" altLang="en-US" sz="1400" dirty="0"/>
          </a:p>
        </p:txBody>
      </p:sp>
    </p:spTree>
    <p:extLst>
      <p:ext uri="{BB962C8B-B14F-4D97-AF65-F5344CB8AC3E}">
        <p14:creationId xmlns:p14="http://schemas.microsoft.com/office/powerpoint/2010/main" val="10381403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C03EAAE0-91C7-479D-B2F6-1545586DAC9A}"/>
              </a:ext>
            </a:extLst>
          </p:cNvPr>
          <p:cNvSpPr txBox="1"/>
          <p:nvPr/>
        </p:nvSpPr>
        <p:spPr>
          <a:xfrm>
            <a:off x="0" y="501468"/>
            <a:ext cx="529981" cy="276999"/>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2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B</a:t>
            </a:r>
            <a:endParaRPr kumimoji="0" lang="zh-CN" altLang="en-US" sz="12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grpSp>
        <p:nvGrpSpPr>
          <p:cNvPr id="2" name="组合 1">
            <a:extLst>
              <a:ext uri="{FF2B5EF4-FFF2-40B4-BE49-F238E27FC236}">
                <a16:creationId xmlns:a16="http://schemas.microsoft.com/office/drawing/2014/main" id="{745E44EE-21CA-4D1F-ADE2-F831DAF493F6}"/>
              </a:ext>
            </a:extLst>
          </p:cNvPr>
          <p:cNvGrpSpPr/>
          <p:nvPr/>
        </p:nvGrpSpPr>
        <p:grpSpPr>
          <a:xfrm>
            <a:off x="106533" y="501468"/>
            <a:ext cx="12189041" cy="5855064"/>
            <a:chOff x="106533" y="501468"/>
            <a:chExt cx="12189041" cy="5855064"/>
          </a:xfrm>
        </p:grpSpPr>
        <p:grpSp>
          <p:nvGrpSpPr>
            <p:cNvPr id="5" name="组合 4">
              <a:extLst>
                <a:ext uri="{FF2B5EF4-FFF2-40B4-BE49-F238E27FC236}">
                  <a16:creationId xmlns:a16="http://schemas.microsoft.com/office/drawing/2014/main" id="{2A3A4F9C-46D9-49DD-B560-350E54ED1217}"/>
                </a:ext>
              </a:extLst>
            </p:cNvPr>
            <p:cNvGrpSpPr/>
            <p:nvPr/>
          </p:nvGrpSpPr>
          <p:grpSpPr>
            <a:xfrm>
              <a:off x="106533" y="501468"/>
              <a:ext cx="12189041" cy="5855064"/>
              <a:chOff x="106533" y="501468"/>
              <a:chExt cx="12189041" cy="5855064"/>
            </a:xfrm>
          </p:grpSpPr>
          <p:sp>
            <p:nvSpPr>
              <p:cNvPr id="3" name="文本框 2">
                <a:extLst>
                  <a:ext uri="{FF2B5EF4-FFF2-40B4-BE49-F238E27FC236}">
                    <a16:creationId xmlns:a16="http://schemas.microsoft.com/office/drawing/2014/main" id="{1B6B5F20-50B0-410B-B673-0694879005E1}"/>
                  </a:ext>
                </a:extLst>
              </p:cNvPr>
              <p:cNvSpPr txBox="1"/>
              <p:nvPr/>
            </p:nvSpPr>
            <p:spPr>
              <a:xfrm>
                <a:off x="106533" y="501468"/>
                <a:ext cx="12189041" cy="5855064"/>
              </a:xfrm>
              <a:prstGeom prst="rect">
                <a:avLst/>
              </a:prstGeom>
              <a:noFill/>
            </p:spPr>
            <p:txBody>
              <a:bodyPr wrap="square">
                <a:spAutoFit/>
              </a:bodyPr>
              <a:lstStyle/>
              <a:p>
                <a:pPr marL="0" marR="0" lvl="0" indent="0" algn="l" defTabSz="914400" rtl="0" eaLnBrk="1" fontAlgn="auto" latinLnBrk="0" hangingPunct="1">
                  <a:lnSpc>
                    <a:spcPts val="1000"/>
                  </a:lnSpc>
                  <a:spcBef>
                    <a:spcPts val="0"/>
                  </a:spcBef>
                  <a:spcAft>
                    <a:spcPts val="0"/>
                  </a:spcAft>
                  <a:buClrTx/>
                  <a:buSzTx/>
                  <a:buFontTx/>
                  <a:buNone/>
                  <a:tabLst/>
                  <a:defRPr/>
                </a:pP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         *      -200         *      -180         *      -160         *      -140         *      -120         *      -100         *       -80         *       -60         *       -4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CACTTCTAGCTACAATTCTAAGTTTCCATTTTCCAACATCCC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CATTGTTCAAAAATATCATCAGCCTCGAGTTAGGGTTTATTATCCTTCGTGACCCTCCTTTTAGTATTTGGTTCTTTTTGAAAGACGATTTGTTAGGTGTTTCTAGGCCTCTAGCCATCTTGTATCTCACCAAAAAAAAATATATT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CACTTCTAGCTACAATTCTAAGTTTCCATTTTCCAACATCCC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CATTGTTCAAAAATATCATCAGCCTCGAGTTAGGGTTTATTATCCTTCGTGACCCTCCTTTTAGTATTTGGTTCTTTTTGAAAGACGATTTGTTAGGTGTTTCTAGGCCTCTAGCCATCTTGTATCTCACCAAAAAAAAATATATT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         *         0         *        20         *        40         *        60         *        80         *       100         *       120         *       140         *       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         *       200         *       220         *       240         *       260         *       280         *       300         *       320         *       340         *       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CCTTCATACACGGACACCATAGAAGGTTTAAA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CATGGAATTGATCAGGCCAAGAACTCAGCTCTTCAGTTCAAGGAAGCTCAACACAATCACCGGTGGGATAGCAACATCATCAGCTCCGGCCAAAACCATTAGCGTCGACGATTTTGGAGCTAAAGGGAATGGTGCTGATGACACACAGGTAAACAACAGATG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CCTTCATACACGGACACCATAGAAGGTTTAAAG</a:t>
                </a:r>
                <a:r>
                  <a:rPr kumimoji="0" lang="en-US" altLang="zh-CN" sz="700" b="1" i="0" u="none" strike="noStrike" kern="0" cap="none" spc="0" normalizeH="0" baseline="0" noProof="0" dirty="0">
                    <a:ln>
                      <a:noFill/>
                    </a:ln>
                    <a:solidFill>
                      <a:srgbClr val="000000"/>
                    </a:solidFill>
                    <a:effectLst/>
                    <a:highlight>
                      <a:srgbClr val="FFFF00"/>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CATGGAATTGATCAGGCCAAGAACTCAGCTCTTCAGTTCAAGGAAGCTCAACACAATCACCGGTGGGATAGCAACATCATCAGCTCCGGCCAAAACCATTAGCGTCGACGATTTTGGAGCTAAAGGGAATGGTGCTGATGACACACAGGTAAACAACAGATG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380         *       400         *       420         *       440         *       460         *       480         *       500         *       520         *       540         *       5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GGACTCATAGGCTTAATAATATTA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ATTAGAATATTCATATGGTGATGCTAACTATAACAACATTTCTGGTCACATTTCTGTTTTATGAAAGATGTGTC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TGTTTGGTACAAATTAATAGTACTATTATTATTTGGACCGAACTCATTATTATTTATTGAGTAAATGTGATACAAATAACATTACTTAAGC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GGACTCATAGGCTTAATAATATTA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ATTAGAATATTCATATGGTGATGCTAACTATAACAACATTTCTGGTCACATTTCTGTTTTATGAAAGATGTGTC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TGTTTGGTACAAATTAATAGTACTATTATTATTTGGACCGAACTCATTATTATTTATTGAGTAAATGTGATACAAATAACATTACTTAAGC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580         *       600         *       620         *       640         *       660         *       680         *       700         *       720         *       740         *       7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a:t>
                </a:r>
                <a:r>
                  <a:rPr kumimoji="0" lang="en-US" altLang="zh-CN" sz="700" b="1" i="0" u="none" strike="noStrike" kern="0" cap="none" spc="0" normalizeH="0" baseline="0" noProof="0" dirty="0">
                    <a:ln>
                      <a:noFill/>
                    </a:ln>
                    <a:solidFill>
                      <a:srgbClr val="000000"/>
                    </a:solidFill>
                    <a:effectLst/>
                    <a:highlight>
                      <a:srgbClr val="FFFF00"/>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AGAACTATCTTGTTAGGCCGATTGAATTCTCAGGCCCATGCAAATCTCAACT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AGAACTATCTTGTTAGGCCGATTGAATTCTCAGGCCCATGCAAATCTCAACT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780         *       800         *       820         *       840         *       860         *       880         *       900         *       920         *       940         *       9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GCAGGTAATAATTAATTCGGATCATCTATGTAATTATCTTTAAATGTAATTCCGGAC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TTTGACGATTATATAATAATTAATATTGCTTAATATTTGGAAAAATTCAGATTTATGGAACCATAGAAGCATCAGAAGACCGATCAATCTACAAAGACATAGACCACTGGCTCATCTTTGACAATGTCCA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GCAGGTAATAATTAATTCGGATCATCTATGTAATTATCTTTAAATGTAATTCCGGAC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TTTGACGATTATATAATAATTAATATTGCTTAATATTTGGAAAAATTCAGATTTATGGAACCATAGAAGCATCAGAAGACCGATCAATCTACAAAGACATAGACCACTGGCTCATCTTTGACAATGTCCA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980         *      1000         *      1020         *      1040         *      1060         *      1080         *      1100         *      1120         *      1140         *      1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GGTACGTGTACA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GGTACGTGTACA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180         *      1200         *      1220         *      1240         *      1260         *      1280         *      1300         *      1320         *      1340         *      1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380         *      1400         *      1420         *      1440         *      1460         *      1480         *      1500         *      1520         *      1540         *      15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a:t>
                </a:r>
                <a:r>
                  <a:rPr lang="en-US" altLang="zh-CN" sz="700" kern="0" dirty="0">
                    <a:solidFill>
                      <a:srgbClr val="000000"/>
                    </a:solidFill>
                    <a:highlight>
                      <a:srgbClr val="FFFFFF"/>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TTTCAAAAGTCATCATTTTGGTCTC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GTTTGATAAATACATATGATCGATCAAACACATTAAGATAAAAAAAC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TTTCAAAAGTCATCATTTTGGTCTC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GTTTGATAAATACATATGATCGATCAAACACATTAAGATAAAAAAAC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580         *      1600         *      1620         *      1640         *      1660         *      1680         *      1700         *      1720         *      1740         *      17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780         *      1800         *      1820         *      1840         *      1860         *      1880         *      1900         *      1920         *      1940         *      19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AATGTTTTTT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AAAAGTGCGGGATGACTTTTTATAGTGTCAATAACAGCTGATTAGTAAATATACCAATATATATTAACGGCTGTTTTAATTTTGTGATCAGTATTGGTAGCTTGGGAGAAGACGGCTCAGAAGATCATGTTTCAGGAGTATTTGTGAATGGAGCTAAGCTTTCAGGAACCTCCAATG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AATGTTTTTT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AAAAGTGCGGGATGACTTTTTATAGTGTCAATAACAGCTGATTAGTAAATATACCAATATATATTAACGGCTGTTTTAATTTTGTGATCAGTATTGGTAGCTTGGGAGAAGACGGCTCAGAAGATCATGTTTCAGGAGTATTTGTGAATGGAGCTAAGCTTTCAGGAACCTCCAATG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980         *      2000         *      2020         *      2040         *      2060         *      2080         *      2100         *      2120         *      2140         *      2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CCGGATCAAGACGTGGAAGGGAGGCTCAGGCAGT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CAACATTGTTTTCCAGAATGTGCAAATGAACGATGTCACCAACCCCATCATCATCGACCAGAACTACTGTGACCACAAAACCAAAGATTGCAAACAACAGGTAATTAATTAATTTAACTAGTTCTTACG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CGTTAATTAGTCCCCAGACAA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CCGGATCAAGACGTGGAAGGGAGGCTCAGGCAGT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CAACATTGTTTTCCAGAATGTGCAAATGAACGATGTCACCAACCCCATCATCATCGACCAGAACTACTGTGACCACAAAACCAAAGATTGCAAACAACAGGTAATTAATTAATTTAACTAGTTCTTACG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CGTTAATTAGTCCCCAGACAA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180         *      2200         *      2220         *      2240         *      2260         *      2280         *      2300         *      2320         *      2340         *      2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AATCACTTCTTGATCGTTTATTTCGTTATGGCAGAAATCGGCGG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AGTGAAAAATGTGTTGTACCAAAACATAAGAGGAACGAGTGCTTCCG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CGCGATAACGTTGAACTGCAGCCAAAGTGTTCCTTGTCAGGGGATCGTGCTGCAAAGTGTTCAACTGCAGAATGGAAGAGCTGAATGCAACAATGTT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AATCACTTCTTGATCGTTTATTTCGTTATGGCAGAAATCGGCGG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AGTGAAAAATGTGTTGTACCAAAACATAAGAGGAACGAGTGCTTCCG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CGCGATAACGTTGAACTGCAGCCAAAGTGTTCCTTGTCAGGGGATCGTGCTGCAAAGTGTTCAACTGCAGAATGGAAGAGCTGAATGCAACAATGTT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380         *      2400         *      2420         *      2440         *      2460         *      2480         *      2500         *      2520         *      254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AAAGATGCAACT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783</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AAAGATGCAACT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783</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endParaRPr kumimoji="0" lang="zh-CN" altLang="en-US" sz="7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
            <p:nvSpPr>
              <p:cNvPr id="4" name="矩形 3">
                <a:extLst>
                  <a:ext uri="{FF2B5EF4-FFF2-40B4-BE49-F238E27FC236}">
                    <a16:creationId xmlns:a16="http://schemas.microsoft.com/office/drawing/2014/main" id="{9A26D25C-6C43-4375-8B4E-4189A5450F1B}"/>
                  </a:ext>
                </a:extLst>
              </p:cNvPr>
              <p:cNvSpPr/>
              <p:nvPr/>
            </p:nvSpPr>
            <p:spPr>
              <a:xfrm>
                <a:off x="2886566" y="1170730"/>
                <a:ext cx="189506" cy="280728"/>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
          <p:nvSpPr>
            <p:cNvPr id="8" name="矩形 7">
              <a:extLst>
                <a:ext uri="{FF2B5EF4-FFF2-40B4-BE49-F238E27FC236}">
                  <a16:creationId xmlns:a16="http://schemas.microsoft.com/office/drawing/2014/main" id="{93606DB3-1C7D-4B33-85F4-CF9502BF00E5}"/>
                </a:ext>
              </a:extLst>
            </p:cNvPr>
            <p:cNvSpPr/>
            <p:nvPr/>
          </p:nvSpPr>
          <p:spPr>
            <a:xfrm flipH="1" flipV="1">
              <a:off x="2558414" y="5721350"/>
              <a:ext cx="178436" cy="31115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Tree>
    <p:extLst>
      <p:ext uri="{BB962C8B-B14F-4D97-AF65-F5344CB8AC3E}">
        <p14:creationId xmlns:p14="http://schemas.microsoft.com/office/powerpoint/2010/main" val="1025228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a:extLst>
              <a:ext uri="{FF2B5EF4-FFF2-40B4-BE49-F238E27FC236}">
                <a16:creationId xmlns:a16="http://schemas.microsoft.com/office/drawing/2014/main" id="{0B2E383D-BCB9-4A75-BE51-325265E5FBFF}"/>
              </a:ext>
            </a:extLst>
          </p:cNvPr>
          <p:cNvGrpSpPr/>
          <p:nvPr/>
        </p:nvGrpSpPr>
        <p:grpSpPr>
          <a:xfrm>
            <a:off x="715611" y="166401"/>
            <a:ext cx="10527699" cy="6211316"/>
            <a:chOff x="715611" y="166401"/>
            <a:chExt cx="10527699" cy="6211316"/>
          </a:xfrm>
        </p:grpSpPr>
        <p:grpSp>
          <p:nvGrpSpPr>
            <p:cNvPr id="2" name="组合 1">
              <a:extLst>
                <a:ext uri="{FF2B5EF4-FFF2-40B4-BE49-F238E27FC236}">
                  <a16:creationId xmlns:a16="http://schemas.microsoft.com/office/drawing/2014/main" id="{2369871A-52ED-442C-929F-9353B4B7B294}"/>
                </a:ext>
              </a:extLst>
            </p:cNvPr>
            <p:cNvGrpSpPr/>
            <p:nvPr/>
          </p:nvGrpSpPr>
          <p:grpSpPr>
            <a:xfrm>
              <a:off x="715611" y="166401"/>
              <a:ext cx="10527699" cy="6211316"/>
              <a:chOff x="715611" y="166401"/>
              <a:chExt cx="10527699" cy="6211316"/>
            </a:xfrm>
          </p:grpSpPr>
          <p:sp>
            <p:nvSpPr>
              <p:cNvPr id="4" name="文本框 3">
                <a:extLst>
                  <a:ext uri="{FF2B5EF4-FFF2-40B4-BE49-F238E27FC236}">
                    <a16:creationId xmlns:a16="http://schemas.microsoft.com/office/drawing/2014/main" id="{F30420F6-507D-4FAC-9E63-C365A32099A5}"/>
                  </a:ext>
                </a:extLst>
              </p:cNvPr>
              <p:cNvSpPr txBox="1"/>
              <p:nvPr/>
            </p:nvSpPr>
            <p:spPr>
              <a:xfrm>
                <a:off x="715611" y="166401"/>
                <a:ext cx="215911"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C</a:t>
                </a:r>
                <a:endParaRPr lang="zh-CN" altLang="en-US" sz="1400" b="1" dirty="0">
                  <a:latin typeface="Times New Roman" panose="02020603050405020304" pitchFamily="18" charset="0"/>
                  <a:cs typeface="Times New Roman" panose="02020603050405020304" pitchFamily="18" charset="0"/>
                </a:endParaRPr>
              </a:p>
            </p:txBody>
          </p:sp>
          <p:sp>
            <p:nvSpPr>
              <p:cNvPr id="6" name="文本框 5">
                <a:extLst>
                  <a:ext uri="{FF2B5EF4-FFF2-40B4-BE49-F238E27FC236}">
                    <a16:creationId xmlns:a16="http://schemas.microsoft.com/office/drawing/2014/main" id="{42C1DD5A-AA2E-4360-882D-9BCA2DC20B84}"/>
                  </a:ext>
                </a:extLst>
              </p:cNvPr>
              <p:cNvSpPr txBox="1"/>
              <p:nvPr/>
            </p:nvSpPr>
            <p:spPr>
              <a:xfrm>
                <a:off x="948690" y="166401"/>
                <a:ext cx="10294620" cy="6211316"/>
              </a:xfrm>
              <a:prstGeom prst="rect">
                <a:avLst/>
              </a:prstGeom>
              <a:noFill/>
            </p:spPr>
            <p:txBody>
              <a:bodyPr wrap="square">
                <a:spAutoFit/>
              </a:bodyPr>
              <a:lstStyle/>
              <a:p>
                <a:pPr>
                  <a:lnSpc>
                    <a:spcPts val="900"/>
                  </a:lnSpc>
                </a:pP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2520         *     -2500         *     -2480         *     -2460         *     -2440         *     -2420         *     -2400         *     -23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TTGTATCCA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AACAATCCTGGCTATTTTTACATATTCAATATAAAGTTCCAATACGATCACTGATTGATTAATTGGTATCAAGTACAATACTTCTGCATCTCTCTTAAAAAACATCAA</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CAATGCAT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GTGTTGTAGATTGTT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TTGTATCCA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AACAATCCTGGCTATTTTTACATATTCAATATAAAGTTCCAATACGATCACTGATTGATTAATTGGTATCAAGTACAATACTTCTGCATCTCTCTTAAAAAACATCAA</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CAATGCAT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GTGTTGTAGATTGTT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60         *     -2340         *     -2320         *     -2300         *     -2280         *     -2260         *     -22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GAGTCGGCC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CCCAGTGTCACCAGGGCGACCGCTTGAGGTCCAAAAAAACGAGTGGCACCAAAAAAAAATTAAGTTGGTTCATATATGTATAAGGTTTTGTTTTATTCTTGATATATAGTAAACGCTCATATTAAATAGCAAT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GAGTCGGCC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CCCAGTGTCACCAGGGCGACCGCTTGAGGTCCAAAAAAACGAGTGGCACCAAAAAAAAATTAAGTTGGTTCATATATGTATAAGGTTTTGTTTTATTCTTGATATATAGTAAACGCTCATATTAAATAGCAAT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2220         *     -2200         *     -2180         *     -2160         *     -2140         *     -2120         *     -2100         *     -20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GATGACAGGGTGGTTTTATTTGGTTTTTCCGTGCCCACCTAGGTTTAATTCCCTCTCTCAACATAAAGGGGTAGTTTCCCTTCTATTTTATTCATGTCTACTTTAAATAACAAACAAACATTAATTAGCTTATTAAATGTGGC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AGATGACAGGGTGGTTTTATTTGGTTTTTCCGTGCCCACCTAGGTTTAATTCCCTCTCTCAACATAAAGGGGTAGTTTCCCTTCTATTTTATTCATGTCTACTTTAAATAACAAACAAACATTAATTAGCTTATTAAATGTGGC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60         *     -2040         *     -2020         *     -2000         *     -1980         *     -1960         *     -19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AGTAGTCGTTTTTTGTTTTCAGTTTGAATTAACTCGCAAAATCATGTTCAAGTTTGTCTAAATATAAATTTAGGTTTTTTATATTTGTTGATAATCTTTTCATGGTTAAGTAATAAACTTGTGATCATTATCTTTTTATTGAAC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AGTAGTCGTTTTTTGTTTTCAGTTTGAATTAACTCGCAAAATCATGTTCAAGTTTGTCTAAATATAAATTTAGGTTTTTTATATTTGTTGATAATCTTTTCATGGTTAAGTAATAAACTTGTGATCATTATCTTTTTATTGAAC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920         *     -1900         *     -1880         *     -1860         *     -1840         *     -1820         *     -1800         *     -17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T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TCCAAAAATATCATCCTACACTTCTTTGTATAAT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TATGATTTTATATATTTGGAATGAACCGCAACTTTTCATGAGCGCTCGAAAAACAAAAACATAGTTGAATTACTATGTG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GTA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T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TCCAAAAATATCATCCTACACTTCTTTGTATAAT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TATGATTTTATATATTTGGAATGAACCGCAACTTTTCATGAGCGCTCGAAAAACAAAAACATAGTTGAATTACTATGTG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GTA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60         *     -1740         *     -1720         *     -1700         *     -1680         *     -1660         *     -16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CAATTTGTTGTTTTCATTTGTTGCTTACATATAGAAATTAGAGATCTTAAATATG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TTCAAAAGTTTCATAATGTGCAAGTAGCTTGTAGATCAGTTAGTTAAAAGTGTTCAGCTTGTCACTCAATGACTCGTTTTC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CAATTTGTTGTTTTCATTTGTTGCTTACATATAGAAATTAGAGATCTTAAATATG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TTCAAAAGTTTCATAATGTGCAAGTAGCTTGTAGATCAGTTAGTTAAAAGTGTTCAGCTTGTCACTCAATGACTCGTTTTC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620         *     -1600         *     -1580         *     -1560         *     -1540         *     -1520         *     -1500         *     -14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CTCACCGTATTTCTGATGA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GTAAATTACCCTATCATTTGTCAAAAAAGTCATAATGTGAAAAAGGTCTATTTTCTTTAATATTCAATGTACAACATA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CTAAGATAAATAATTATTTTATGTGAAGTTA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CCTCACCGTATTTCTGATGA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GTAAATTACCCTATCATTTGTCAAAAAAGTCATAATGTGAAAAAGGTCTATTTTCTTTAATATTCAATGTACAACATA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CTAAGATAAATAATTATTTTATGTGAAGTTA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60         *     -1440         *     -1420         *     -1400         *     -1380         *     -1360         *     -13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CATATTTTTC</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ATGTCGCC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CCTCATAAAACTCAGGATAGGCCTTGATTGTTATATATGGTACTAAACAAAAGTTT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ACAAAGTTTAAAAAGATTCAAGTGGAATTTTGAAGAATTTTAAAAGTATTATAAA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CATATTTTTC</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ATGTCGCC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GCCTCATAAAACTCAGGATAGGCCTTGATTGTTATATATGGTACTAAACAAAAGTTT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TACAAAGTTTAAAAAGATTCAAGTGGAATTTTGAAGAATTTTAAAAGTATTATAAATT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320         *     -1300         *     -1280         *     -1260         *     -1240         *     -1220         *     -1200         *     -11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CGAGTTGATTAATTGCGGGGGATGTGGTCATCATGACCG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GTTCATGGAGCAACCTACTTGTTCCCCCACTTATGATTGACGCATTTTT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GAACATCATAATCAGAACCGTTCGTTCTCTTTGTC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CTCGAGTTGATTAATTGCGGGGGATGTGGTCATCATGACCG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TAGTTCATGGAGCAACCTACTTGTTCCCCCACTTATGATTGACGCATTTTT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GAACATCATAATCAGAACCGTTCGTTCTCTTTGTC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60         *     -1140         *     -1120         *     -1100         *     -1080         *     -1060         *     -10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CGAAAGATCATATATGCAAAAACTCATTAAATTG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TTTAGCCATTC</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ATATGTATCA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AATAGACGGTTCATCATAAGG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TTGTTACCAAAAACATTGATTGGTTTGACATATATGGATGGGTAAACA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CGAAAGATCATATATGCAAAAACTCATTAAATTG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TTTAGCCATTC</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ATATGTATCA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AATAGACGGTTCATCATAAGG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TTGTTACCAAAAACATTGATTGGTTTGACATATATGGATGGGTAAACA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020         *     -1000         *      -980         *      -960         *      -940         *      -920         *      -900         *      -8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CAAATGGAATATTTTTTTTAGATATGATATTTCGATGATGATAAAGAGAATGAACGGGTCAAATAATAATGTTCATATGGTGAAGATGCGTAAATCATAAGTGAAGGGACAAGTTGGTTCCCTATGGAGGACACAAGCATT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CAAATGGAATATTTTTTTTAGATATGATATTTCGATGATGATAAAGAGAATGAACGGGTCAAATAATAATGTTCATATGGTGAAGATGCGTAAATCATAAGTGAAGGGACAAGTTGGTTCCCTATGGAGGACACAAGCATT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60         *      -840         *      -820         *      -800         *      -780         *      -760         *      -7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GGTGTATTCAATTAGAATTGTAAATGAATCTATAAAAGTTCAGGAATATTCAGTCAGAATGTTAAACAAGCTTATAGAACTCCATACAAATTCAGGTGTATTAATCAATTAAAATTTTAAAGGATTTTATAAAAGTCAACAGAA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GGTGTATTCAATTAGAATTGTAAATGAATCTATAAAAGTTCAGGAATATTCAGTCAGAATGTTAAACAAGCTTATAGAACTCCATACAAATTCAGGTGTATTAATCAATTAAAATTTTAAAGGATTTTATAAAAGTCAACAGAA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720         *      -700         *      -680         *      -660         *      -640         *      -620         *      -600         *      -5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GAGTGTATTCAAAGAAGATTTTGAAAAAGTCTAAGAAAGTTAGAGTGT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TAATTTGATTTTAAAGAATTTTAAA</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ATGATACAT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TAAATTTGAAGGAATTTCATAGAGTATTTAACCCTTAATAAATCAT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GAGTGTATTCAAAGAAGATTTTGAAAAAGTCTAAGAAAGTTAGAGTGT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TAATTTGATTTTAAAGAATTTTAAA</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ATGATACAT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TAAATTTGAAGGAATTTCATAGAGTATTTAACCCTTAATAAATCAT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60         *      -540         *      -520         *      -500         *      -480         *      -460         *      -4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TGTAAAGTCCATT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ATCAACTTTCATAAATTGAAACATTTTTAAATCCATAAAAGTTGAACCGAATCTATTTTCATATATTATTTTATACATGCAACGACTTACGTTGTAACATAAGGGATG</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CAATGCATG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GCAG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TGTAAAGTCCATT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ATCAACTTTCATAAATTGAAACATTTTTAAATCCATAAAAGTTGAACCGAATCTATTTTCATATATTATTTTATACATGCAACGACTTACGTTGTAACATAAGGGATG</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CAATGCATG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GCAG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420         *      -400         *      -380         *      -360         *      -340         *      -320         *      -300         *      -28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CAT</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GAGTCGGC</a:t>
                </a:r>
                <a:r>
                  <a:rPr lang="en-US" altLang="zh-CN" sz="800" b="1" kern="0" dirty="0">
                    <a:solidFill>
                      <a:srgbClr val="1527D5"/>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TTTCGTCTGAATCTCTCATGTCCGAGAACCCATACCTCAAGAGCCCAAGACGACACAATACACAACAATCACCGTCAATACCCTTCTCTTCCGCTGCCTATAAATACCAATGGAAATCCCACGA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4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CAT</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GAGTCGGC</a:t>
                </a:r>
                <a:r>
                  <a:rPr lang="en-US" altLang="zh-CN" sz="800" b="1" kern="0" dirty="0">
                    <a:solidFill>
                      <a:srgbClr val="1527D5"/>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b="1" kern="0" dirty="0">
                    <a:solidFill>
                      <a:srgbClr val="FFFF00"/>
                    </a:solidFill>
                    <a:effectLst/>
                    <a:highlight>
                      <a:srgbClr val="000000"/>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ATTTCGTCTGAATCTCTCATGTCCGAGAACCCATACCTCAAGAGCCCAAGACGACACAATACACAACAATCACCGTCAATACCCTTCTCTTCCGCTGCCTATAAATACCAATGGAAATCCCACGA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         *      -240         *      -220         *      -200         *      -180         *      -160         *      -14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CTCACCAAATCATCATCACTTGAACACACCAATCCTTACACTTCTAGCTACAATTCTAAGTTTCCATTTTCCAACATCCCATCACATTGTTCAAAAATATCATCAGCCTCGAGTTAGGGTTTATTATCCTTCGTGACC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97</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CTCACCAAATCATCATCACTTGAACACACCAATCCTTACACTTCTAGCTACAATTCTAAGTTTCCATTTTCCAACATCCCATCACATTGTTCAAAAATATCATCAGCCTCGAGTTAGGGTTTATTATCCTTCGTGACC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20         *      -100         *       -80         *       -60         *       -40         *       -2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TTGGTTCTTTTTGAA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TTTCTAGGCCTCTAGCCATC</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TTGTATC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AAAAAAAAATATATTACCAGCTGTTTACACCAAATTAAATAGTAAAAAGAAAGCATC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23</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TTTGGTTCTTTTTGAAA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TTTCTAGGCCTCTAGCCATC</a:t>
                </a:r>
                <a:r>
                  <a:rPr lang="en-US" altLang="zh-CN" sz="800" b="1" kern="0" dirty="0">
                    <a:solidFill>
                      <a:srgbClr val="FF0000"/>
                    </a:solidFill>
                    <a:effectLst/>
                    <a:highlight>
                      <a:srgbClr val="000000"/>
                    </a:highlight>
                    <a:latin typeface="Courier"/>
                    <a:ea typeface="等线" panose="02010600030101010101" pitchFamily="2" charset="-122"/>
                    <a:cs typeface="Times New Roman" panose="02020603050405020304" pitchFamily="18" charset="0"/>
                  </a:rPr>
                  <a:t>TTGTATC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CAAAAAAAAATATATTACCAGCTGTTTACACCAAATTAAATAGTAAAAAGAAAGCATCAA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26</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endParaRPr lang="zh-CN" altLang="en-US" sz="800" dirty="0"/>
              </a:p>
            </p:txBody>
          </p:sp>
        </p:grpSp>
        <p:sp>
          <p:nvSpPr>
            <p:cNvPr id="7" name="矩形 6">
              <a:extLst>
                <a:ext uri="{FF2B5EF4-FFF2-40B4-BE49-F238E27FC236}">
                  <a16:creationId xmlns:a16="http://schemas.microsoft.com/office/drawing/2014/main" id="{2595DEA5-ED6F-4AF9-8F2C-F4D12833054A}"/>
                </a:ext>
              </a:extLst>
            </p:cNvPr>
            <p:cNvSpPr/>
            <p:nvPr/>
          </p:nvSpPr>
          <p:spPr>
            <a:xfrm>
              <a:off x="9239250" y="5889056"/>
              <a:ext cx="213571" cy="300736"/>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solidFill>
                  <a:schemeClr val="tx1"/>
                </a:solidFill>
              </a:endParaRPr>
            </a:p>
          </p:txBody>
        </p:sp>
      </p:grpSp>
    </p:spTree>
    <p:extLst>
      <p:ext uri="{BB962C8B-B14F-4D97-AF65-F5344CB8AC3E}">
        <p14:creationId xmlns:p14="http://schemas.microsoft.com/office/powerpoint/2010/main" val="295795744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a:extLst>
              <a:ext uri="{FF2B5EF4-FFF2-40B4-BE49-F238E27FC236}">
                <a16:creationId xmlns:a16="http://schemas.microsoft.com/office/drawing/2014/main" id="{6AE45015-E19A-A6EE-29E2-D8F5E9DFAC6B}"/>
              </a:ext>
            </a:extLst>
          </p:cNvPr>
          <p:cNvGrpSpPr/>
          <p:nvPr/>
        </p:nvGrpSpPr>
        <p:grpSpPr>
          <a:xfrm>
            <a:off x="619760" y="0"/>
            <a:ext cx="10646833" cy="6903813"/>
            <a:chOff x="619760" y="0"/>
            <a:chExt cx="10646833" cy="6903813"/>
          </a:xfrm>
        </p:grpSpPr>
        <p:grpSp>
          <p:nvGrpSpPr>
            <p:cNvPr id="3" name="组合 2">
              <a:extLst>
                <a:ext uri="{FF2B5EF4-FFF2-40B4-BE49-F238E27FC236}">
                  <a16:creationId xmlns:a16="http://schemas.microsoft.com/office/drawing/2014/main" id="{9F99295C-9633-4687-9384-4F7E39893868}"/>
                </a:ext>
              </a:extLst>
            </p:cNvPr>
            <p:cNvGrpSpPr/>
            <p:nvPr/>
          </p:nvGrpSpPr>
          <p:grpSpPr>
            <a:xfrm>
              <a:off x="619760" y="0"/>
              <a:ext cx="10646833" cy="6903813"/>
              <a:chOff x="619760" y="0"/>
              <a:chExt cx="10646833" cy="6903813"/>
            </a:xfrm>
          </p:grpSpPr>
          <p:sp>
            <p:nvSpPr>
              <p:cNvPr id="10" name="文本框 9">
                <a:extLst>
                  <a:ext uri="{FF2B5EF4-FFF2-40B4-BE49-F238E27FC236}">
                    <a16:creationId xmlns:a16="http://schemas.microsoft.com/office/drawing/2014/main" id="{D369E08E-50F9-4012-91DF-2D03C3471BB3}"/>
                  </a:ext>
                </a:extLst>
              </p:cNvPr>
              <p:cNvSpPr txBox="1"/>
              <p:nvPr/>
            </p:nvSpPr>
            <p:spPr>
              <a:xfrm>
                <a:off x="619760" y="60960"/>
                <a:ext cx="215911" cy="307777"/>
              </a:xfrm>
              <a:prstGeom prst="rect">
                <a:avLst/>
              </a:prstGeom>
              <a:noFill/>
            </p:spPr>
            <p:txBody>
              <a:bodyPr wrap="square" rtlCol="0">
                <a:spAutoFit/>
              </a:bodyPr>
              <a:lstStyle/>
              <a:p>
                <a:r>
                  <a:rPr lang="en-US" altLang="zh-CN" sz="1400" b="1" dirty="0">
                    <a:latin typeface="Times New Roman" panose="02020603050405020304" pitchFamily="18" charset="0"/>
                    <a:cs typeface="Times New Roman" panose="02020603050405020304" pitchFamily="18" charset="0"/>
                  </a:rPr>
                  <a:t>D</a:t>
                </a:r>
                <a:endParaRPr lang="zh-CN" altLang="en-US" sz="1400" b="1" dirty="0">
                  <a:latin typeface="Times New Roman" panose="02020603050405020304" pitchFamily="18" charset="0"/>
                  <a:cs typeface="Times New Roman" panose="02020603050405020304" pitchFamily="18" charset="0"/>
                </a:endParaRPr>
              </a:p>
            </p:txBody>
          </p:sp>
          <p:grpSp>
            <p:nvGrpSpPr>
              <p:cNvPr id="2" name="组合 1">
                <a:extLst>
                  <a:ext uri="{FF2B5EF4-FFF2-40B4-BE49-F238E27FC236}">
                    <a16:creationId xmlns:a16="http://schemas.microsoft.com/office/drawing/2014/main" id="{3A008E76-55F9-4958-AF95-DA08507F84BD}"/>
                  </a:ext>
                </a:extLst>
              </p:cNvPr>
              <p:cNvGrpSpPr/>
              <p:nvPr/>
            </p:nvGrpSpPr>
            <p:grpSpPr>
              <a:xfrm>
                <a:off x="925406" y="0"/>
                <a:ext cx="10341187" cy="6903813"/>
                <a:chOff x="132080" y="0"/>
                <a:chExt cx="10341187" cy="7246692"/>
              </a:xfrm>
            </p:grpSpPr>
            <p:sp>
              <p:nvSpPr>
                <p:cNvPr id="9" name="文本框 8">
                  <a:extLst>
                    <a:ext uri="{FF2B5EF4-FFF2-40B4-BE49-F238E27FC236}">
                      <a16:creationId xmlns:a16="http://schemas.microsoft.com/office/drawing/2014/main" id="{8AEFAA68-241B-4D42-8BDE-32506CDF1248}"/>
                    </a:ext>
                  </a:extLst>
                </p:cNvPr>
                <p:cNvSpPr txBox="1"/>
                <p:nvPr/>
              </p:nvSpPr>
              <p:spPr>
                <a:xfrm>
                  <a:off x="132080" y="0"/>
                  <a:ext cx="10341187" cy="7246692"/>
                </a:xfrm>
                <a:prstGeom prst="rect">
                  <a:avLst/>
                </a:prstGeom>
                <a:noFill/>
              </p:spPr>
              <p:txBody>
                <a:bodyPr wrap="square">
                  <a:spAutoFit/>
                </a:bodyPr>
                <a:lstStyle/>
                <a:p>
                  <a:pPr>
                    <a:lnSpc>
                      <a:spcPts val="900"/>
                    </a:lnSpc>
                  </a:pPr>
                  <a:r>
                    <a:rPr lang="en-US" altLang="zh-CN" sz="10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         *      -200         *      -180         *      -160         *      -140         *      -120         *      -1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TACACTTCTAGCTACAATTCTAAGTTTCCATTTTCCAACATCCCATCACATTGTTCAAAAATATCATCAGCCTCGAGTTAGGGTTTATTATCCTTCGTGACCC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GTATTTGGTTCTTTTTGAAAGA</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TTACACTTCTAGCTACAATTCTAAGTTTCCATTTTCCAACATCCCATCACATTGTTCAAAAATATCATCAGCCTCGAGTTAGGGTTTATTATCCTTCGTGACCC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GTATTTGGTTCTTTTTGAAAGA</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80         *       -60         *       -40         *       -20         *         0         *        20         *        40         *        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TAGGCCTCTAGCCATCTTGTATCTCACCAAAAAAAAATATATTACCAGCTGTTTACACCAAATTAAATAGTAAAAAGAAAGCATCAATGGCTTTAAAAACACAGTTGTTGTGGTCATTTGTTGTTGTTTTTGTTGTTTCCTTCA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TAGGCCTCTAGCCATCTTGTATCTCACCAAAAAAAAATATATTACCAGCTGTTTACACCAAATTAAATAGTAAAAAGAAAGCATCAATGGCTTTAAAAACACAGTTGTTGTGGTCATTTGTTGTTGTTTTTGTTGTTTCCTTCA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         *       100         *       120         *       140         *       160         *       180         *       2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ACTTCATGTTCTGGTAGTAGTTTCCAGGAGGTCAACGCGCTTCATAGTTACGTTGACCATGTTGATGATAAAGAGTCCGGCTATAATTCTAGGGCTTATCCTTCATACACGGACACCATAGAAGGTTTAAAG</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ATGGAATTG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AACTTCATGTTCTGGTAGTAGTTTCCAGGAGGTCAACGCGCTTCATAGTTACGTTGACCATGTTGATGATAAAGAGTCCGGCTATAATTCTAGGGCTTATCCTTCATACACGGACACCATAGAAGGTTTAAAG</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ATGGAATTGA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220         *       240         *       260         *       280         *       300         *       320         *       340         *       3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CCAAGAACTCAGCTCTTCAGTTCAAGGAAGCTCAACACAATCACCGGTGGGATAGCAACATCATCAGCTCCGGCCAAAACCATTAGCGTCGACGATTTTGGAGCTAAAGGGAATGGTGCTGATGACACACAGGTAAACAACAGA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GCCAAGAACTCAGCTCTTCAGTTCAAGGAAGCTCAACACAATCACCGGTGGGATAGCAACATCATCAGCTCCGGCCAAAACCATTAGCGTCGACGATTTTGGAGCTAAAGGGAATGGTGCTGATGACACACAGGTAAACAACAGA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80         *       400         *       420         *       440         *       460         *       480         *       5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TCATAGGCTTAATAATATTAGAATATTAGAATATTCATATGGTGATGCTAACTATAACAACATTTCTGGTCACATTTCTGTTTTATGAAAGATGTGTCCATAATGTTTGGTACAAATTAATAGTACTATTATTATTTGGACCG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TCATAGGCTTAATAATATTAGAATATTAGAATATTCATATGGTGATGCTAACTATAACAACATTTCTGGTCACATTTCTGTTTTATGAAAGATGTGTCCATAATGTTTGGTACAAATTAATAGTACTATTATTATTTGGACCG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520         *       540         *       560         *       580         *       600         *       620         *       640         *       6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TTATTATTTATTGAGTAAATGTGATACAAATAACATTACTTAAGCGTTTAATTTGGTTGAACCAAAAGTTTAAAGTTTATGTATGAATATAATATTGTTTAATTTTTTGTATGTGTTGGTTTAGGCATTTGTGAAGGCATGGAAG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TTATTATTTATTGAGTAAATGTGATACAAATAACATTACTTAAGCGTTTAATTTGGTTGAACCAAAAGTTTAAAGTTTATGTATGAATATAATATTGTTTAATTTTTTGTATGTGTTGGTTTAGGCATTTGTGAAGGCATGGAAG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80         *       700         *       720         *       740         *       760         *       780         *       8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CTTGTTCTTCCAGTGGAGCTATGGTTCTTGTGGTACCA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AGAACTATCTTGTTAGGCCGATTGAATTCTCAGGCCCATGCAAATCTCAACTTACACTGCAGGTAATAATTAATTCGGATCATCTATGTAATTATCTTTAAAT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GCTTGTTCTTCCAGTGGAGCTATGGTTCTTGTGGTACCA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AGAACTATCTTGTTAGGCCGATTGAATTCTCAGGCCCATGCAAATCTCAACTTACACTGCAGGTAATAATTAATTCGGATCATCTATGTAATTATCTTTAAAT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820         *       840         *       860         *       880         *       900         *       920         *       940         *       9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TCCGGACTATAAACTTTGACGATTATATAATAATTAATATTGCTTAATATTTGGAAAAATTCAGATTTATGGAACCATAGAAGCATCAGAAGACCGATCAATCTACAAAGACATAGACCACTGGCTCATCTTTGACAATGTCC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TCCGGACTATAAACTTTGACGATTATATAATAATTAATATTGCTTAATATTTGGAAAAATTCAGATTTATGGAACCATAGAAGCATCAGAAGACCGATCAATCTACAAAGACATAGACCACTGGCTCATCTTTGACAATGTCCA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80         *      1000         *      1020         *      1040         *      1060         *      1080         *      11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120         *      1140         *      1160         *      1180         *      1200         *      1220         *      1240         *      12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ACAGCCCCCTTGCGGTACATACGCCCCCA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CGTGTACATACGTACTCTAATCTGAATATGTATGTGCATTTTAATTAATTAAGCACCATTATTTCTGGAACTAATTAAAATTTGTACATGTAATGTGCAGGCTGTGACC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ACAGCCCCCTTGCGGTACATACGCCCCCA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CGTGTACATACGTACTCTAATCTGAATATGTATGTGCATTTTAATTAATTAAGCACCATTATTTCTGGAACTAATTAAAATTTGTACATGTAATGTGCAGGCTGTGACC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80         *      1300         *      1320         *      1340         *      1360         *      1380         *      14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CAGGTGCAATAACTTGGTGGTGAAGAATCTGAATATCCAAGACGCACAACAAATCCATGTCATATTCCAAAACTGCATCAACGTTCAAGCTTC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TCACGGTAACTGCACCAGAGGACAGCCCTAATACGGACGGAATTCAT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CAGGTGCAATAACTTGGTGGTGAAGAATCTGAATATCCAAGACGCACAACAAATCCATGTCATATTCCAAAACTGCATCAACGTTCAAGCTTCC</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TCACGGTAACTGCACCAGAGGACAGCCCTAATACGGACGGAATTCAT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420         *      1440         *      1460         *      1480         *      1500         *      1520         *      1540         *      15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ATACCCAGAACATCACTATCTCGAGCTCGGTTATAGGAACAGGTGTGACAAATAGTTCA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TCAAAAGTCATCATTTTGGTCTCTCGCGTTTGATAAATACATATGATCGATCAAACACATTAAGATAAAAAAACT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AATACCCAGAACATCACTATCTCGAGCTCGGTTATAGGAACAGGTGTGACAAATAGTTCATG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TTTCAAAAGTCATCATTTTGGTCTCTCGCGTTTGATAAATACATATGATCGATCAAACACATTAAGATAAAAAAACT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80         *      1600         *      1620         *      1640         *      1660         *      1680         *      17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1720         *      1740         *      1760         *      1780         *      1800         *      1820         *      1840         *      18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CTCCAAATTGTTCGACAAATCATCCTAAATTCCTCTTGTCAACATATTATTAATGTTTTTTATG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AAAAGTGCGGGATGACTTTTTATAGTGTCAATAACAGCTGATTAGTAAATATACCAATATATATTAACGGCTGTTTT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CTCCAAATTGTTCGACAAATCATCCTAAATTCCTCTTGTCAACATATTATTAATGTTTTTTATGT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AAAAGTGCGGGATGACTTTTTATAGTGTCAATAACAGCTGATTAGTAAATATACCAATATATATTAACGGCTGTTTT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80         *      1900         *      1920         *      1940         *      1960         *      1980         *      20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TGATCAGTA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AGCTTGGGAGAAGACGGCTCAGAAGATCATGTTTCAGGAGTATTTGTGAATGGAGCTAAGCTTTCAGGAACCTCCAATGGACTCCGGATCAAGACGTGGAAGGGAGGCTCAGGCAGTG</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CAACAT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GTGATCAGTA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AGCTTGGGAGAAGACGGCTCAGAAGATCATGTTTCAGGAGTATTTGTGAATGGAGCTAAGCTTTCAGGAACCTCCAATGGACTCCGGATCAAGACGTGGAAGGGAGGCTCAGGCAGTG</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CAACAT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2020         *      2040         *      2060         *      2080         *      2100         *      2120         *      2140         *      21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CAGAATGTGCAAATGAACGATGTCACCAACCCCATCATCATCGACCAGAACTACTGTGACCACAAAACCAAAGATTGCAAACAACAGGTAATTAATTAATTTAACTAGTTCTTACG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GTTAATTAGTCCCCAGACAAA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CAGAATGTGCAAATGAACGATGTCACCAACCCCATCATCATCGACCAGAACTACTGTGACCACAAAACCAAAGATTGCAAACAACAGGTAATTAATTAATTTAACTAGTTCTTACG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CGTTAATTAGTCCCCAGACAAACC</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80         *      2200         *      2220         *      2240         *      2260         *      2280         *      2300         *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TCACTTCTTGATC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TTCGTTATGGCAGAAATCGGCGG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GTGAAAAATGTGTTGTACCAAAACATAAGAGGAACGAGTGCTTCCGGCGACGCGATAACGTTGAACTGCAGCCAAAGTGTTCCTTGTCAGGGGATCG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5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TCACTTCTTGATCG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TTCGTTATGGCAGAAATCGGCGGT</a:t>
                  </a:r>
                  <a:r>
                    <a:rPr lang="en-US" altLang="zh-CN" sz="8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AGTGAAAAATGTGTTGTACCAAAACATAAGAGGAACGAGTGCTTCCGGCGACGCGATAACGTTGAACTGCAGCCAAAGTGTTCCTTGTCAGGGGATCGTG</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5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2320         *      2340         *      2360         *      2380         *      2400         *      2420         *      2440         *      246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GCAAAGTGTTCAACTGCAGAATGGAAGAGCTGAATGCAACAATGTTCAGCCTGCTTACAAAGGAGTTGTCTCCCCTAGATGTTAAAACCTAGGGTTCATAATTATGGGCATTGTGAAATAGATTATGCAATTCTTGTACCAATTAGC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00</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GCAAAGTGTTCAACTGCAGAATGGAAGAGCTGAATGCAACAATGTTCAGCCTGCTTACAAAGGAGTTGTCTCCCCTAGATGTTAAAACCTAGGGTTCATAATTATGGGCATTGTGAAATAGATTATGCAATTCTTGTACCAATTAGC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0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80         *      2500         *      2520         *      2540          </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AAATAATTGTTTGTTTGTAATATTTATGTTTAATTTGGCATTGTACATAAACATATTCAT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ATGCA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83</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AAATAATTGTTTGTTTGTAATATTTATGTTTAATTTGGCATTGTACATAAACATATTCATAAA</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ATGCAAC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8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
                  </a: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83</a:t>
                  </a:r>
                  <a:b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8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endParaRPr lang="zh-CN" altLang="en-US" sz="800" dirty="0"/>
                </a:p>
              </p:txBody>
            </p:sp>
            <p:sp>
              <p:nvSpPr>
                <p:cNvPr id="11" name="矩形 10">
                  <a:extLst>
                    <a:ext uri="{FF2B5EF4-FFF2-40B4-BE49-F238E27FC236}">
                      <a16:creationId xmlns:a16="http://schemas.microsoft.com/office/drawing/2014/main" id="{24532C5A-9B84-4008-B927-6C5683017A23}"/>
                    </a:ext>
                  </a:extLst>
                </p:cNvPr>
                <p:cNvSpPr/>
                <p:nvPr/>
              </p:nvSpPr>
              <p:spPr>
                <a:xfrm>
                  <a:off x="6256867" y="585893"/>
                  <a:ext cx="189506" cy="294670"/>
                </a:xfrm>
                <a:prstGeom prst="rect">
                  <a:avLst/>
                </a:prstGeom>
                <a:noFill/>
                <a:ln w="127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solidFill>
                      <a:schemeClr val="tx1"/>
                    </a:solidFill>
                  </a:endParaRPr>
                </a:p>
              </p:txBody>
            </p:sp>
          </p:grpSp>
        </p:grpSp>
        <p:sp>
          <p:nvSpPr>
            <p:cNvPr id="4" name="矩形 3">
              <a:extLst>
                <a:ext uri="{FF2B5EF4-FFF2-40B4-BE49-F238E27FC236}">
                  <a16:creationId xmlns:a16="http://schemas.microsoft.com/office/drawing/2014/main" id="{89EFB550-28EB-8982-4E5C-92A802EC9A8C}"/>
                </a:ext>
              </a:extLst>
            </p:cNvPr>
            <p:cNvSpPr/>
            <p:nvPr/>
          </p:nvSpPr>
          <p:spPr>
            <a:xfrm flipH="1" flipV="1">
              <a:off x="6692264" y="6051550"/>
              <a:ext cx="178436" cy="31115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Tree>
    <p:extLst>
      <p:ext uri="{BB962C8B-B14F-4D97-AF65-F5344CB8AC3E}">
        <p14:creationId xmlns:p14="http://schemas.microsoft.com/office/powerpoint/2010/main" val="49532982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a:extLst>
              <a:ext uri="{FF2B5EF4-FFF2-40B4-BE49-F238E27FC236}">
                <a16:creationId xmlns:a16="http://schemas.microsoft.com/office/drawing/2014/main" id="{42DF3CCA-7E7F-41F8-AF76-378E0BAEE745}"/>
              </a:ext>
            </a:extLst>
          </p:cNvPr>
          <p:cNvSpPr txBox="1"/>
          <p:nvPr/>
        </p:nvSpPr>
        <p:spPr>
          <a:xfrm>
            <a:off x="254001" y="-105358"/>
            <a:ext cx="12344400" cy="7095789"/>
          </a:xfrm>
          <a:prstGeom prst="rect">
            <a:avLst/>
          </a:prstGeom>
          <a:noFill/>
        </p:spPr>
        <p:txBody>
          <a:bodyPr wrap="square">
            <a:spAutoFit/>
          </a:bodyPr>
          <a:lstStyle/>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720                   *               -4680                   *               -4640                   *               -4600                   *               -4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GTGAACAACCAAACATACCGGCAATCTAATCAATCCCCCTGGAGGCTAGTGCA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AATGTGGATGCTTCACCTGCTAAGAGTTGTCCCACATCGGTGAGGGATAA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GCTTATA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GGCTACTTCTCATATTGCTAATTGGTTTTATGTTGGAACCCCAATTTCATCATGG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GTGAACAACCAAACATACCGGCAATCTAATCAATCCCCCTGGAGGCTAGTGCA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AATGTGGATGCTTCACCTGCTAAGAGTTGTCCCACATCGGTGAGGGATAA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GCTTATA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GGCTACTTCTCATATTGCTAATTGGTTTTATGTTGGAACCCCAATTTCATCATGG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20                   *               -4480                   *               -4440                   *               -4400                   *               -4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TTGTCCTCGTGTGAAGCCAAACGGCCACACGCGCTCCACGTCACCTAGTTGTTGTCCACGTGTAGGC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AATCCACCACACGTGCAGGGGCATGTTGAGAGTCGTCACCTAGTTGTTGTCCACGTGTAGGCT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TCCACCACACG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GCATGTTGAGAGTTGTCCCACATCGGTGAGG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TTGTCCTCGTGTGAAGCCAAACGGCCACACGCGCTCCACGTCACCTAGTTGTTGTCCACGTGTAGGCT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TCCACCACACG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GCATGTTGAGAGTTGTCCCACATCGGTGAGG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320                   *               -4280                   *               -4240                   *               -4200                   *               -4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GTTTGCTATGTGCTTATATGATCTTGGGC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TCATATTGCCAATTGGTT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AACTCCAATTTCATCATCACCTTTATTTTATTAAATTAATGTTTCATTTGGCTATATCTTATTCTTTACGTGACCCTTAAGCCAATTCAAAGCTCTAGAAATAAAGCACAAGATTTACACTTTTTATAATCG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GTTTGCTATGTGCTTATATGATCTTGGGC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TCATATTGCCAATTGGTT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GGAACTCCAATTTCATCATCACCTTTATTTTATTAAATTAATGTTTCATTTGGCTATATCTTATTCTTTACGTGACCCTTAAGCCAATTCAAAGCTCTAGAAATAAAGCACAAGATTTACACTTTTTATAATCG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120                   *               -4080                   *               -4040                   *               -4000                   *               -3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ATTTTCTCATCATTTCGTGGTGTGTTCAAAATTCAAATAAACACGCAAGGTGTAAGCA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TTGAAAAGTGGATAACGTACGTTTGCATGGTGACATGCATGAGCCGTCCCTTTGAGATAGCAAAGGGTTATACCATGCCATGATCTAGAAAGAAAACATACACGATAGAAATATATTTGAAT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ATTTTCTCATCATTTCGTGGTGTGTTCAAAATTCAAATAAACACGCAAGGTGTAAGCA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TTGAAAAGTGGATAACGTACGTTTGCATGGTGACATGCATGAGCCGTCCCTTTGAGATAGCAAAGGGTTATACCATGCCATGATCTAGAAAGAAAACATACACGATAGAAATATATTTGAATTCA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3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20                   *               -3880                   *               -3840                   *               -3800                   *               -3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ATTTGGACCATTCCGAGCAAGTCTATCTAAATAGCAATAGCATCACTCTATATTATTGC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GGCCCGGCCCAGGCGCAGTGCAACAGGGGCAATTGTCCAGGGCCCAAAGTTGAATGGGGCACCCAAAAAACAAAATCCAAATAATTAGGTATAAAAAAAAATTTGTCCAA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CTATTTGGACCATTCCGAGCAAGTCTATCTAAATAGCAATAGCATCACTCTATATTATTGC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1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20                   *               -3680                   *               -3640                   *               -3600                   *               -3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CAAAATAAAGGCTGTAGGCGATAACTTGTCCAGGTTTTGGGGATTAAAAATCAATATAACATAAAGGGTATCTGAAGGGGACAAGTCGTCCAGGTTTTGGGCATGGAGGAGAGGCATAAGATTCAAGTTTTTCAAAGGGAGCTCCCTCTCTGCTTGGAGCTTGTCACCCAACTGCCCAAGCCCAAGGTACTACGGAG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520                   *               -3480                   *               -3440                   *               -3400                   *               -3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CAAACCCTTCTCAAATTTCAGCTTAATTTTTGTGTTCTAAGTCGGAAGCTTCGTTTCTTTTGCTTGAATTGTTCTGGTTTCTGTTTTCAAAATTGGGGTTTTTTTTGTAGCTATTGAGAGGTGCAAGCAGCAGATTTCAGATGCAACCGCAAATTACCTGCATGGACAATCTAAGTGTTCTGAGCAGACTTCAAG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20                   *               -3280                   *               -3240                   *               -3200                   *               -3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GGCATGTTTTTGAGGAATTCATTCCATTAACACGGATTTCATACAACTCCAGATGCACCACTCGAAGAGGTATAAAAAAAAGACTCCACCTTCATCAATTTTAGTAAATTTTGTGACTGCCCTTTTGTTTGGTTGCTTATAAAATTTGAGGTGAAGAAGTGGAAAGTATTGATTTTTAGGTGTAGGGTAATGGCAG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120                   *               -3080                   *               -3040                   *               -3000                   *               -2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AGCAAGTTAAAGGCTATAGTGATGGAGATGAAGAGAAATGGGGTGCTTTTCAGCCTTTCCAAGGGAAAAAAAAAGCATTGGAAAGACAAATGGACCGGTGGCTAAAGAACCTTCTTCGGCTCCGGCTACTAGTTCCACCACGGACACCGTGAGTGGAGACAGTGGTGGGAACAACAAGAACAAAGAGAAAGATGGA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20                   *               -2880                   *               -2840                   *               -2800                   *               -2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GAAACGAAGGCGAAACTGGTCACCGGAGTTGCACCGCCGGTTCTTGCATGCTCTTCTCTTCAACAACTTGGTGGTTCACTTGGTATGCAGTTGAGATTAATTTAGTGGGATATGTTATTTTATATGATTGGATGAATATGTGATTGGATTGTGATGTATTGGATGTGTTTAATGCGTTCTGCGTATATGTGATTT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20                   *               -2680                   *               -2640                   *               -2600                   *               -2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ATCTGTTTTTAATCATAATTTGGTTGATGTGAAAATTTTTGCACATACATGATAGAAATTGGAAGGCATTTTGCATGCTACTAGTGATGATTTTTTTACACATACATGTGATTAACCTCGCAAAATATTTATTTTAAACATATGTTTCTGTACTAAAAAGGGCACATTTTGAACTTTCGCACTGGGCACCAAAAAAC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20                   *               -2480                   *               -2440                   *               -2400                   *               -2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ACCGGCCCTG</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TTACATATTCAATATAAAGTTCCAATACGATCACTGATTGATTAATTGGTATCAAGTACAATACTTCTGCATCTCTCTTAAAAAACATCAACAATGCATTACGTGTTGTAGATTGTTATCAGAGTCGGCCC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TTACATATTCAATATAAAGTTCCAATACGATCACTGATTGATTAATTGGTATCAAGTACAATACTTCTGCATCTCTCTTAAAAAACATCAACAATGCATTACGTGTTGTAGATTGTTATCAGAGTCGGCCC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98</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20                   *               -2280                   *               -2240                   *               -2200                   *               -2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ACCAGGGCGACCGCTCGAGGTCCAAAAAAACGAGG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CATATATGTATAAGGTTTTGTTTTATTCTTGAT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ACGCTCATATTAAATAGCAATATGTTTTAG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GGTTTTATTTGGTTTTTCCGTGCCCACCTAGGTTTAATTCCCTCTCTC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ACCAGGGCGACCGCTCGAGGTCCAAAAAAACGAGG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CATATATGTATAAGGTTTTGTTTTATTCTTGAT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ACGCTCATATTAAATAGCAATATGTTTTAGATG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GGTTTTATTTGGTTTTTCCGTGCCCACCTAGGTTTAATTCCCTCTCTCAA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20                   *               -2080                   *               -2040                   *               -2000                   *               -1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GTAGTTTCCCTTCTATTTTATTCATGTCTACTTTAAATAACAAACAAACATTAATTAGCTTATTAAATGT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AGTAGTCGTTTTTTGTTTTCAGTTTGAATTAACTCGCAAAATCATGTTCAAGTTTGTCTAAATATAAATTTAGGTTTTTTATATTTGTTGATAATCTTTTCATGGTTAAGTA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GGGTAGTTTCCCTTCTATTTTATTCATGTCTACTTTAAATAACAAACAAACATTAATTAGCTTATTAAATGTG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TCAGTAGTCGTTTTTTGTTTTCAGTTTGAATTAACTCGCAAAATCATGTTCAAGTTTGTCTAAATATAAATTTAGGTTTTTTATATTTGTTGATAATCTTTTCATGGTTAAGTA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20                   *               -1880                   *               -1840                   *               -1800                   *               -1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TGTGATCATTATCTTTTTATTGAACGAAGTATTGTTATTGACAATCCAAAAATATCATCCTACACTTCTTTGTATAATTTTTCCCTTATGATTTTATATATTTGGAATGAACCGCAACTTTTCATGAGCGCTCGAAAAACAAAAACATAGTTGAATTACTATG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GTAGTAGCAATTTGTTGTTTT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TGTGATCATTATCTTTTTATTGAACGAAGTATTGTTATTGACAATCCAAAAATATCATCCTACACTTCTTTGTATAATTTTTCCCTTATGATTTTATATATTTGGAATGAACCGCAACTTTTCATGAGCGCTCGAAAAACAAAAACATAGTTGAATTACTATGT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GGTAGTAGCAATTTGTTGTTTT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20                   *               -1680                   *               -1640                   *               -1600                   *               -1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TGCTTACATATAGAAATTAGAGATCTTAAATA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TTCAAAAGTTTCATAATGTGCAAGTAGCTTGTAGATCAGTTAGTTAAAAGTGTTCAGCTTGTCACTCAATGACTCGTTTTCAAATTTCCTCACCGTA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GTAAATTACCCTATCATTTGTCAAAAAAGTCATAATG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TTGCTTACATATAGAAATTAGAGATCTTAAATATG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TTCAAAAGTTTCATAATGTGCAAGTAGCTTGTAGATCAGTTAGTTAAAAGTGTTCAGCTTGTCACTCAATGACTCGTTTTCAAATTTCCTCACCGTA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GTAAATTACCCTATCATTTGTCAAAAAAGTCATAATG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7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520                   *               -1480                   *               -1440                   *               -1400                   *               -1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GTCTATTTTCTTTAATATTCAATGTACAACATACGAATACTAAGATAAATAATTATTTTATGTGAAGTTATGTTAGGGCATATTTTTCAATGT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GGGCCTCATAAAACTCAGGATAGGCCTTGATTGTTATATATGGTACTAAACAAAAGTTTCCCAAATACAAAGTTTAAAAAGATTCAAGTG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GGTCTATTTTCTTTAATATTCAATGTACAACATACGAATACTAAGATAAATAATTATTTTATGTGAAGTTATGTTAGGGCATATTTTTCAATGT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AGGGCCTCATAAAACTCAGGATAGGCCTTGATTGTTATATATGGTACTAAACAAAAGTTTCCCAAATACAAAGTTTAAAAAGATTCAAGTG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9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320                   *               -1280                   *               -1240                   *               -1200                   *               -1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GAATT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ATTATAAATTTTGATAAACCCTCGAGTTGATTAATTGCGGGGGATGTGGTCATCATGACCGCTGTGGTAGTTCATGGAGCAACCTACTTGTTCCCCCACTTATGATTGACGCATTTTT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GAACAT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5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GAATT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GTATTATAAATTTTGATAAACCCTCGAGTTGATTAATTGCGGGGGATGTGGTCATCATGACCGCTGTGGTAGTTCATGGAGCAACCTACTTGTTCCCCCACTTATGATTGACGCATTTTTA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GAACATC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CAGAACCGTTCGTTCTCTTTGTCATCATCGAAAGATCA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1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120                   *               -1080                   *               -1040                   *               -1000                   *                -9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CTCATTAAATTG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TTTA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ATGTATCATACAAAT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TCATCATAAG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TTGTTACCAAAAACATTGATTGGTTTGACATATATGGATGGGTAAACAATCTCCAAATGGAATATTTTTTTTAGATATGATATTTCGATGATGATAAAGAGAATGAACGGGTCAAATA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7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CTCATTAAATTG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TTTAG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CATATGTATCATACAAAT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TTCATCATAAGG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TTGTTACCAAAAACATTGATTGGTTTGACATATATGGATGGGTAAACAATCTCCAAATGGAATATTTTTTTTAGATATGATATTTCGATGATGATAAAGAGAATGAACGGGTCAAATAA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3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920                   *                -880                   *                -840                   *                -800                   *                -7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TCATATGGTGAAGATGCGTAAATCATAAGTGAAGGGACAAGTTGGTTCCCTATGGAGGACACAAGCATT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TTTAGGTGTATTCAATTAGAATTGTAAATGAATCTATAAAAGTTCAGGAATATTCAGTCAGAATGTTAAACAAGCTTATAGAACTCCATACAAATTCAGGTGTATTAATCAATTA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9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GTTCATATGGTGAAGATGCGTAAATCATAAGTGAAGGGACAAGTTGGTTCCCTATGGAGGACACAAGCATT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TTTTAGGTGTATTCAATTAGAATTGTAAATGAATCTATAAAAGTTCAGGAATATTCAGTCAGAATGTTAAACAAGCTTATAGAACTCCATACAAATTCAGGTGTATTAATCAATTA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596</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720                   *                -680                   *                -640                   *                -600                   *                -5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AGGATTTTATAAAAGTCAACAGAAATCTGAGTGTATTCAAAGAAGATTTTGAAAAAGTCTAAGAAAGTTAGAGTGTAT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TAATTTGATTTTAAAGAATTTTAAAATGATACATTTTAGTAAATTTGAAGGAATTTCATAGAGTATTTAACCCTTAATAAATCATACTTCTGTAAAGTC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1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AGGATTTTATAAAAGTCAACAGAAATCTGAGTGTATTCAAAGAAGATTTTGAAAAAGTCTAAGAAAGTTAGAGTGTAT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AATAATTTGATTTTAAAGAATTTTAAAATGATACATTTTAGTAAATTTGAAGGAATTTCATAGAGTATTTAACCCTTAATAAATCATACTTCTGTAAAGTCC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520                   *                -480                   *                -440                   *                -400                   *                -3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ATCAACTTTCATAAATTGAAACATTTTTAAATCCATAAAAGTTGAACCGAATCTATTTTCATATATTATTTTATACATGCAACGACTTACGTTGTAACATAAGGGATGCAATGCATGGCGCAGAAAGTCATAGAGTCGGCCAAGAGATCATTTCGTCTGAATCTCTCATGTCCGAGAACCCATACCTCAAG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3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ATCAACTTTCATAAATTGAAACATTTTTAAATCCATAAAAGTTGAACCGAATCTATTTTCATATATTATTTTATACATGCAACGACTTACGTTGTAACATAAGGGATGCAATGCATGGCGCAGAAAGTCATAGAGTCGGCCAAGAGATCATTTCGTCTGAATCTCTCATGTCCGAGAACCCATACCTCAAGAG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9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                   *                -280                   *                -240                   *                -200                   *                -16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AGACGACACAATACACAACAA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G</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TCAATACCCTTCTCTTCCGCTGCCTATAAATACCAATGGAAATCCCACGACATTCTCACCAAATCATCATCACTTGAACACACCAA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ACTTCTAGCTACAATTCTAAGTTTCCATTTTCCAACATCC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TGTTCAAAAATATCATCAGCCTCGAG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5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AGACGACACAATACACAACAA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GTCAATACCCTTCTCTTCCGCTGCCTATAAATACCAATGGAAATCCCACGACATTCTCACCAAATCATCATCACTTGAACACACCAAT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CACTTCTAGCTACAATTCTAAGTTTCCATTTTCCAACATCC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TGTTCAAAAATATCATCAGCCTCGAGTT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1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                   *                 -80                   *                 -40                   *                   0                   *                  4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TTTATTATCCTTCGTGA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GTATTTGGTTCTTTTTGAA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C</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TTTCTAGGCCTCTAGCCATCTTGTATCTCACCAAAAAAAAATATATTACCAGCTGTTTACACCAAATTAAATAGTAAAAAGAAAGCATCAATGGCTTTAAAAACACAGTTGTTGTGGTCATTTGTTGT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7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GTTTATTATCCTTCGTGACC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TTAGTATTTGGTTCTTTTTGAAA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TTGTTAGGTGTTTCTAGGCCTCTAGCCATCTTGTATCTCACCAAAAAAAAATATATTACCAGCTGTTTACACCAAATTAAATAGTAAAAAGAAAGCATCAATGGCTTTAAAAACACAGTTGTTGTGGTCATTTGTTGTTG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3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                   *                 120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TTGTTTCCTTCAGTACAACTTCATGTTCTGGTAGTAGTTTCCAGGAGGTCAACGCGCTTCATAGTTACGTTGACCATGTTGATGATAAAGAG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8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TTGTTTCCTTCAGTACAACTTCATGTTCTGGTAGTAGTTTCCAGGAGGTCAACGCGCTTCATAGTTACGTTGACCATGTTGATGATAAAGAGTCC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95</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zh-CN" altLang="en-US" sz="700" dirty="0"/>
          </a:p>
        </p:txBody>
      </p:sp>
      <p:sp>
        <p:nvSpPr>
          <p:cNvPr id="4" name="文本框 3">
            <a:extLst>
              <a:ext uri="{FF2B5EF4-FFF2-40B4-BE49-F238E27FC236}">
                <a16:creationId xmlns:a16="http://schemas.microsoft.com/office/drawing/2014/main" id="{F45167E6-63FB-46A5-AF2A-81804596A93D}"/>
              </a:ext>
            </a:extLst>
          </p:cNvPr>
          <p:cNvSpPr txBox="1"/>
          <p:nvPr/>
        </p:nvSpPr>
        <p:spPr>
          <a:xfrm>
            <a:off x="0" y="-43891"/>
            <a:ext cx="529981"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E</a:t>
            </a:r>
            <a:endParaRPr kumimoji="0" lang="zh-CN" altLang="en-US" sz="14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
        <p:nvSpPr>
          <p:cNvPr id="5" name="矩形 4">
            <a:extLst>
              <a:ext uri="{FF2B5EF4-FFF2-40B4-BE49-F238E27FC236}">
                <a16:creationId xmlns:a16="http://schemas.microsoft.com/office/drawing/2014/main" id="{82AF37BA-4E16-4B30-B9D1-3BC2919BAAC1}"/>
              </a:ext>
            </a:extLst>
          </p:cNvPr>
          <p:cNvSpPr/>
          <p:nvPr/>
        </p:nvSpPr>
        <p:spPr>
          <a:xfrm>
            <a:off x="9360518" y="6181642"/>
            <a:ext cx="189506" cy="280728"/>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spTree>
    <p:extLst>
      <p:ext uri="{BB962C8B-B14F-4D97-AF65-F5344CB8AC3E}">
        <p14:creationId xmlns:p14="http://schemas.microsoft.com/office/powerpoint/2010/main" val="25360674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C03EAAE0-91C7-479D-B2F6-1545586DAC9A}"/>
              </a:ext>
            </a:extLst>
          </p:cNvPr>
          <p:cNvSpPr txBox="1"/>
          <p:nvPr/>
        </p:nvSpPr>
        <p:spPr>
          <a:xfrm>
            <a:off x="-65837" y="589250"/>
            <a:ext cx="529981"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F</a:t>
            </a:r>
            <a:endParaRPr kumimoji="0" lang="zh-CN" altLang="en-US" sz="14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grpSp>
        <p:nvGrpSpPr>
          <p:cNvPr id="9" name="组合 8">
            <a:extLst>
              <a:ext uri="{FF2B5EF4-FFF2-40B4-BE49-F238E27FC236}">
                <a16:creationId xmlns:a16="http://schemas.microsoft.com/office/drawing/2014/main" id="{B93E2EF6-28F7-8120-845B-4EBD8EC3050D}"/>
              </a:ext>
            </a:extLst>
          </p:cNvPr>
          <p:cNvGrpSpPr/>
          <p:nvPr/>
        </p:nvGrpSpPr>
        <p:grpSpPr>
          <a:xfrm>
            <a:off x="106533" y="501468"/>
            <a:ext cx="12189041" cy="5855064"/>
            <a:chOff x="106533" y="501468"/>
            <a:chExt cx="12189041" cy="5855064"/>
          </a:xfrm>
        </p:grpSpPr>
        <p:grpSp>
          <p:nvGrpSpPr>
            <p:cNvPr id="10" name="组合 9">
              <a:extLst>
                <a:ext uri="{FF2B5EF4-FFF2-40B4-BE49-F238E27FC236}">
                  <a16:creationId xmlns:a16="http://schemas.microsoft.com/office/drawing/2014/main" id="{E064C1C6-954A-972C-8803-20D769CFF205}"/>
                </a:ext>
              </a:extLst>
            </p:cNvPr>
            <p:cNvGrpSpPr/>
            <p:nvPr/>
          </p:nvGrpSpPr>
          <p:grpSpPr>
            <a:xfrm>
              <a:off x="106533" y="501468"/>
              <a:ext cx="12189041" cy="5855064"/>
              <a:chOff x="106533" y="501468"/>
              <a:chExt cx="12189041" cy="5855064"/>
            </a:xfrm>
          </p:grpSpPr>
          <p:sp>
            <p:nvSpPr>
              <p:cNvPr id="12" name="文本框 11">
                <a:extLst>
                  <a:ext uri="{FF2B5EF4-FFF2-40B4-BE49-F238E27FC236}">
                    <a16:creationId xmlns:a16="http://schemas.microsoft.com/office/drawing/2014/main" id="{6A5BCB23-E763-D534-0327-AEC127624B2C}"/>
                  </a:ext>
                </a:extLst>
              </p:cNvPr>
              <p:cNvSpPr txBox="1"/>
              <p:nvPr/>
            </p:nvSpPr>
            <p:spPr>
              <a:xfrm>
                <a:off x="106533" y="501468"/>
                <a:ext cx="12189041" cy="5855064"/>
              </a:xfrm>
              <a:prstGeom prst="rect">
                <a:avLst/>
              </a:prstGeom>
              <a:noFill/>
            </p:spPr>
            <p:txBody>
              <a:bodyPr wrap="square">
                <a:spAutoFit/>
              </a:bodyPr>
              <a:lstStyle/>
              <a:p>
                <a:pPr marL="0" marR="0" lvl="0" indent="0" algn="l" defTabSz="914400" rtl="0" eaLnBrk="1" fontAlgn="auto" latinLnBrk="0" hangingPunct="1">
                  <a:lnSpc>
                    <a:spcPts val="1000"/>
                  </a:lnSpc>
                  <a:spcBef>
                    <a:spcPts val="0"/>
                  </a:spcBef>
                  <a:spcAft>
                    <a:spcPts val="0"/>
                  </a:spcAft>
                  <a:buClrTx/>
                  <a:buSzTx/>
                  <a:buFontTx/>
                  <a:buNone/>
                  <a:tabLst/>
                  <a:defRPr/>
                </a:pP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         *      -200         *      -180         *      -160         *      -140         *      -120         *      -100         *       -80         *       -60         *       -4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CACTTCTAGCTACAATTCTAAGTTTCCATTTTCCAACATCCC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CATTGTTCAAAAATATCATCAGCCTCGAGTTAGGGTTTATTATCCTTCGTGACCC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TTAGTATTTGGTTCTTTTTGAAAG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TTTGTTAGGTGTTTCTAGGCCTCTAGCCATCTTGTATCTCACCAAAAAAAAATATATT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CACTTCTAGCTACAATTCTAAGTTTCCATTTTCCAACATCCC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ACATTGTTCAAAAATATCATCAGCCTCGAGTTAGGGTTTATTATCCTTCGTGACCC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TTAGTATTTGGTTCTTTTTGAAAGA</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TTTGTTAGGTGTTTCTAGGCCTCTAGCCATCTTGTATCTCACCAAAAAAAAATATATT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         *         0         *        20         *        40         *        60         *        80         *       100         *       120         *       140         *       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         *       200         *       220         *       240         *       260         *       280         *       300         *       320         *       340         *       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CCTTCATACACGGACACCATAGAAGGTTTAAAGTTCATGGAATTGATCAGGCCAAGAACTCAGCTCTTCAGTTCAAGGAAGCTCAACACAATCACCGGTGGGATAGCAACATCATCAGCTCCGGCCAAAACCATTAGCGTCGACGATTTTGGAGCTAAAGGGAATGGTGCTGATGACACACAGGTAAACAACAGATG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CCTTCATACACGGACACCATAGAAGGTTTAAAGTTCATGGAATTGATCAGGCCAAGAACTCAGCTCTTCAGTTCAAGGAAGCTCAACACAATCACCGGTGGGATAGCAACATCATCAGCTCCGGCCAAAACCATTAGCGTCGACGATTTTGGAGCTAAAGGGAATGGTGCTGATGACACACAGGTAAACAACAGATG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380         *       400         *       420         *       440         *       460         *       480         *       500         *       520         *       540         *       5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GGACTCATAGGCTTAATAATATTA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ATTAGAATATTCATATGGTGATGCTAACTATAACAACATTTCTGGTCACATTTCTGTTTTATGAAAGATGTGTC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TGTTTGGTACAAATTAATAGTACTATTATTATTTGGACCGAACTCATTATTATTTATTGAGTAAATGTGATACAAATAACATTACTTAAGC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GGACTCATAGGCTTAATAATATTA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TATTAGAATATTCATATGGTGATGCTAACTATAACAACATTTCTGGTCACATTTCTGTTTTATGAAAGATGTGTC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TGTTTGGTACAAATTAATAGTACTATTATTATTTGGACCGAACTCATTATTATTTATTGAGTAAATGTGATACAAATAACATTACTTAAGC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580         *       600         *       620         *       640         *       660         *       680         *       700         *       720         *       740         *       7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GGAAGAACTATCTTGTTAGGCCGATTGAATTCTCAGGCCCATGCAAATCTCAACT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GGAAGAACTATCTTGTTAGGCCGATTGAATTCTCAGGCCCATGCAAATCTCAACT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780         *       800         *       820         *       840         *       860         *       880         *       900         *       920         *       940         *       9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GCAGGTAATAATTAATTCGGATCATCTATGTAATTATCTTTAAATGTAATTCCGGAC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TTTGACGATTATATAATAATTAATATTGCTTAATATTTGGAAAAATTCAGATTTATGGAACCATAGAAGCATCAGAAGACCGATCAATCTACAAAGACATAGACCACTGGCTCATCTTTGACAATGTCCA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GCAGGTAATAATTAATTCGGATCATCTATGTAATTATCTTTAAATGTAATTCCGGAC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ACTTTGACGATTATATAATAATTAATATTGCTTAATATTTGGAAAAATTCAGATTTATGGAACCATAGAAGCATCAGAAGACCGATCAATCTACAAAGACATAGACCACTGGCTCATCTTTGACAATGTCCA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980         *      1000         *      1020         *      1040         *      1060         *      1080         *      1100         *      1120         *      1140         *      1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GTGTACA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GTGTACATA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180         *      1200         *      1220         *      1240         *      1260         *      1280         *      1300         *      1320         *      1340         *      1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C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C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380         *      1400         *      1420         *      1440         *      1460         *      1480         *      1500         *      1520         *      1540         *      15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CGCTTTCAAAAGTCATCATTTTGGTCTC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GTTTGATAAATACATATGATCGATCAAACACATTAAGATAAAAAAAC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CGCTTTCAAAAGTCATCATTTTGGTCTCT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GTTTGATAAATACATATGATCGATCAAACACATTAAGATAAAAAAACTAA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8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580         *      1600         *      1620         *      1640         *      1660         *      1680         *      1700         *      1720         *      1740         *      17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0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780         *      1800         *      1820         *      1840         *      1860         *      1880         *      1900         *      1920         *      1940         *      19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AATGTTTTTT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CGAGAAAAGTGCGGGATGACTTTTTATAGTGTCAATAACAGCTGATTAGTAAATATACCAATATATATTAACGGCTGTTTTAATTTTGTGATCAGTA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GTAGCTTGGGAGAAGACGGCTCAGAAGATCATGTTTCAGGAGTATTTGTGAATGGAGCTAAGCTTTCAGGAACCTCCAATG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AATGTTTTTT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TCGAGAAAAGTGCGGGATGACTTTTTATAGTGTCAATAACAGCTGATTAGTAAATATACCAATATATATTAACGGCTGTTTTAATTTTGTGATCAGTAT</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GTAGCTTGGGAGAAGACGGCTCAGAAGATCATGTTTCAGGAGTATTTGTGAATGGAGCTAAGCTTTCAGGAACCTCCAATGG</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2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1980         *      2000         *      2020         *      2040         *      2060         *      2080         *      2100         *      2120         *      2140         *      21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CCGGATCAAGACGTGGAAGGGAGGCTCAGGCAGTGTAACCAACATTGTTTTCCAGAATGTGCAAATGAACGATGTCACCAACCCCATCATCATCGACCAGAACTACTGTGACCACAAAACCAAAGATTGCAAACAACAGGTAATTAATTAATTTAACTAGTTCTTACGCATTTCGTTAATTAGTCCCCAGACAA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ACTCCGGATCAAGACGTGGAAGGGAGGCTCAGGCAGTGTAACCAACATTGTTTTCCAGAATGTGCAAATGAACGATGTCACCAACCCCATCATCATCGACCAGAACTACTGTGACCACAAAACCAAAGATTGCAAACAACAGGTAATTAATTAATTTAACTAGTTCTTACGCATTTCGTTAATTAGTCCCCAGACAAACC</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4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180         *      2200         *      2220         *      2240         *      2260         *      2280         *      2300         *      2320         *      2340         *      236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AATCACTTCTTGATC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TCGTTATGGCAGAAATCGGCGGTTCAAGTGAAAAATGTGTTGTACCAAAACATAAGAGGAACGAGTGCTTCCG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CGCGATAACGTTGAACTGCAGCCAAAGTGTTCCTTGTCAGGGGATCGTGCTGCAAAGTGTTCAACTGCAGAATGGAAGAGCTGAATGCAACAATGTT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TAATCACTTCTTGATCG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TTCGTTATGGCAGAAATCGGCGGTTCAAGTGAAAAATGTGTTGTACCAAAACATAAGAGGAACGAGTGCTTCCGG</a:t>
                </a:r>
                <a:r>
                  <a:rPr lang="en-US" altLang="zh-CN" sz="700" b="1" kern="0" dirty="0">
                    <a:solidFill>
                      <a:srgbClr val="000000"/>
                    </a:solidFill>
                    <a:highlight>
                      <a:srgbClr val="FFFF00"/>
                    </a:highlight>
                    <a:latin typeface="Courier"/>
                    <a:ea typeface="等线" panose="02010600030101010101" pitchFamily="2" charset="-122"/>
                    <a:cs typeface="Times New Roman" panose="02020603050405020304" pitchFamily="18" charset="0"/>
                  </a:rPr>
                  <a:t>C</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ACGCGATAACGTTGAACTGCAGCCAAAGTGTTCCTTGTCAGGGGATCGTGCTGCAAAGTGTTCAACTGCAGAATGGAAGAGCTGAATGCAACAATGTTCA</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600</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380         *      2400         *      2420         *      2440         *      2460         *      2480         *      2500         *      2520         *      2540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1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GAAAAAGATGCAAC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783</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allele2 : </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GAAAAAGATGCAAC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G</a:t>
                </a:r>
                <a:r>
                  <a:rPr kumimoji="0" lang="en-US" altLang="zh-CN" sz="700" b="0" i="0" u="none" strike="noStrike" kern="0" cap="none" spc="0" normalizeH="0" baseline="0" noProof="0" dirty="0">
                    <a:ln>
                      <a:noFill/>
                    </a:ln>
                    <a:solidFill>
                      <a:srgbClr val="FFFFFF"/>
                    </a:solidFill>
                    <a:effectLst/>
                    <a:highlight>
                      <a:srgbClr val="000000"/>
                    </a:highlight>
                    <a:uLnTx/>
                    <a:uFillTx/>
                    <a:latin typeface="Courier"/>
                    <a:ea typeface="等线" panose="02010600030101010101" pitchFamily="2" charset="-122"/>
                    <a:cs typeface="Times New Roman" panose="02020603050405020304" pitchFamily="18" charset="0"/>
                  </a:rPr>
                  <a:t>T</a:t>
                </a: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 2783</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t>                                                                                                                                                                                                        </a:t>
                </a:r>
                <a:br>
                  <a:rPr kumimoji="0" lang="en-US" altLang="zh-CN" sz="700" b="0" i="0" u="none" strike="noStrike" kern="0" cap="none" spc="0" normalizeH="0" baseline="0" noProof="0" dirty="0">
                    <a:ln>
                      <a:noFill/>
                    </a:ln>
                    <a:solidFill>
                      <a:srgbClr val="000000"/>
                    </a:solidFill>
                    <a:effectLst/>
                    <a:highlight>
                      <a:srgbClr val="FFFFFF"/>
                    </a:highlight>
                    <a:uLnTx/>
                    <a:uFillTx/>
                    <a:latin typeface="Courier"/>
                    <a:ea typeface="等线" panose="02010600030101010101" pitchFamily="2" charset="-122"/>
                    <a:cs typeface="Times New Roman" panose="02020603050405020304" pitchFamily="18" charset="0"/>
                  </a:rPr>
                </a:br>
                <a:endParaRPr kumimoji="0" lang="zh-CN" altLang="en-US" sz="7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
            <p:nvSpPr>
              <p:cNvPr id="13" name="矩形 12">
                <a:extLst>
                  <a:ext uri="{FF2B5EF4-FFF2-40B4-BE49-F238E27FC236}">
                    <a16:creationId xmlns:a16="http://schemas.microsoft.com/office/drawing/2014/main" id="{7F9621A9-A5DE-AAFB-2917-3B1DC9EE8C28}"/>
                  </a:ext>
                </a:extLst>
              </p:cNvPr>
              <p:cNvSpPr/>
              <p:nvPr/>
            </p:nvSpPr>
            <p:spPr>
              <a:xfrm>
                <a:off x="2886566" y="1170730"/>
                <a:ext cx="189506" cy="280728"/>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
          <p:nvSpPr>
            <p:cNvPr id="11" name="矩形 10">
              <a:extLst>
                <a:ext uri="{FF2B5EF4-FFF2-40B4-BE49-F238E27FC236}">
                  <a16:creationId xmlns:a16="http://schemas.microsoft.com/office/drawing/2014/main" id="{5EB574DD-19D7-A44C-EE04-FA8A0378680E}"/>
                </a:ext>
              </a:extLst>
            </p:cNvPr>
            <p:cNvSpPr/>
            <p:nvPr/>
          </p:nvSpPr>
          <p:spPr>
            <a:xfrm flipH="1" flipV="1">
              <a:off x="2558414" y="5721350"/>
              <a:ext cx="178436" cy="31115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Tree>
    <p:extLst>
      <p:ext uri="{BB962C8B-B14F-4D97-AF65-F5344CB8AC3E}">
        <p14:creationId xmlns:p14="http://schemas.microsoft.com/office/powerpoint/2010/main" val="42528735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43B68F95-C906-4A6C-B616-6A895626B548}"/>
              </a:ext>
            </a:extLst>
          </p:cNvPr>
          <p:cNvSpPr txBox="1"/>
          <p:nvPr/>
        </p:nvSpPr>
        <p:spPr>
          <a:xfrm>
            <a:off x="0" y="-43891"/>
            <a:ext cx="529981"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G</a:t>
            </a:r>
            <a:endParaRPr kumimoji="0" lang="zh-CN" altLang="en-US" sz="14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grpSp>
        <p:nvGrpSpPr>
          <p:cNvPr id="6" name="组合 5">
            <a:extLst>
              <a:ext uri="{FF2B5EF4-FFF2-40B4-BE49-F238E27FC236}">
                <a16:creationId xmlns:a16="http://schemas.microsoft.com/office/drawing/2014/main" id="{E3EDF37D-9BC0-B8DF-2142-2C823682F51D}"/>
              </a:ext>
            </a:extLst>
          </p:cNvPr>
          <p:cNvGrpSpPr/>
          <p:nvPr/>
        </p:nvGrpSpPr>
        <p:grpSpPr>
          <a:xfrm>
            <a:off x="132521" y="15758"/>
            <a:ext cx="11926957" cy="6826484"/>
            <a:chOff x="132521" y="15758"/>
            <a:chExt cx="11926957" cy="6826484"/>
          </a:xfrm>
        </p:grpSpPr>
        <p:sp>
          <p:nvSpPr>
            <p:cNvPr id="3" name="文本框 2">
              <a:extLst>
                <a:ext uri="{FF2B5EF4-FFF2-40B4-BE49-F238E27FC236}">
                  <a16:creationId xmlns:a16="http://schemas.microsoft.com/office/drawing/2014/main" id="{9EBFBD62-041A-5374-EE72-A842E6A6E20E}"/>
                </a:ext>
              </a:extLst>
            </p:cNvPr>
            <p:cNvSpPr txBox="1"/>
            <p:nvPr/>
          </p:nvSpPr>
          <p:spPr>
            <a:xfrm>
              <a:off x="132521" y="15758"/>
              <a:ext cx="11926957" cy="6826484"/>
            </a:xfrm>
            <a:prstGeom prst="rect">
              <a:avLst/>
            </a:prstGeom>
            <a:noFill/>
          </p:spPr>
          <p:txBody>
            <a:bodyPr wrap="square">
              <a:spAutoFit/>
            </a:bodyPr>
            <a:lstStyle/>
            <a:p>
              <a:pPr>
                <a:lnSpc>
                  <a:spcPts val="7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         *        40         *        60         *        80         *       100         *       120         *       140         *       160         *       180         *       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AATGTGGATGCTTCACCTGCTAAGAGTTGTCCCACATCGGTGAGGGATAATGTTTACTATGTGCTTATATAATCTTGGGCTACTTCTCATATTGCTAATTGGTTTTATGTTGGAACCCCAATTTCATCATGGTATCAGACAGGATTGTCCTCGTGTGAAGCCAAACGGCCACACGCGCTCCACGTCACCTAGTT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AAATGTGGATGCTTCACCTGCTAAGAGTTGTCCCACATCGGTGAGGGATAATGTTTACTATGTGCTTATATAATCTTGGGCTACTTCTCATATTGCTAATTGGTTTTATGTTGGAACCCCAATTTCATCATGGTATCAGACAGGATTGTCCTCGTGTGAAGCCAAACGGCCACACGCGCTCCACGTCACCTAGTT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         *       240         *       260         *       280         *       300         *       320         *       340         *       360         *       380         *       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CACGTGTAGGCTTGAAAATCCACCACACGTGCAGGGGCATGTTGAGAGTCGTCACCTAGTTGTTGTCCACGTGTAGGCTTAAAAATCCACCACACGTGCAGGGGCATGTTGAGAGTTGTCCCACATCGGTGAGGGACAATGTTTGCTATGTGCTTATATGATCTTGGGCTAATTCTCATATTGCCAATTGGTT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CCACGTGTAGGCTTGAAAATCCACCACACGTGCAGGGGCATGTTGAGAGTCGTCACCTAGTTGTTGTCCACGTGTAGGCTTAAAAATCCACCACACGTGCAGGGGCATGTTGAGAGTTGTCCCACATCGGTGAGGGACAATGTTTGCTATGTGCTTATATGATCTTGGGCTAATTCTCATATTGCCAATTGGTT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         *       440         *       460         *       480         *       500         *       520         *       540         *       560         *       580         *       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GGAACTCCAATTTCATCATCACCTTTATTTTATTAAATTAATGTTTCATTTGGCTATATCTTATTCTTTACGTGACCCTTAAGCCAATTCAAAGCTCTAGAAATAAAGCACAAGATTTACACTTTTTATAATCGAAAATGTATTTTCTCATCATTTCGTGGTGTGTTCAAAATTCAAATAAACACGCAAGGTGTA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GAGGAACTCCAATTTCATCATCACCTTTATTTTATTAAATTAATGTTTCATTTGGCTATATCTTATTCTTTACGTGACCCTTAAGCCAATTCAAAGCTCTAGAAATAAAGCACAAGATTTACACTTTTTATAATCGAAAATGTATTTTCTCATCATTTCGTGGTGTGTTCAAAATTCAAATAAACACGCAAGGTGTAA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20         *       640         *       660         *       680         *       700         *       720         *       740         *       760         *       780         *       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GCATTTGAAAAGTGGATAACGTACGTTTGCATGGTGACATGCATGAGCCGTCCCTTTGAGATAGCAAAGGGTTATACCATGCCATGATCTAGAAAGAAAACATACACGATAGAAATATATTTGAATTCAAAAAAACTATTTGGACCATTCCGAGCAAGTCTATCTAAATAGCAATAGCATCACTCTATA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CATATGCATTTGAAAAGTGGATAACGTACGTTTGCATGGTGACATGCATGAGCCGTCCCTTTGAGATAGCAAAGGGTTATACCATGCCATGATCTAGAAAGAAAACATACACGATAGAAATATATTTGAATTCAAAAAAACTATTTGGACCATTCCGAGCAAGTCTATCTAAATAGCAATAGCATCACTCTATAT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20         *       840         *       860         *       880         *       900         *       920         *       940         *       960         *       980         *      1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CAGTTCTTATTAAGA</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GGCCCGGCCCAGGCGCAGTGCAACAGGGGCAATTGTCCAGGGCCCAAAGTTGAATGGGGCACCCAAAAAACAAAATCCAAATAATTAGGTATAAAAAAAAATTTGTCCAAAGCCCAAAATAAAGGCTGTAGGCGATAACTTGTCCAGGTTTTGGGGATTAAAAATCAAT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CAGTTCTTATTAAGA</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GGCCCGGCCCAGGCGCAGTGCAACAGGGGCAATTGTCCAGGGCCCAAAGTTGAATGGGGCACCCAAAAAACAAAATCCAAATAATTAGGTATAAAAAAAAATTTGTCCAAAGCCCAAAATAAAGGCTGTAGGCGATAACTTGTCCAGGTTTTGGGGATTAAAAATCAATA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20         *      1040         *      1060         *      1080         *      1100         *      1120         *      1140         *      1160         *      1180         *      1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TAAAGGGTATCTGAAGGGGACAAGTCGTCCAGGTTTTGGGCATGGAGGAGAGGCATAAGATTCAAGTTTTTCAAAGGGAGCTCCCTCTCTGCTTGGAGCTTGTCACCCAACTGCCCAAGCCCAAGGTACTACGGAGAACACAAACCCTTCTCAAATTTCAGCTTAATTTTTGTGTTCTAAGTCGGAAGCTTCG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TAAAGGGTATCTGAAGGGGACAAGTCGTCCAGGTTTTGGGCATGGAGGAGAGGCATAAGATTCAAGTTTTTCAAAGGGAGCTCCCTCTCTGCTTGGAGCTTGTCACCCAACTGCCCAAGCCCAAGGTACTACGGAGAACACAAACCCTTCTCAAATTTCAGCTTAATTTTTGTGTTCTAAGTCGGAAGCTTCGTTTC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20         *      1240         *      1260         *      1280         *      1300         *      1320         *      1340         *      1360         *      1380         *      1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TTTGCTTGAATTGTTCTGGTTTCTGTTTTCAAAATTGGGGTTTTTTTTGTAGCTATTGAGAGGTGCAAGCAGCAGATTTCAGATGCAACCGCAAATTACCTGCATGGACAATCTAAGTGTTCTGAGCAGACTTCAAGTGAGGGGCATGTTTTTGAGGAATTCATTCCATTAACACGGATTTCATACAACTCCAGATG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TTTGCTTGAATTGTTCTGGTTTCTGTTTTCAAAATTGGGGTTTTTTTTGTAGCTATTGAGAGGTGCAAGCAGCAGATTTCAGATGCAACCGCAAATTACCTGCATGGACAATCTAAGTGTTCTGAGCAGACTTCAAGTGAGGGGCATGTTTTTGAGGAATTCATTCCATTAACACGGATTTCATACAACTCCAGATG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20         *      1440         *      1460         *      1480         *      1500         *      1520         *      1540         *      1560         *      1580         *      1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CTCGAAGAGGTATAAAAAAAAGACTCCACCTTCATCAATTTTAGTAAATTTTGTGACTGCCCTTTTGTTTGGTTGCTTATAAAATTTGAGGTGAAGAAGTGGAAAGTATTGATTTTTAGGTGTAGGGTAATGGCAGGAGGAGCAAGTTAAAGGCTATAGTGATGGAGATGAAGAGAAATGGGGTGCTTTTCAGCC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ACTCGAAGAGGTATAAAAAAAAGACTCCACCTTCATCAATTTTAGTAAATTTTGTGACTGCCCTTTTGTTTGGTTGCTTATAAAATTTGAGGTGAAGAAGTGGAAAGTATTGATTTTTAGGTGTAGGGTAATGGCAGGAGGAGCAAGTTAAAGGCTATAGTGATGGAGATGAAGAGAAATGGGGTGCTTTTCAGCC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20         *      1640         *      1660         *      1680         *      1700         *      1720         *      1740         *      1760         *      1780         *      1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CAAGGGAAAAAAAAAGCATTGGAAAGACAAATGGACCGGTGGCTAAAGAACCTTCTTCGGCTCCGGCTACTAGTTCCACCACGGACACCGTGAGTGGAGACAGTGGTGGGAACAACAAGAACAAAGAGAAAGATGGACAGGGAA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CCAAGGGAAAAAAAAAGCATTGGAAAGACAAATGGACCGGTGGCTAAAGAACCTTCTTCGGCTCCGGCTACTAGTTCCACCACGGACACCGTGAGTGGAGACAGTGGTGGGAACAACAAGAACAAAGAGAAAGATGGACAGGGAAACGAAGGCGAAACTGGTCACCGGAGTTGCACCGCCGGTTCTTGCATGCTCTTCT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20         *      1840         *      1860         *      1880         *      1900         *      1920         *      1940         *      1960         *      1980         *      2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TTCAACAACTTGGTGGTTCACTTGGTATGCAGTTGAGATTAATTTAGTGGGATATGTTATTTTATATGATTGGATGAATATGTGATTGGATTGTGATGTATTGGATGTGTTTAATGCGTTCTGCGTATATGTGATTTTCCATCTGTTTTTAATCATAATTTGGTTGATGTGAAAATTTTTGCACATACATG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TTCAACAACTTGGTGGTTCACTTGGTATGCAGTTGAGATTAATTTAGTGGGATATGTTATTTTATATGATTGGATGAATATGTGATTGGATTGTGATGTATTGGATGTGTTTAATGCGTTCTGCGTATATGTGATTTTCCATCTGTTTTTAATCATAATTTGGTTGATGTGAAAATTTTTGCACATACATGATAGA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20         *      2040         *      2060         *      2080         *      2100         *      2120         *      2140         *      2160         *      2180         *      2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0000"/>
                  </a:solidFill>
                  <a:effectLst/>
                  <a:highlight>
                    <a:srgbClr val="FFFFFF"/>
                  </a:highlight>
                  <a:latin typeface="Courier"/>
                  <a:ea typeface="等线" panose="02010600030101010101" pitchFamily="2" charset="-122"/>
                  <a:cs typeface="Times New Roman" panose="02020603050405020304" pitchFamily="18" charset="0"/>
                </a:rPr>
                <a:t>GGAAGGCATTTTGCATGCTACTAGTGATGATTTTTTTACACATACATGTGATTAACCTCGCAAAATATTTATTTTAAACATATGTTTCTGTACTAAAAAGGGCACATTTTGAACTTTCGCACTGGGCACCAAAAAACTCAGGACCGGCCCTG</a:t>
              </a:r>
              <a:r>
                <a:rPr kumimoji="0" lang="en-US" altLang="zh-CN" sz="700" b="1" i="0" u="none" strike="noStrike" kern="0" cap="none" spc="0" normalizeH="0" baseline="0" noProof="0" dirty="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a:t>
              </a:r>
              <a:r>
                <a:rPr lang="en-US" altLang="zh-CN" sz="700" kern="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r>
                <a:rPr lang="en-US" altLang="zh-CN" sz="700" kern="0">
                  <a:solidFill>
                    <a:srgbClr val="FF0000"/>
                  </a:solidFill>
                  <a:effectLst/>
                  <a:highlight>
                    <a:srgbClr val="FFFFFF"/>
                  </a:highlight>
                  <a:latin typeface="Courier"/>
                  <a:ea typeface="等线" panose="02010600030101010101" pitchFamily="2" charset="-122"/>
                  <a:cs typeface="Times New Roman" panose="02020603050405020304" pitchFamily="18" charset="0"/>
                </a:rPr>
                <a:t>GGAAGGCATTTTGCATGCTACTAGTGATGATTTTTTTACACATACATGTGATTAACCTCGCAAAATATTTATTTTAAACATATGTTTCTGTACTAAAAAGGGCACATTTTGAACTTTCGCACTGGGCACCAAAAAACTCAGGACCGGCCCTG</a:t>
              </a:r>
              <a:r>
                <a:rPr kumimoji="0" lang="en-US" altLang="zh-CN" sz="700" b="1" i="0" u="none" strike="noStrike" kern="0" cap="none" spc="0" normalizeH="0" baseline="0" noProof="0">
                  <a:ln>
                    <a:noFill/>
                  </a:ln>
                  <a:solidFill>
                    <a:srgbClr val="FF0000"/>
                  </a:solidFill>
                  <a:effectLst/>
                  <a:highlight>
                    <a:srgbClr val="00FFFF"/>
                  </a:highlight>
                  <a:uLnTx/>
                  <a:uFillTx/>
                  <a:latin typeface="Courier"/>
                  <a:ea typeface="等线" panose="02010600030101010101" pitchFamily="2" charset="-122"/>
                  <a:cs typeface="Times New Roman" panose="02020603050405020304" pitchFamily="18" charset="0"/>
                </a:rPr>
                <a:t>GTGTGTAT</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TATTGTACTTGTATCCAAAACAACAATCCTGGCTA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20         *      2240         *      2260         *      2280         *      2300         *      2320         *      2340         *      2360         *      2380         *      2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CATATTCAATATAAAGTTCCAATACGATCACTGATTGATTAATTGGTATCAAGTACAATACTTCTGCATCTCTCTTAAAAAACATCAACAATGCATTACGTGTTGTAGATTGTTATCAGAGTCGGCCCTGGTCCAGTGTCACCAGGGCGACCGCTCGAGGTCCAAAAAAACGAGG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CATATTCAATATAAAGTTCCAATACGATCACTGATTGATTAATTGGTATCAAGTACAATACTTCTGCATCTCTCTTAAAAAACATCAACAATGCATTACGTGTTGTAGATTGTTATCAGAGTCGGCCCTGGTCCAGTGTCACCAGGGCGACCGCTCGAGGTCCAAAAAAACGAGGGGCACCAAAAAAAAATTAAG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20         *      2440         *      2460         *      2480         *      2500         *      2520         *      2540         *      2560         *      2580         *      2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TCATATATGTATAAGGTTTTGTTTTATTCTTGATATATAGTAAACGCTCATATTAAATAGCAATATGTTTTAGATGACAGGGTGGTTTTATTTGGTTTTTCCGTGCCCACCTAGGTTTAATTCCCTCTCTCAACATAAAGGGGTAGTTTCCCTTCTATTTTATTCATGTCTACTTTAAATAACAAACAAACAT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TTCATATATGTATAAGGTTTTGTTTTATTCTTGATATATAGTAAACGCTCATATTAAATAGCAATATGTTTTAGATGACAGGGTGGTTTTATTTGGTTTTTCCGTGCCCACCTAGGTTTAATTCCCTCTCTCAACATAAAGGGGTAGTTTCCCTTCTATTTTATTCATGTCTACTTTAAATAACAAACAAACATTA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20         *      2640         *      2660         *      2680         *      2700         *      2720         *      2740         *      2760         *      2780         *      2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TATTAAATGTGGCATTTTCAGTAGTCGTTTTTTGTTTTCAGTTTGAATTAACTCGCAAAATCATGTTCAAGTTTGTCTAAATATAAATTTAGGTTTTTTATATTTGTTGATAATCTTTTCATGGTTAAGTAATAAACTTGTGATCATTATCTTTTTATTGAACGAAGTATTGTTATTGACAATCCAAAAA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GCTTATTAAATGTGGCATTTTCAGTAGTCGTTTTTTGTTTTCAGTTTGAATTAACTCGCAAAATCATGTTCAAGTTTGTCTAAATATAAATTTAGGTTTTTTATATTTGTTGATAATCTTTTCATGGTTAAGTAATAAACTTGTGATCATTATCTTTTTATTGAACGAAGTATTGTTATTGACAATCCAAAAATA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820         *      2840         *      2860         *      2880         *      2900         *      2920         *      2940         *      2960         *      2980         *      3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CTACACTTCTTTGTATAATTTTTCCCTTATGATTTTATATATTTGGAATGAACCGCAACTTTTCATGAGCGCTCGAAAAACAAAAACATAGTTGAATTACTATGTGCCCTTTGGTAGTAGCAATTTGTTGTTTTCATTTGTTGCTTACATATAGAAATTAGAGATCTTAAATATGAAAAATTCATTTCAAAAG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CCTACACTTCTTTGTATAATTTTTCCCTTATGATTTTATATATTTGGAATGAACCGCAACTTTTCATGAGCGCTCGAAAAACAAAAACATAGTTGAATTACTATGTGCCCTTTGGTAGTAGCAATTTGTTGTTTTCATTTGTTGCTTACATATAGAAATTAGAGATCTTAAATATGAAAAATTCATTTCAAAAGT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020         *      3040         *      3060         *      3080         *      3100         *      3120         *      3140         *      3160         *      3180         *      3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TGTGCAAGTAGCTTGTAGATCAGTTAGTTAAAAGTGTTCAGCTTGTCACTCAATGACTCGTTTTCAAATTTCCTCACCGTATTTCTAATGAGTTTAGTGTAAATTACCCTATCATTTGTCAAAAAAGTCATAATGTGAAAAAGGTCTATTTTCTTTAATATTCAATGTACAACATACGAATACTAAGATAAAT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TGTGCAAGTAGCTTGTAGATCAGTTAGTTAAAAGTGTTCAGCTTGTCACTCAATGACTCGTTTTCAAATTTCCTCACCGTATTTCTAATGAGTTTAGTGTAAATTACCCTATCATTTGTCAAAAAAGTCATAATGTGAAAAAGGTCTATTTTCTTTAATATTCAATGTACAACATACGAATACTAAGATAAAT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220         *      3240         *      3260         *      3280         *      3300         *      3320         *      3340         *      3360         *      3380         *      3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ATGTGAAGTTATGTTAGGGCATATTTTTCAATGTCGTCTAGGGCCTCATAAAACTCAGGATAGGCCTTGATTGTTATATATGGTACTAAACAAAAGTTTCCCAAATACAAAGTTTAAAAAGATTCAAGTGGAATTTTGAAGAATTTTATAAGTATTATAAATTTTGATAAACCCTCGAGTTGATTAATTGCGG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TTTATGTGAAGTTATGTTAGGGCATATTTTTCAATGTCGTCTAGGGCCTCATAAAACTCAGGATAGGCCTTGATTGTTATATATGGTACTAAACAAAAGTTTCCCAAATACAAAGTTTAAAAAGATTCAAGTGGAATTTTGAAGAATTTTATAAGTATTATAAATTTTGATAAACCCTCGAGTTGATTAATTGCGG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420         *      3440         *      3460         *      3480         *      3500         *      3520         *      3540         *      3560         *      3580         *      3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GGTCATCATGACCGCTGTGGTAGTTCATGGAGCAACCTACTTGTTCCCCCACTTATGATTGACGCATTTTTACTGTATGAACATCATAATGCAAAAACTCATTAAATTGAGAGATTTTTTTAGCCTTTCATATGTATCATACAAATAGATGGTTCATCATAAGGATGCTACTTGTTACCAAAAACATTGATTG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ATGTGGTCATCATGACCGCTGTGGTAGTTCATGGAGCAACCTACTTGTTCCCCCACTTATGATTGACGCATTTTTACTGTATGAACATCATAATGCAAAAACTCATTAAATTGAGAGATTTTTTTAGCCTTTCATATGTATCATACAAATAGATGGTTCATCATAAGGATGCTACTTGTTACCAAAAACATTGATTG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620         *      3640         *      3660         *      3680         *      3700         *      3720         *      3740         *      3760         *      3780         *      3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CATATATGGATGGGTAAACAATCTCCAAATGGAATATTTTTTTTAGATATGATATTTCGATGATGATAAAGAGAATGAACGGGTCAAATAATAATGTTCATATGGTGAAGATGCGTAAATCATAAGTGAAGGGACAAGTTGGTTCCCTATGGAGGACACAAGCATTATTCGTTTTTAGGTGTATTCAATTA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CATATATGGATGGGTAAACAATCTCCAAATGGAATATTTTTTTTAGATATGATATTTCGATGATGATAAAGAGAATGAACGGGTCAAATAATAATGTTCATATGGTGAAGATGCGTAAATCATAAGTGAAGGGACAAGTTGGTTCCCTATGGAGGACACAAGCATTATTCGTTTTTAGGTGTATTCAATTAGAA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3820         *      3840         *      3860         *      3880         *      3900         *      3920         *      3940         *      3960         *      3980         *      4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AATGAATCTATAAAAGTTCAGGAATATTCAGTCAGAATGTTAAACAAGCTTATAGAACTCCATACAAATTCAGGTGTATTAATCAATTAAAATTTTAAAGGATTTTATAAAAGTCAACAGAAATCTGAGTGTATTCAAAGAAGATTTTGAAAAAGTCTAAGAAAGTTAGAGTGTATTAATCAGTAATAATTTGA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AATGAATCTATAAAAGTTCAGGAATATTCAGTCAGAATGTTAAACAAGCTTATAGAACTCCATACAAATTCAGGTGTATTAATCAATTAAAATTTTAAAGGATTTTATAAAAGTCAACAGAAATCTGAGTGTATTCAAAGAAGATTTTGAAAAAGTCTAAGAAAGTTAGAGTGTATTAATCAGTAATAATTTGA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20         *      4040         *      4060         *      4080         *      4100         *      4120         *      4140         *      4160         *      4180         *      4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GAATTTTAAAATGATACATTTTAGTAAATTTGAAGGAATTTCATAGAGTATTTAACCCTTAATAAATCATACTTCTGTAAAGTCCATTAAAAAAACTCCATCAACTTTCATAAATTGAAACATTTTTAAATCCATAAAAGTTGAACCGAATCTATTTTCATATATTATTTTATACATGCAACGACTTACGTTG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AAGAATTTTAAAATGATACATTTTAGTAAATTTGAAGGAATTTCATAGAGTATTTAACCCTTAATAAATCATACTTCTGTAAAGTCCATTAAAAAAACTCCATCAACTTTCATAAATTGAAACATTTTTAAATCCATAAAAGTTGAACCGAATCTATTTTCATATATTATTTTATACATGCAACGACTTACGTTGT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20         *      4240         *      4260         *      4280         *      4300         *      4320         *      4340         *      4360         *      4380         *      4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AAGGGATGCAATGCATGGCGCAGAAAGTCATAGAGTCGGCCAAGAGATCATTTCGTCTGAATCTCTCATGTCCGAGAACCCATACCTCAAGAGCCCAAGACGACACAATACACAACAATCGCCGTCAATACCCTTCTCTTCCGCTGCCTATAAATACCAATGGAAATCCCACGACATTCTCACCAAATCATCA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ATAAGGGATGCAATGCATGGCGCAGAAAGTCATAGAGTCGGCCAAGAGATCATTTCGTCTGAATCTCTCATGTCCGAGAACCCATACCTCAAGAGCCCAAGACGACACAATACACAACAATCGCCGTCAATACCCTTCTCTTCCGCTGCCTATAAATACCAATGGAAATCCCACGACATTCTCACCAAATCATCATC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420         *      4440         *      4460         *      4480         *      4500         *      4520         *      4540         *      4560         *      4580         *      4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CACACCAATCCATACACTTCTAGCTACAATTCTAAGTTTCCATTTTCCAACATCCCAACACATTGTTCAAAAATATCATCAGCCTCGAGTTAGGGTTTATTATCCTTCGTGACCCTCCTTTTAGTATTTGGTTCTTTTTGAAAGACGATTTGTTAGGTGTTTCTAGGCCTCTAGCCATCTTGTATCTCACC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GAACACACCAATCCATACACTTCTAGCTACAATTCTAAGTTTCCATTTTCCAACATCCCAACACATTGTTCAAAAATATCATCAGCCTCGAGTTAGGGTTTATTATCCTTCGTGACCCTCCTTTTAGTATTTGGTTCTTTTTGAAAGACGATTTGTTAGGTGTTTCTAGGCCTCTAGCCATCTTGTATCTCACC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20         *      4640         *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ATATTACCAGCTGTTTACACCAAATTAAATAGTAAAAAGAAAGCATC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AAAATATATTACCAGCTGTTTACACCAAATTAAATAGTAAAAAGAAAGCATCAAT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657</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endParaRPr lang="zh-CN" altLang="en-US" sz="700" dirty="0"/>
            </a:p>
          </p:txBody>
        </p:sp>
        <p:sp>
          <p:nvSpPr>
            <p:cNvPr id="5" name="矩形 4">
              <a:extLst>
                <a:ext uri="{FF2B5EF4-FFF2-40B4-BE49-F238E27FC236}">
                  <a16:creationId xmlns:a16="http://schemas.microsoft.com/office/drawing/2014/main" id="{58E1B0E4-464D-CAB9-FA99-77E13F63F287}"/>
                </a:ext>
              </a:extLst>
            </p:cNvPr>
            <p:cNvSpPr/>
            <p:nvPr/>
          </p:nvSpPr>
          <p:spPr>
            <a:xfrm>
              <a:off x="3659433" y="6332717"/>
              <a:ext cx="189506" cy="280728"/>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Tree>
    <p:extLst>
      <p:ext uri="{BB962C8B-B14F-4D97-AF65-F5344CB8AC3E}">
        <p14:creationId xmlns:p14="http://schemas.microsoft.com/office/powerpoint/2010/main" val="194875769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组合 5">
            <a:extLst>
              <a:ext uri="{FF2B5EF4-FFF2-40B4-BE49-F238E27FC236}">
                <a16:creationId xmlns:a16="http://schemas.microsoft.com/office/drawing/2014/main" id="{A79D1A23-05A4-FC12-0D27-CDB16B4D5116}"/>
              </a:ext>
            </a:extLst>
          </p:cNvPr>
          <p:cNvGrpSpPr/>
          <p:nvPr/>
        </p:nvGrpSpPr>
        <p:grpSpPr>
          <a:xfrm>
            <a:off x="71562" y="-43830"/>
            <a:ext cx="12120439" cy="5855064"/>
            <a:chOff x="71562" y="79114"/>
            <a:chExt cx="12120439" cy="5855064"/>
          </a:xfrm>
        </p:grpSpPr>
        <p:sp>
          <p:nvSpPr>
            <p:cNvPr id="2" name="文本框 1">
              <a:extLst>
                <a:ext uri="{FF2B5EF4-FFF2-40B4-BE49-F238E27FC236}">
                  <a16:creationId xmlns:a16="http://schemas.microsoft.com/office/drawing/2014/main" id="{04C0C88B-C4D4-E79E-0AFA-BAF4A0CD3E47}"/>
                </a:ext>
              </a:extLst>
            </p:cNvPr>
            <p:cNvSpPr txBox="1"/>
            <p:nvPr/>
          </p:nvSpPr>
          <p:spPr>
            <a:xfrm>
              <a:off x="198785" y="79114"/>
              <a:ext cx="11993216" cy="5855064"/>
            </a:xfrm>
            <a:prstGeom prst="rect">
              <a:avLst/>
            </a:prstGeom>
            <a:noFill/>
          </p:spPr>
          <p:txBody>
            <a:bodyPr wrap="square">
              <a:spAutoFit/>
            </a:bodyPr>
            <a:lstStyle/>
            <a:p>
              <a:pPr>
                <a:lnSpc>
                  <a:spcPts val="1000"/>
                </a:lnSpc>
              </a:pP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         *        40         *        60         *        80         *       100         *       120         *       140         *       160         *       180         *       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CACTTCTAGCTACAATTCTAAGTTTCCATTTTCCAACATCCCAACACATTGTTCAAAAATATCATCAGCCTCGAGTTAGGGTTTATTATCCTTCGTGACCCTCCTTTTAGTATTTGGTTCTTTTTGAAAGACGATTTGTTAGGTGTTTCTAGGCCTCTAGCCATCTTGTATCTCACCAAAAAAAAATATATT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CACTTCTAGCTACAATTCTAAGTTTCCATTTTCCAACATCCCAACACATTGTTCAAAAATATCATCAGCCTCGAGTTAGGGTTTATTATCCTTCGTGACCCTCCTTTTAGTATTTGGTTCTTTTTGAAAGACGATTTGTTAGGTGTTTCTAGGCCTCTAGCCATCTTGTATCTCACCAAAAAAAAATATATT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         *       240         *       260         *       280         *       300         *       320         *       340         *       360         *       380         *       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GCTGTTTACACCAAATTAAATAGTAAAAAGAAAGCATCAATGGCTTTAAAAACACAGTTGTTGTGGTCATTTGTTGTTGTTTTTGTTGTTTCCTTCAGTACAACTTCATGTTCTGGTAGTAGTTTCCAGGAGGTCAACGCGCTTCATAGTTACGTTGACCATGTTGATGATAAAGAGTCCGGCTATAATTCTAGGGC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420         *       440         *       460         *       480         *       500         *       520         *       540         *       560         *       580         *       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CTTCATACACGGACACCATAGAAGGTTTAAAGTTCATGGAATTGATCAGGCCAAGAACTCAGCTCTTCAGTTCAAGGAAGCTCAACACAATCACCGGTGGGATAGCAACATCATCAGCTCCGGCCAAAACCATTAGCGTCGACGATTTTGGAGCTAAAGGGAATGGTGCTGATGACACACAGGTAAACAACAGA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TCCTTCATACACGGACACCATAGAAGGTTTAAAGTTCATGGAATTGATCAGGCCAAGAACTCAGCTCTTCAGTTCAAGGAAGCTCAACACAATCACCGGTGGGATAGCAACATCATCAGCTCCGGCCAAAACCATTAGCGTCGACGATTTTGGAGCTAAAGGGAATGGTGCTGATGACACACAGGTAAACAACAGATG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620         *       640         *       660         *       680         *       700         *       720         *       740         *       760         *       780         *       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TCATAGGCTTAATAATATTAGTATATTAGAATATTCATATGGTGATGCTAACTATAACAACATTTCTGGTCACATTTCTGTTTTATGAAAGATGTGTCCACAATGTTTGGTACAAATTAATAGTACTATTATTATTTGGACCGAACTCATTATTATTTATTGAGTAAATGTGATACAAATAACATTACTTAAG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GGACTCATAGGCTTAATAATATTAGTATATTAGAATATTCATATGGTGATGCTAACTATAACAACATTTCTGGTCACATTTCTGTTTTATGAAAGATGTGTCCACAATGTTTGGTACAAATTAATAGTACTATTATTATTTGGACCGAACTCATTATTATTTATTGAGTAAATGTGATACAAATAACATTACTTAAGC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820         *       840         *       860         *       880         *       900         *       920         *       940         *       960         *       980         *      1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GGAAGAACTATCTTGTTAGGCCGATTGAATTCTCAGGCCCATGCAAATCTCAACT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TAATTTGGTTGAACCAAAAGTTTAAAGTTTATGTATGAATATAATATTGTTTAATTTTTTGTATGTGTTGGTTTAGGCATTTGTGAAGGCATGGAAGGCAGCTTGTTCTTCCAGTGGAGCTATGGTTCTTGTGGTACCACGGAAGAACTATCTTGTTAGGCCGATTGAATTCTCAGGCCCATGCAAATCTCAACT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020         *      1040         *      1060         *      1080         *      1100         *      1120         *      1140         *      1160         *      1180         *      1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GCAGGTAATAATTAATTCGGATCATCTATGTAATTATCTTTAAATGTAATTCCGGACTATTAACTTTGACGATTATATAATAATTAATATTGCTTAATATTTGGAAAAATTCAGATTTATGGAACCATAGAAGCATCAGAAGACCGATCAATCTACAAAGACATAGACCACTGGCTCATCTTTGACAATGTCC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GCAGGTAATAATTAATTCGGATCATCTATGTAATTATCTTTAAATGTAATTCCGGACTATTAACTTTGACGATTATATAATAATTAATATTGCTTAATATTTGGAAAAATTCAGATTTATGGAACCATAGAAGCATCAGAAGACCGATCAATCTACAAAGACATAGACCACTGGCTCATCTTTGACAATGTCCA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220         *      1240         *      1260         *      1280         *      1300         *      1320         *      1340         *      1360         *      1380         *      1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GGTACGTGTACA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TGCTAGTTGTTGGTCCTGGAACCATCAATGGCAATGGAAACATCTGGTGGAAAAACTCATGCAAAATAAAACCTCAGGTACGTTCTAATTAAACAAATAATTAGCTCTCACTAATACTAACCCTGTACTAATTACAATCTCTTTCATTGATTTACAGCCCCCTTGCGGTACATACGCCCCCACGGTACGTGTACATA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420         *      1440         *      1460         *      1480         *      1500         *      1520         *      1540         *      1560         *      1580         *      1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C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TACTCTAATCTGAATATGTATGTGCATTTTAATTAATTAAGCACCATTATTTCTGGAACTAATTAAAATTTGTACATGTAATGTGCAGGCTGTGACCTTCAACAGGTGCAATAACTTGGTGGTGAAGAATCTGAATATCCAAGACGCACAACAAATCCATGTCATATTCCAAAACTGCATCAACGTTCAAGCTTCCCG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620         *      1640         *      1660         *      1680         *      1700         *      1720         *      1740         *      1760         *      1780         *      18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CGCTTTCAAAAGTCATCATTTTGGTCTCTCACGTTTGATAAATACATATGATCGATCAAACACATTAAGATAAAAAAACT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TCACGGTAACTGCACCAGAGGACAGCCCTAATACGGACGGAATTCATGTGACAAATACCCAGAACATCACTATCTCGAGCTCGGTTATAGGAACAGGTGTGACAAATAGTTCATGACGCTTTCAAAAGTCATCATTTTGGTCTCTCACGTTTGATAAATACATATGATCGATCAAACACATTAAGATAAAAAAACTAA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1820         *      1840         *      1860         *      1880         *      1900         *      1920         *      1940         *      1960         *      1980         *      20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CCATATTATGCATAAAATTAACAATCTTATGGTTTCTAATTTGTATTGTGAAGGTGATGACTGTATTTCTATTGTGAGTGGGTCCCAAAGAGTTCAAGCCACAGACATTACTTGTGGACCAGGCCATGGAATCAGGTAATTTCCAACCCTAGTCTCCAAATTGTTCGACAAATCATCCTAAATTCCTCTTGTCAACATA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020         *      2040         *      2060         *      2080         *      2100         *      2120         *      2140         *      2160         *      2180         *      22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TAATGTTTTTTACGTCGAGAAAAGTGCGGGATGACTTTTTATAGTGTCAATAACAGCTGATTAGTAAATATACCAATATATATTAACGGCTGTTTTAATTTTGTGATCAGTATTGGTAGCTTGGGAGAAGACGGCTCAGAAGATCATGTTTCAGGAGTATTTGTGAATGGAGCTAAGCTTTCAGGAACCTCCAA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ATTAATGTTTTTTACGTCGAGAAAAGTGCGGGATGACTTTTTATAGTGTCAATAACAGCTGATTAGTAAATATACCAATATATATTAACGGCTGTTTTAATTTTGTGATCAGTATTGGTAGCTTGGGAGAAGACGGCTCAGAAGATCATGTTTCAGGAGTATTTGTGAATGGAGCTAAGCTTTCAGGAACCTCCAATGG</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220         *      2240         *      2260         *      2280         *      2300         *      2320         *      2340         *      2360         *      2380         *      24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GGATCAAGACGTGGAAGGGAGGCTCAGGCAGTGTAACCAACATTGTTTTCCAGAATGTGCAAATGAACGATGTCACCAACCCCATCATCATCGACCAGAACTACTGTGACCACAAAACCAAAGATTGCAAACAACAGGTAATTAATTAATTTAACTAGTTCTTACGCATTTCGTTAATTAGTCCCCAGACAA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ACTCCGGATCAAGACGTGGAAGGGAGGCTCAGGCAGTGTAACCAACATTGTTTTCCAGAATGTGCAAATGAACGATGTCACCAACCCCATCATCATCGACCAGAACTACTGTGACCACAAAACCAAAGATTGCAAACAACAGGTAATTAATTAATTTAACTAGTTCTTACGCATTTCGTTAATTAGTCCCCAGACAAACC</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420         *      2440         *      2460         *      2480         *      2500         *      2520         *      2540         *      2560         *      2580         *      260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TCACTTCTTGATCGTTTATTTCGTTATGGCAGAAATCGGCGGTTCAAGTGAAAAATGTGTTGTACCAAAACATAAGAGGAACGAGTGCTTCCGGTGACGCGATAACGTTGAACTGCAGCCAAAGTGTTCCTTGTCAGGGGATCGTGCTGCAAAGTGTTCAACTGCAGAATGGAAGAGCTGAATGCAACAATG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TTAATCACTTCTTGATCGTTTATTTCGTTATGGCAGAAATCGGCGGTTCAAGTGAAAAATGTGTTGTACCAAAACATAAGAGGAACGAGTGCTTCCGGTGACGCGATAACGTTGAACTGCAGCCAAAGTGTTCCTTGTCAGGGGATCGTGCTGCAAAGTGTTCAACTGCAGAATGGAAGAGCTGAATGCAACAATGTTCA</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00</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620         *      2640         *      2660         *      2680         *      2700         *      2720         *      2740         *      2760         *      2780          </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1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GAAAAAGATGCAAC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8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allele2 : </a:t>
              </a:r>
              <a:r>
                <a:rPr lang="en-US" altLang="zh-CN" sz="700" kern="0" dirty="0">
                  <a:solidFill>
                    <a:srgbClr val="FFFFFF"/>
                  </a:solidFill>
                  <a:effectLst/>
                  <a:highlight>
                    <a:srgbClr val="000000"/>
                  </a:highlight>
                  <a:latin typeface="Courier"/>
                  <a:ea typeface="等线" panose="02010600030101010101" pitchFamily="2" charset="-122"/>
                  <a:cs typeface="Times New Roman" panose="02020603050405020304" pitchFamily="18" charset="0"/>
                </a:rPr>
                <a:t>GCCTGCTTACAAAGGAGTTGTCTCCCCTAGATGTTAAAACCTAGGGTTCATAATTATGGGCATTGTGAAATAGATTATGCAATTCTTGTACCAATTAGCACATAAATAATTGTTTGTTTGTAATATTTATGTTTAATTTGGCATTGTACATAAACATATTCATAAAGAAAAAGATGCAACTTT</a:t>
              </a: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 2783</a:t>
              </a:r>
              <a:b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br>
              <a:r>
                <a:rPr lang="en-US" altLang="zh-CN" sz="700" kern="0" dirty="0">
                  <a:solidFill>
                    <a:srgbClr val="000000"/>
                  </a:solidFill>
                  <a:effectLst/>
                  <a:highlight>
                    <a:srgbClr val="FFFFFF"/>
                  </a:highlight>
                  <a:latin typeface="Courier"/>
                  <a:ea typeface="等线" panose="02010600030101010101" pitchFamily="2" charset="-122"/>
                  <a:cs typeface="Times New Roman" panose="02020603050405020304" pitchFamily="18" charset="0"/>
                </a:rPr>
                <a:t>                                                                                                                 </a:t>
              </a:r>
              <a:endParaRPr lang="zh-CN" altLang="en-US" sz="700" dirty="0"/>
            </a:p>
          </p:txBody>
        </p:sp>
        <p:sp>
          <p:nvSpPr>
            <p:cNvPr id="3" name="文本框 2">
              <a:extLst>
                <a:ext uri="{FF2B5EF4-FFF2-40B4-BE49-F238E27FC236}">
                  <a16:creationId xmlns:a16="http://schemas.microsoft.com/office/drawing/2014/main" id="{31B9DA1F-EF01-60CB-0FDC-2584247A062F}"/>
                </a:ext>
              </a:extLst>
            </p:cNvPr>
            <p:cNvSpPr txBox="1"/>
            <p:nvPr/>
          </p:nvSpPr>
          <p:spPr>
            <a:xfrm>
              <a:off x="71562" y="79114"/>
              <a:ext cx="529981" cy="307777"/>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H</a:t>
              </a:r>
              <a:endParaRPr kumimoji="0" lang="zh-CN" altLang="en-US" sz="1400" b="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
          <p:nvSpPr>
            <p:cNvPr id="4" name="矩形 3">
              <a:extLst>
                <a:ext uri="{FF2B5EF4-FFF2-40B4-BE49-F238E27FC236}">
                  <a16:creationId xmlns:a16="http://schemas.microsoft.com/office/drawing/2014/main" id="{6FE2646F-3A01-02E7-8378-F38094C91F80}"/>
                </a:ext>
              </a:extLst>
            </p:cNvPr>
            <p:cNvSpPr/>
            <p:nvPr/>
          </p:nvSpPr>
          <p:spPr>
            <a:xfrm flipH="1" flipV="1">
              <a:off x="2651547" y="5315949"/>
              <a:ext cx="178436" cy="31115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sp>
          <p:nvSpPr>
            <p:cNvPr id="5" name="矩形 4">
              <a:extLst>
                <a:ext uri="{FF2B5EF4-FFF2-40B4-BE49-F238E27FC236}">
                  <a16:creationId xmlns:a16="http://schemas.microsoft.com/office/drawing/2014/main" id="{043181A1-AFEA-E052-43A7-0AB3F833C479}"/>
                </a:ext>
              </a:extLst>
            </p:cNvPr>
            <p:cNvSpPr/>
            <p:nvPr/>
          </p:nvSpPr>
          <p:spPr>
            <a:xfrm flipH="1" flipV="1">
              <a:off x="2980373" y="737545"/>
              <a:ext cx="178436" cy="311150"/>
            </a:xfrm>
            <a:prstGeom prst="rect">
              <a:avLst/>
            </a:prstGeom>
            <a:noFill/>
            <a:ln w="1905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zh-CN" altLang="en-US" sz="1800" b="0" i="0" u="none" strike="noStrike" kern="1200" cap="none" spc="0" normalizeH="0" baseline="0" noProof="0">
                <a:ln>
                  <a:noFill/>
                </a:ln>
                <a:solidFill>
                  <a:prstClr val="black"/>
                </a:solidFill>
                <a:effectLst/>
                <a:uLnTx/>
                <a:uFillTx/>
                <a:latin typeface="等线" panose="020F0502020204030204"/>
                <a:ea typeface="等线" panose="02010600030101010101" pitchFamily="2" charset="-122"/>
                <a:cs typeface="+mn-cs"/>
              </a:endParaRPr>
            </a:p>
          </p:txBody>
        </p:sp>
      </p:grpSp>
      <p:sp>
        <p:nvSpPr>
          <p:cNvPr id="7" name="文本框 6">
            <a:extLst>
              <a:ext uri="{FF2B5EF4-FFF2-40B4-BE49-F238E27FC236}">
                <a16:creationId xmlns:a16="http://schemas.microsoft.com/office/drawing/2014/main" id="{2EB7D605-6AC8-FEBC-0AB4-09728084299C}"/>
              </a:ext>
            </a:extLst>
          </p:cNvPr>
          <p:cNvSpPr txBox="1"/>
          <p:nvPr/>
        </p:nvSpPr>
        <p:spPr>
          <a:xfrm>
            <a:off x="78401" y="5503108"/>
            <a:ext cx="11993216" cy="1384995"/>
          </a:xfrm>
          <a:prstGeom prst="rect">
            <a:avLst/>
          </a:prstGeom>
          <a:noFill/>
        </p:spPr>
        <p:txBody>
          <a:bodyPr wrap="square">
            <a:spAutoFit/>
          </a:bodyPr>
          <a:lstStyle/>
          <a:p>
            <a:pPr marL="0" marR="0" lvl="0" indent="0" algn="just" defTabSz="914400" rtl="0" eaLnBrk="1" fontAlgn="auto" latinLnBrk="0" hangingPunct="1">
              <a:lnSpc>
                <a:spcPct val="100000"/>
              </a:lnSpc>
              <a:spcBef>
                <a:spcPts val="0"/>
              </a:spcBef>
              <a:spcAft>
                <a:spcPts val="0"/>
              </a:spcAft>
              <a:buClrTx/>
              <a:buSzTx/>
              <a:buFontTx/>
              <a:buNone/>
              <a:tabLst/>
              <a:defRPr/>
            </a:pPr>
            <a:r>
              <a:rPr kumimoji="0" lang="en-US" altLang="zh-CN" sz="1400" b="1" i="0" u="none" strike="noStrike" kern="1200" cap="none" spc="0" normalizeH="0" baseline="0" noProof="0" dirty="0">
                <a:ln>
                  <a:noFill/>
                </a:ln>
                <a:solidFill>
                  <a:prstClr val="black"/>
                </a:solidFill>
                <a:effectLst/>
                <a:uLnTx/>
                <a:uFillTx/>
                <a:latin typeface="Times New Roman" panose="02020603050405020304" pitchFamily="18" charset="0"/>
                <a:ea typeface="等线" panose="02010600030101010101" pitchFamily="2" charset="-122"/>
                <a:cs typeface="+mn-cs"/>
              </a:rPr>
              <a:t>Supplemental Figure S1. </a:t>
            </a:r>
            <a:r>
              <a:rPr lang="en-US" altLang="zh-CN" sz="1400" b="1" dirty="0">
                <a:effectLst/>
                <a:latin typeface="Times New Roman" panose="02020603050405020304" pitchFamily="18" charset="0"/>
                <a:ea typeface="等线" panose="02010600030101010101" pitchFamily="2" charset="-122"/>
              </a:rPr>
              <a:t>Sequence alignments of </a:t>
            </a:r>
            <a:r>
              <a:rPr lang="en-US" altLang="zh-CN" sz="1400" b="1" i="1" dirty="0">
                <a:effectLst/>
                <a:latin typeface="Times New Roman" panose="02020603050405020304" pitchFamily="18" charset="0"/>
                <a:ea typeface="等线" panose="02010600030101010101" pitchFamily="2" charset="-122"/>
              </a:rPr>
              <a:t>MdPG1</a:t>
            </a:r>
            <a:r>
              <a:rPr lang="en-US" altLang="zh-CN" sz="1400" b="1" dirty="0">
                <a:effectLst/>
                <a:latin typeface="Times New Roman" panose="02020603050405020304" pitchFamily="18" charset="0"/>
                <a:ea typeface="等线" panose="02010600030101010101" pitchFamily="2" charset="-122"/>
              </a:rPr>
              <a:t> alleles of ‘</a:t>
            </a:r>
            <a:r>
              <a:rPr lang="en-US" altLang="zh-CN" sz="1400" b="1" dirty="0" err="1">
                <a:effectLst/>
                <a:latin typeface="Times New Roman" panose="02020603050405020304" pitchFamily="18" charset="0"/>
                <a:ea typeface="等线" panose="02010600030101010101" pitchFamily="2" charset="-122"/>
              </a:rPr>
              <a:t>Meiba</a:t>
            </a:r>
            <a:r>
              <a:rPr lang="en-US" altLang="zh-CN" sz="1400" b="1" dirty="0">
                <a:effectLst/>
                <a:latin typeface="Times New Roman" panose="02020603050405020304" pitchFamily="18" charset="0"/>
                <a:ea typeface="等线" panose="02010600030101010101" pitchFamily="2" charset="-122"/>
              </a:rPr>
              <a:t>’, ‘</a:t>
            </a:r>
            <a:r>
              <a:rPr lang="en-US" altLang="zh-CN" sz="1400" b="1" dirty="0" err="1">
                <a:effectLst/>
                <a:latin typeface="Times New Roman" panose="02020603050405020304" pitchFamily="18" charset="0"/>
                <a:ea typeface="等线" panose="02010600030101010101" pitchFamily="2" charset="-122"/>
              </a:rPr>
              <a:t>Huahong</a:t>
            </a:r>
            <a:r>
              <a:rPr lang="en-US" altLang="zh-CN" sz="1400" b="1" dirty="0">
                <a:effectLst/>
                <a:latin typeface="Times New Roman" panose="02020603050405020304" pitchFamily="18" charset="0"/>
                <a:ea typeface="等线" panose="02010600030101010101" pitchFamily="2" charset="-122"/>
              </a:rPr>
              <a:t>’, ‘</a:t>
            </a:r>
            <a:r>
              <a:rPr lang="en-US" altLang="zh-CN" sz="1400" b="1" dirty="0" err="1">
                <a:effectLst/>
                <a:latin typeface="Times New Roman" panose="02020603050405020304" pitchFamily="18" charset="0"/>
                <a:ea typeface="等线" panose="02010600030101010101" pitchFamily="2" charset="-122"/>
              </a:rPr>
              <a:t>Huaxing</a:t>
            </a:r>
            <a:r>
              <a:rPr lang="en-US" altLang="zh-CN" sz="1400" b="1" dirty="0">
                <a:effectLst/>
                <a:latin typeface="Times New Roman" panose="02020603050405020304" pitchFamily="18" charset="0"/>
                <a:ea typeface="等线" panose="02010600030101010101" pitchFamily="2" charset="-122"/>
              </a:rPr>
              <a:t>’ and ‘</a:t>
            </a:r>
            <a:r>
              <a:rPr lang="en-US" altLang="zh-CN" sz="1400" b="1" dirty="0" err="1">
                <a:effectLst/>
                <a:latin typeface="Times New Roman" panose="02020603050405020304" pitchFamily="18" charset="0"/>
                <a:ea typeface="等线" panose="02010600030101010101" pitchFamily="2" charset="-122"/>
              </a:rPr>
              <a:t>Huashuo</a:t>
            </a:r>
            <a:r>
              <a:rPr lang="en-US" altLang="zh-CN" sz="1400" b="1" dirty="0">
                <a:effectLst/>
                <a:latin typeface="Times New Roman" panose="02020603050405020304" pitchFamily="18" charset="0"/>
                <a:ea typeface="等线" panose="02010600030101010101" pitchFamily="2" charset="-122"/>
              </a:rPr>
              <a:t>’. </a:t>
            </a:r>
            <a:r>
              <a:rPr lang="en-US" altLang="zh-CN" sz="1400" dirty="0">
                <a:effectLst/>
                <a:latin typeface="Times New Roman" panose="02020603050405020304" pitchFamily="18" charset="0"/>
                <a:ea typeface="等线" panose="02010600030101010101" pitchFamily="2" charset="-122"/>
              </a:rPr>
              <a:t>(A-H) The sequences covering the promoter (A, C, E, G) and coding regions (B, D, F, H) of two alleles of </a:t>
            </a:r>
            <a:r>
              <a:rPr lang="en-US" altLang="zh-CN" sz="1400" i="1" dirty="0">
                <a:effectLst/>
                <a:latin typeface="Times New Roman" panose="02020603050405020304" pitchFamily="18" charset="0"/>
                <a:ea typeface="等线" panose="02010600030101010101" pitchFamily="2" charset="-122"/>
              </a:rPr>
              <a:t>MdPG1</a:t>
            </a:r>
            <a:r>
              <a:rPr lang="en-US" altLang="zh-CN" sz="1400" dirty="0">
                <a:effectLst/>
                <a:latin typeface="Times New Roman" panose="02020603050405020304" pitchFamily="18" charset="0"/>
                <a:ea typeface="等线" panose="02010600030101010101" pitchFamily="2" charset="-122"/>
              </a:rPr>
              <a:t> were PCR amplified from genomic DNA of ‘</a:t>
            </a:r>
            <a:r>
              <a:rPr lang="en-US" altLang="zh-CN" sz="1400" dirty="0" err="1">
                <a:effectLst/>
                <a:latin typeface="Times New Roman" panose="02020603050405020304" pitchFamily="18" charset="0"/>
                <a:ea typeface="等线" panose="02010600030101010101" pitchFamily="2" charset="-122"/>
              </a:rPr>
              <a:t>Meiba</a:t>
            </a:r>
            <a:r>
              <a:rPr lang="en-US" altLang="zh-CN" sz="1400" dirty="0">
                <a:effectLst/>
                <a:latin typeface="Times New Roman" panose="02020603050405020304" pitchFamily="18" charset="0"/>
                <a:ea typeface="等线" panose="02010600030101010101" pitchFamily="2" charset="-122"/>
              </a:rPr>
              <a:t>’ (A, B), ‘</a:t>
            </a:r>
            <a:r>
              <a:rPr lang="en-US" altLang="zh-CN" sz="1400" dirty="0" err="1">
                <a:effectLst/>
                <a:latin typeface="Times New Roman" panose="02020603050405020304" pitchFamily="18" charset="0"/>
                <a:ea typeface="等线" panose="02010600030101010101" pitchFamily="2" charset="-122"/>
              </a:rPr>
              <a:t>Huahong</a:t>
            </a:r>
            <a:r>
              <a:rPr lang="en-US" altLang="zh-CN" sz="1400" dirty="0">
                <a:effectLst/>
                <a:latin typeface="Times New Roman" panose="02020603050405020304" pitchFamily="18" charset="0"/>
                <a:ea typeface="等线" panose="02010600030101010101" pitchFamily="2" charset="-122"/>
              </a:rPr>
              <a:t>’ (C, D), ‘</a:t>
            </a:r>
            <a:r>
              <a:rPr lang="en-US" altLang="zh-CN" sz="1400" dirty="0" err="1">
                <a:effectLst/>
                <a:latin typeface="Times New Roman" panose="02020603050405020304" pitchFamily="18" charset="0"/>
                <a:ea typeface="等线" panose="02010600030101010101" pitchFamily="2" charset="-122"/>
              </a:rPr>
              <a:t>Huaxing</a:t>
            </a:r>
            <a:r>
              <a:rPr lang="en-US" altLang="zh-CN" sz="1400" dirty="0">
                <a:effectLst/>
                <a:latin typeface="Times New Roman" panose="02020603050405020304" pitchFamily="18" charset="0"/>
                <a:ea typeface="等线" panose="02010600030101010101" pitchFamily="2" charset="-122"/>
              </a:rPr>
              <a:t>’ (E, F) and ‘</a:t>
            </a:r>
            <a:r>
              <a:rPr lang="en-US" altLang="zh-CN" sz="1400" dirty="0" err="1">
                <a:effectLst/>
                <a:latin typeface="Times New Roman" panose="02020603050405020304" pitchFamily="18" charset="0"/>
                <a:ea typeface="等线" panose="02010600030101010101" pitchFamily="2" charset="-122"/>
              </a:rPr>
              <a:t>Huashuo</a:t>
            </a:r>
            <a:r>
              <a:rPr lang="en-US" altLang="zh-CN" sz="1400" dirty="0">
                <a:effectLst/>
                <a:latin typeface="Times New Roman" panose="02020603050405020304" pitchFamily="18" charset="0"/>
                <a:ea typeface="等线" panose="02010600030101010101" pitchFamily="2" charset="-122"/>
              </a:rPr>
              <a:t>’ (G, H). The amplified fragments were cloned and sequenced. Pairwise sequence alignment of the promoter and gene body regions of </a:t>
            </a:r>
            <a:r>
              <a:rPr lang="en-US" altLang="zh-CN" sz="1400" i="1" dirty="0">
                <a:effectLst/>
                <a:latin typeface="Times New Roman" panose="02020603050405020304" pitchFamily="18" charset="0"/>
                <a:ea typeface="等线" panose="02010600030101010101" pitchFamily="2" charset="-122"/>
              </a:rPr>
              <a:t>MdPG1</a:t>
            </a:r>
            <a:r>
              <a:rPr lang="en-US" altLang="zh-CN" sz="1400" dirty="0">
                <a:effectLst/>
                <a:latin typeface="Times New Roman" panose="02020603050405020304" pitchFamily="18" charset="0"/>
                <a:ea typeface="等线" panose="02010600030101010101" pitchFamily="2" charset="-122"/>
              </a:rPr>
              <a:t> was performed using </a:t>
            </a:r>
            <a:r>
              <a:rPr lang="en-US" altLang="zh-CN" sz="1400" dirty="0" err="1">
                <a:effectLst/>
                <a:latin typeface="Times New Roman" panose="02020603050405020304" pitchFamily="18" charset="0"/>
                <a:ea typeface="等线" panose="02010600030101010101" pitchFamily="2" charset="-122"/>
              </a:rPr>
              <a:t>Geneious</a:t>
            </a:r>
            <a:r>
              <a:rPr lang="en-US" altLang="zh-CN" sz="1400" dirty="0">
                <a:effectLst/>
                <a:latin typeface="Times New Roman" panose="02020603050405020304" pitchFamily="18" charset="0"/>
                <a:ea typeface="等线" panose="02010600030101010101" pitchFamily="2" charset="-122"/>
              </a:rPr>
              <a:t> software v9.1.4. The start (ATG) and stop codon (TAA) of </a:t>
            </a:r>
            <a:r>
              <a:rPr lang="en-US" altLang="zh-CN" sz="1400" i="1" dirty="0">
                <a:effectLst/>
                <a:latin typeface="Times New Roman" panose="02020603050405020304" pitchFamily="18" charset="0"/>
                <a:ea typeface="等线" panose="02010600030101010101" pitchFamily="2" charset="-122"/>
              </a:rPr>
              <a:t>MdPG1</a:t>
            </a:r>
            <a:r>
              <a:rPr lang="en-US" altLang="zh-CN" sz="1400" dirty="0">
                <a:effectLst/>
                <a:latin typeface="Times New Roman" panose="02020603050405020304" pitchFamily="18" charset="0"/>
                <a:ea typeface="等线" panose="02010600030101010101" pitchFamily="2" charset="-122"/>
              </a:rPr>
              <a:t> gene are shown in red box. AP2/ERF and EIN/EIL3 binding elements are highlighted with yellow and red color, respectively. An SNP within an ERF binding element is using blue color. The SNPs in the 5’ UTR and CDS of two </a:t>
            </a:r>
            <a:r>
              <a:rPr lang="en-US" altLang="zh-CN" sz="1400" i="1" dirty="0">
                <a:effectLst/>
                <a:latin typeface="Times New Roman" panose="02020603050405020304" pitchFamily="18" charset="0"/>
                <a:ea typeface="等线" panose="02010600030101010101" pitchFamily="2" charset="-122"/>
              </a:rPr>
              <a:t>MdPG1</a:t>
            </a:r>
            <a:r>
              <a:rPr lang="en-US" altLang="zh-CN" sz="1400" dirty="0">
                <a:effectLst/>
                <a:latin typeface="Times New Roman" panose="02020603050405020304" pitchFamily="18" charset="0"/>
                <a:ea typeface="等线" panose="02010600030101010101" pitchFamily="2" charset="-122"/>
              </a:rPr>
              <a:t> alleles are highlighted. The red sequence represents the 1.3 kb insertion (A, E, G).</a:t>
            </a:r>
            <a:endParaRPr kumimoji="0" lang="zh-CN" altLang="en-US" sz="1400" i="0" u="none" strike="noStrike" kern="1200" cap="none" spc="0" normalizeH="0" baseline="0" noProof="0" dirty="0">
              <a:ln>
                <a:noFill/>
              </a:ln>
              <a:solidFill>
                <a:prstClr val="black"/>
              </a:solidFill>
              <a:effectLst/>
              <a:uLnTx/>
              <a:uFillTx/>
              <a:latin typeface="等线" panose="020F0502020204030204"/>
              <a:ea typeface="等线" panose="02010600030101010101" pitchFamily="2" charset="-122"/>
              <a:cs typeface="+mn-cs"/>
            </a:endParaRPr>
          </a:p>
        </p:txBody>
      </p:sp>
    </p:spTree>
    <p:extLst>
      <p:ext uri="{BB962C8B-B14F-4D97-AF65-F5344CB8AC3E}">
        <p14:creationId xmlns:p14="http://schemas.microsoft.com/office/powerpoint/2010/main" val="281103591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a:extLst>
              <a:ext uri="{FF2B5EF4-FFF2-40B4-BE49-F238E27FC236}">
                <a16:creationId xmlns:a16="http://schemas.microsoft.com/office/drawing/2014/main" id="{7DD882D0-71F7-229A-1769-78456105275D}"/>
              </a:ext>
            </a:extLst>
          </p:cNvPr>
          <p:cNvGrpSpPr/>
          <p:nvPr/>
        </p:nvGrpSpPr>
        <p:grpSpPr>
          <a:xfrm>
            <a:off x="3312630" y="1480896"/>
            <a:ext cx="5566740" cy="3896207"/>
            <a:chOff x="1582829" y="546726"/>
            <a:chExt cx="5566740" cy="3896207"/>
          </a:xfrm>
        </p:grpSpPr>
        <p:pic>
          <p:nvPicPr>
            <p:cNvPr id="5" name="图片 4">
              <a:extLst>
                <a:ext uri="{FF2B5EF4-FFF2-40B4-BE49-F238E27FC236}">
                  <a16:creationId xmlns:a16="http://schemas.microsoft.com/office/drawing/2014/main" id="{017CBBDB-1FEF-38A3-017D-A350EE19A1B3}"/>
                </a:ext>
              </a:extLst>
            </p:cNvPr>
            <p:cNvPicPr>
              <a:picLocks/>
            </p:cNvPicPr>
            <p:nvPr/>
          </p:nvPicPr>
          <p:blipFill>
            <a:blip r:embed="rId2"/>
            <a:stretch>
              <a:fillRect/>
            </a:stretch>
          </p:blipFill>
          <p:spPr>
            <a:xfrm>
              <a:off x="4380440" y="677330"/>
              <a:ext cx="2769129" cy="3723268"/>
            </a:xfrm>
            <a:prstGeom prst="rect">
              <a:avLst/>
            </a:prstGeom>
          </p:spPr>
        </p:pic>
        <p:pic>
          <p:nvPicPr>
            <p:cNvPr id="6" name="图片 5">
              <a:extLst>
                <a:ext uri="{FF2B5EF4-FFF2-40B4-BE49-F238E27FC236}">
                  <a16:creationId xmlns:a16="http://schemas.microsoft.com/office/drawing/2014/main" id="{57217890-69AA-74E7-2CA2-D1589DED82AD}"/>
                </a:ext>
              </a:extLst>
            </p:cNvPr>
            <p:cNvPicPr>
              <a:picLocks/>
            </p:cNvPicPr>
            <p:nvPr/>
          </p:nvPicPr>
          <p:blipFill>
            <a:blip r:embed="rId3"/>
            <a:stretch>
              <a:fillRect/>
            </a:stretch>
          </p:blipFill>
          <p:spPr>
            <a:xfrm>
              <a:off x="1590857" y="719665"/>
              <a:ext cx="2569240" cy="3723268"/>
            </a:xfrm>
            <a:prstGeom prst="rect">
              <a:avLst/>
            </a:prstGeom>
          </p:spPr>
        </p:pic>
        <p:sp>
          <p:nvSpPr>
            <p:cNvPr id="8" name="文本框 7">
              <a:extLst>
                <a:ext uri="{FF2B5EF4-FFF2-40B4-BE49-F238E27FC236}">
                  <a16:creationId xmlns:a16="http://schemas.microsoft.com/office/drawing/2014/main" id="{9EA3BC4A-3014-C1C3-B133-29DBE3EEEE0E}"/>
                </a:ext>
              </a:extLst>
            </p:cNvPr>
            <p:cNvSpPr txBox="1"/>
            <p:nvPr/>
          </p:nvSpPr>
          <p:spPr>
            <a:xfrm flipH="1">
              <a:off x="1582829" y="546726"/>
              <a:ext cx="152399" cy="307777"/>
            </a:xfrm>
            <a:prstGeom prst="rect">
              <a:avLst/>
            </a:prstGeom>
            <a:noFill/>
          </p:spPr>
          <p:txBody>
            <a:bodyPr wrap="square" rtlCol="0">
              <a:spAutoFit/>
            </a:bodyPr>
            <a:lstStyle/>
            <a:p>
              <a:r>
                <a:rPr lang="en-US" altLang="zh-CN" sz="1400" dirty="0">
                  <a:latin typeface="Times New Roman" panose="02020603050405020304" pitchFamily="18" charset="0"/>
                  <a:cs typeface="Times New Roman" panose="02020603050405020304" pitchFamily="18" charset="0"/>
                </a:rPr>
                <a:t>A</a:t>
              </a:r>
              <a:endParaRPr lang="zh-CN" altLang="en-US" sz="1400" dirty="0">
                <a:latin typeface="Times New Roman" panose="02020603050405020304" pitchFamily="18" charset="0"/>
                <a:cs typeface="Times New Roman" panose="02020603050405020304" pitchFamily="18" charset="0"/>
              </a:endParaRPr>
            </a:p>
          </p:txBody>
        </p:sp>
        <p:sp>
          <p:nvSpPr>
            <p:cNvPr id="9" name="文本框 8">
              <a:extLst>
                <a:ext uri="{FF2B5EF4-FFF2-40B4-BE49-F238E27FC236}">
                  <a16:creationId xmlns:a16="http://schemas.microsoft.com/office/drawing/2014/main" id="{D80E1D3B-36F9-C9FF-BD69-51916A66E9BA}"/>
                </a:ext>
              </a:extLst>
            </p:cNvPr>
            <p:cNvSpPr txBox="1"/>
            <p:nvPr/>
          </p:nvSpPr>
          <p:spPr>
            <a:xfrm flipH="1">
              <a:off x="4401920" y="546726"/>
              <a:ext cx="152399" cy="307777"/>
            </a:xfrm>
            <a:prstGeom prst="rect">
              <a:avLst/>
            </a:prstGeom>
            <a:noFill/>
          </p:spPr>
          <p:txBody>
            <a:bodyPr wrap="square" rtlCol="0">
              <a:spAutoFit/>
            </a:bodyPr>
            <a:lstStyle/>
            <a:p>
              <a:r>
                <a:rPr lang="en-US" altLang="zh-CN" sz="1400" dirty="0">
                  <a:latin typeface="Times New Roman" panose="02020603050405020304" pitchFamily="18" charset="0"/>
                  <a:cs typeface="Times New Roman" panose="02020603050405020304" pitchFamily="18" charset="0"/>
                </a:rPr>
                <a:t>B</a:t>
              </a:r>
              <a:endParaRPr lang="zh-CN" altLang="en-US" sz="1400" dirty="0">
                <a:latin typeface="Times New Roman" panose="02020603050405020304" pitchFamily="18" charset="0"/>
                <a:cs typeface="Times New Roman" panose="02020603050405020304" pitchFamily="18" charset="0"/>
              </a:endParaRPr>
            </a:p>
          </p:txBody>
        </p:sp>
      </p:grpSp>
      <p:sp>
        <p:nvSpPr>
          <p:cNvPr id="22" name="文本框 21">
            <a:extLst>
              <a:ext uri="{FF2B5EF4-FFF2-40B4-BE49-F238E27FC236}">
                <a16:creationId xmlns:a16="http://schemas.microsoft.com/office/drawing/2014/main" id="{98E5A25B-BE00-BCC1-05D7-EF3EF3CFEE07}"/>
              </a:ext>
            </a:extLst>
          </p:cNvPr>
          <p:cNvSpPr txBox="1"/>
          <p:nvPr/>
        </p:nvSpPr>
        <p:spPr>
          <a:xfrm>
            <a:off x="1200896" y="5465372"/>
            <a:ext cx="10166447" cy="738664"/>
          </a:xfrm>
          <a:prstGeom prst="rect">
            <a:avLst/>
          </a:prstGeom>
          <a:noFill/>
        </p:spPr>
        <p:txBody>
          <a:bodyPr wrap="square">
            <a:spAutoFit/>
          </a:bodyPr>
          <a:lstStyle/>
          <a:p>
            <a:pPr algn="just"/>
            <a:r>
              <a:rPr lang="en-US" altLang="zh-CN" sz="1400" b="1" dirty="0">
                <a:effectLst/>
                <a:latin typeface="Times New Roman" panose="02020603050405020304" pitchFamily="18" charset="0"/>
                <a:ea typeface="等线" panose="02010600030101010101" pitchFamily="2" charset="-122"/>
              </a:rPr>
              <a:t>Supplemental Figure S2. Phylogenetic analysis of the EIL and AP2 proteins. </a:t>
            </a:r>
            <a:r>
              <a:rPr lang="en-US" altLang="zh-CN" sz="1400" dirty="0">
                <a:effectLst/>
                <a:latin typeface="Times New Roman" panose="02020603050405020304" pitchFamily="18" charset="0"/>
                <a:ea typeface="等线" panose="02010600030101010101" pitchFamily="2" charset="-122"/>
              </a:rPr>
              <a:t>Rooted </a:t>
            </a:r>
            <a:r>
              <a:rPr lang="en-US" altLang="zh-CN" sz="1400" dirty="0" err="1">
                <a:effectLst/>
                <a:latin typeface="Times New Roman" panose="02020603050405020304" pitchFamily="18" charset="0"/>
                <a:ea typeface="等线" panose="02010600030101010101" pitchFamily="2" charset="-122"/>
              </a:rPr>
              <a:t>Neighbour</a:t>
            </a:r>
            <a:r>
              <a:rPr lang="en-US" altLang="zh-CN" sz="1400" dirty="0">
                <a:effectLst/>
                <a:latin typeface="Times New Roman" panose="02020603050405020304" pitchFamily="18" charset="0"/>
                <a:ea typeface="等线" panose="02010600030101010101" pitchFamily="2" charset="-122"/>
              </a:rPr>
              <a:t>-joining phylogenetic tree were constructed using protein sequences of members of the EIL (A) and AP2 (B) family from apple, Arabidopsis and kiwifruit. The GenBank or Arabidopsis TAIR accession numbers or Gene ID in GDR used are listed in Table S2.</a:t>
            </a:r>
            <a:endParaRPr lang="zh-CN" altLang="en-US" sz="1400" dirty="0"/>
          </a:p>
        </p:txBody>
      </p:sp>
    </p:spTree>
    <p:extLst>
      <p:ext uri="{BB962C8B-B14F-4D97-AF65-F5344CB8AC3E}">
        <p14:creationId xmlns:p14="http://schemas.microsoft.com/office/powerpoint/2010/main" val="958476344"/>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391</TotalTime>
  <Words>6343</Words>
  <Application>Microsoft Office PowerPoint</Application>
  <PresentationFormat>宽屏</PresentationFormat>
  <Paragraphs>71</Paragraphs>
  <Slides>12</Slides>
  <Notes>1</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2</vt:i4>
      </vt:variant>
    </vt:vector>
  </HeadingPairs>
  <TitlesOfParts>
    <vt:vector size="18" baseType="lpstr">
      <vt:lpstr>Courier</vt: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萌 萌</dc:creator>
  <cp:lastModifiedBy>萌 萌</cp:lastModifiedBy>
  <cp:revision>25</cp:revision>
  <dcterms:created xsi:type="dcterms:W3CDTF">2023-03-03T01:30:46Z</dcterms:created>
  <dcterms:modified xsi:type="dcterms:W3CDTF">2023-03-23T16:32:09Z</dcterms:modified>
</cp:coreProperties>
</file>